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custom-properties" Target="docProps/custom.xml"/><Relationship Id="rId4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7315200" cy="10058400"/>
  <p:notesSz cx="7008813" cy="9294813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44A7568-74DB-4EB6-92CB-40ECCA8F8540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66480" y="402840"/>
            <a:ext cx="6583320" cy="1676520"/>
          </a:xfrm>
          <a:prstGeom prst="rect">
            <a:avLst/>
          </a:prstGeom>
          <a:noFill/>
          <a:ln w="0">
            <a:noFill/>
          </a:ln>
        </p:spPr>
        <p:txBody>
          <a:bodyPr lIns="93960" rIns="93960" tIns="47160" bIns="47160" anchor="ctr">
            <a:noAutofit/>
          </a:bodyPr>
          <a:p>
            <a:pPr indent="0" algn="ctr">
              <a:buNone/>
              <a:tabLst>
                <a:tab algn="l" pos="0"/>
                <a:tab algn="l" pos="939960"/>
                <a:tab algn="l" pos="1879560"/>
                <a:tab algn="l" pos="2819520"/>
                <a:tab algn="l" pos="3759120"/>
                <a:tab algn="l" pos="4699080"/>
                <a:tab algn="l" pos="5638680"/>
                <a:tab algn="l" pos="6578640"/>
                <a:tab algn="l" pos="7518240"/>
                <a:tab algn="l" pos="8458200"/>
                <a:tab algn="l" pos="9398160"/>
                <a:tab algn="l" pos="10337760"/>
              </a:tabLst>
            </a:pPr>
            <a:endParaRPr b="0" lang="en-US" sz="4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66480" y="2346120"/>
            <a:ext cx="6583320" cy="3166560"/>
          </a:xfrm>
          <a:prstGeom prst="rect">
            <a:avLst/>
          </a:prstGeom>
          <a:noFill/>
          <a:ln w="0">
            <a:noFill/>
          </a:ln>
        </p:spPr>
        <p:txBody>
          <a:bodyPr lIns="93960" rIns="93960" tIns="47160" bIns="47160" anchor="t">
            <a:normAutofit/>
          </a:bodyPr>
          <a:p>
            <a:pPr indent="0">
              <a:spcBef>
                <a:spcPts val="850"/>
              </a:spcBef>
              <a:buNone/>
              <a:tabLst>
                <a:tab algn="l" pos="939960"/>
                <a:tab algn="l" pos="1879560"/>
                <a:tab algn="l" pos="2819520"/>
                <a:tab algn="l" pos="3759120"/>
                <a:tab algn="l" pos="4699080"/>
                <a:tab algn="l" pos="5638680"/>
                <a:tab algn="l" pos="6578640"/>
                <a:tab algn="l" pos="7518240"/>
                <a:tab algn="l" pos="8458200"/>
                <a:tab algn="l" pos="9398160"/>
                <a:tab algn="l" pos="10337760"/>
              </a:tabLst>
            </a:pPr>
            <a:endParaRPr b="0" lang="en-US" sz="3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66480" y="5814000"/>
            <a:ext cx="6583320" cy="3166560"/>
          </a:xfrm>
          <a:prstGeom prst="rect">
            <a:avLst/>
          </a:prstGeom>
          <a:noFill/>
          <a:ln w="0">
            <a:noFill/>
          </a:ln>
        </p:spPr>
        <p:txBody>
          <a:bodyPr lIns="93960" rIns="93960" tIns="47160" bIns="47160" anchor="t">
            <a:normAutofit/>
          </a:bodyPr>
          <a:p>
            <a:pPr indent="0">
              <a:spcBef>
                <a:spcPts val="850"/>
              </a:spcBef>
              <a:buNone/>
              <a:tabLst>
                <a:tab algn="l" pos="939960"/>
                <a:tab algn="l" pos="1879560"/>
                <a:tab algn="l" pos="2819520"/>
                <a:tab algn="l" pos="3759120"/>
                <a:tab algn="l" pos="4699080"/>
                <a:tab algn="l" pos="5638680"/>
                <a:tab algn="l" pos="6578640"/>
                <a:tab algn="l" pos="7518240"/>
                <a:tab algn="l" pos="8458200"/>
                <a:tab algn="l" pos="9398160"/>
                <a:tab algn="l" pos="10337760"/>
              </a:tabLst>
            </a:pPr>
            <a:endParaRPr b="0" lang="en-US" sz="3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5E90324-B21A-4BDE-81C5-AEC86431DAC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66480" y="402840"/>
            <a:ext cx="6583320" cy="1676520"/>
          </a:xfrm>
          <a:prstGeom prst="rect">
            <a:avLst/>
          </a:prstGeom>
          <a:noFill/>
          <a:ln w="0">
            <a:noFill/>
          </a:ln>
        </p:spPr>
        <p:txBody>
          <a:bodyPr lIns="93960" rIns="93960" tIns="47160" bIns="47160" anchor="ctr">
            <a:noAutofit/>
          </a:bodyPr>
          <a:p>
            <a:pPr indent="0" algn="ctr">
              <a:buNone/>
              <a:tabLst>
                <a:tab algn="l" pos="0"/>
                <a:tab algn="l" pos="939960"/>
                <a:tab algn="l" pos="1879560"/>
                <a:tab algn="l" pos="2819520"/>
                <a:tab algn="l" pos="3759120"/>
                <a:tab algn="l" pos="4699080"/>
                <a:tab algn="l" pos="5638680"/>
                <a:tab algn="l" pos="6578640"/>
                <a:tab algn="l" pos="7518240"/>
                <a:tab algn="l" pos="8458200"/>
                <a:tab algn="l" pos="9398160"/>
                <a:tab algn="l" pos="10337760"/>
              </a:tabLst>
            </a:pPr>
            <a:endParaRPr b="0" lang="en-US" sz="4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66480" y="2346120"/>
            <a:ext cx="3212640" cy="3166560"/>
          </a:xfrm>
          <a:prstGeom prst="rect">
            <a:avLst/>
          </a:prstGeom>
          <a:noFill/>
          <a:ln w="0">
            <a:noFill/>
          </a:ln>
        </p:spPr>
        <p:txBody>
          <a:bodyPr lIns="93960" rIns="93960" tIns="47160" bIns="47160" anchor="t">
            <a:normAutofit/>
          </a:bodyPr>
          <a:p>
            <a:pPr indent="0">
              <a:spcBef>
                <a:spcPts val="850"/>
              </a:spcBef>
              <a:buNone/>
              <a:tabLst>
                <a:tab algn="l" pos="939960"/>
                <a:tab algn="l" pos="1879560"/>
                <a:tab algn="l" pos="2819520"/>
                <a:tab algn="l" pos="3759120"/>
                <a:tab algn="l" pos="4699080"/>
                <a:tab algn="l" pos="5638680"/>
                <a:tab algn="l" pos="6578640"/>
                <a:tab algn="l" pos="7518240"/>
                <a:tab algn="l" pos="8458200"/>
                <a:tab algn="l" pos="9398160"/>
                <a:tab algn="l" pos="10337760"/>
              </a:tabLst>
            </a:pPr>
            <a:endParaRPr b="0" lang="en-US" sz="3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740040" y="2346120"/>
            <a:ext cx="3212640" cy="3166560"/>
          </a:xfrm>
          <a:prstGeom prst="rect">
            <a:avLst/>
          </a:prstGeom>
          <a:noFill/>
          <a:ln w="0">
            <a:noFill/>
          </a:ln>
        </p:spPr>
        <p:txBody>
          <a:bodyPr lIns="93960" rIns="93960" tIns="47160" bIns="47160" anchor="t">
            <a:normAutofit/>
          </a:bodyPr>
          <a:p>
            <a:pPr indent="0">
              <a:spcBef>
                <a:spcPts val="850"/>
              </a:spcBef>
              <a:buNone/>
              <a:tabLst>
                <a:tab algn="l" pos="939960"/>
                <a:tab algn="l" pos="1879560"/>
                <a:tab algn="l" pos="2819520"/>
                <a:tab algn="l" pos="3759120"/>
                <a:tab algn="l" pos="4699080"/>
                <a:tab algn="l" pos="5638680"/>
                <a:tab algn="l" pos="6578640"/>
                <a:tab algn="l" pos="7518240"/>
                <a:tab algn="l" pos="8458200"/>
                <a:tab algn="l" pos="9398160"/>
                <a:tab algn="l" pos="10337760"/>
              </a:tabLst>
            </a:pPr>
            <a:endParaRPr b="0" lang="en-US" sz="3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66480" y="5814000"/>
            <a:ext cx="3212640" cy="3166560"/>
          </a:xfrm>
          <a:prstGeom prst="rect">
            <a:avLst/>
          </a:prstGeom>
          <a:noFill/>
          <a:ln w="0">
            <a:noFill/>
          </a:ln>
        </p:spPr>
        <p:txBody>
          <a:bodyPr lIns="93960" rIns="93960" tIns="47160" bIns="47160" anchor="t">
            <a:normAutofit/>
          </a:bodyPr>
          <a:p>
            <a:pPr indent="0">
              <a:spcBef>
                <a:spcPts val="850"/>
              </a:spcBef>
              <a:buNone/>
              <a:tabLst>
                <a:tab algn="l" pos="939960"/>
                <a:tab algn="l" pos="1879560"/>
                <a:tab algn="l" pos="2819520"/>
                <a:tab algn="l" pos="3759120"/>
                <a:tab algn="l" pos="4699080"/>
                <a:tab algn="l" pos="5638680"/>
                <a:tab algn="l" pos="6578640"/>
                <a:tab algn="l" pos="7518240"/>
                <a:tab algn="l" pos="8458200"/>
                <a:tab algn="l" pos="9398160"/>
                <a:tab algn="l" pos="10337760"/>
              </a:tabLst>
            </a:pPr>
            <a:endParaRPr b="0" lang="en-US" sz="3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740040" y="5814000"/>
            <a:ext cx="3212640" cy="3166560"/>
          </a:xfrm>
          <a:prstGeom prst="rect">
            <a:avLst/>
          </a:prstGeom>
          <a:noFill/>
          <a:ln w="0">
            <a:noFill/>
          </a:ln>
        </p:spPr>
        <p:txBody>
          <a:bodyPr lIns="93960" rIns="93960" tIns="47160" bIns="47160" anchor="t">
            <a:normAutofit/>
          </a:bodyPr>
          <a:p>
            <a:pPr indent="0">
              <a:spcBef>
                <a:spcPts val="850"/>
              </a:spcBef>
              <a:buNone/>
              <a:tabLst>
                <a:tab algn="l" pos="939960"/>
                <a:tab algn="l" pos="1879560"/>
                <a:tab algn="l" pos="2819520"/>
                <a:tab algn="l" pos="3759120"/>
                <a:tab algn="l" pos="4699080"/>
                <a:tab algn="l" pos="5638680"/>
                <a:tab algn="l" pos="6578640"/>
                <a:tab algn="l" pos="7518240"/>
                <a:tab algn="l" pos="8458200"/>
                <a:tab algn="l" pos="9398160"/>
                <a:tab algn="l" pos="10337760"/>
              </a:tabLst>
            </a:pPr>
            <a:endParaRPr b="0" lang="en-US" sz="3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578802C-E6FD-4390-9F5B-F4891A05FBE0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66480" y="402840"/>
            <a:ext cx="6583320" cy="1676520"/>
          </a:xfrm>
          <a:prstGeom prst="rect">
            <a:avLst/>
          </a:prstGeom>
          <a:noFill/>
          <a:ln w="0">
            <a:noFill/>
          </a:ln>
        </p:spPr>
        <p:txBody>
          <a:bodyPr lIns="93960" rIns="93960" tIns="47160" bIns="47160" anchor="ctr">
            <a:noAutofit/>
          </a:bodyPr>
          <a:p>
            <a:pPr indent="0" algn="ctr">
              <a:buNone/>
              <a:tabLst>
                <a:tab algn="l" pos="0"/>
                <a:tab algn="l" pos="939960"/>
                <a:tab algn="l" pos="1879560"/>
                <a:tab algn="l" pos="2819520"/>
                <a:tab algn="l" pos="3759120"/>
                <a:tab algn="l" pos="4699080"/>
                <a:tab algn="l" pos="5638680"/>
                <a:tab algn="l" pos="6578640"/>
                <a:tab algn="l" pos="7518240"/>
                <a:tab algn="l" pos="8458200"/>
                <a:tab algn="l" pos="9398160"/>
                <a:tab algn="l" pos="10337760"/>
              </a:tabLst>
            </a:pPr>
            <a:endParaRPr b="0" lang="en-US" sz="4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66480" y="2346120"/>
            <a:ext cx="2119680" cy="3166560"/>
          </a:xfrm>
          <a:prstGeom prst="rect">
            <a:avLst/>
          </a:prstGeom>
          <a:noFill/>
          <a:ln w="0">
            <a:noFill/>
          </a:ln>
        </p:spPr>
        <p:txBody>
          <a:bodyPr lIns="93960" rIns="93960" tIns="47160" bIns="47160" anchor="t">
            <a:normAutofit/>
          </a:bodyPr>
          <a:p>
            <a:pPr indent="0">
              <a:spcBef>
                <a:spcPts val="850"/>
              </a:spcBef>
              <a:buNone/>
              <a:tabLst>
                <a:tab algn="l" pos="939960"/>
                <a:tab algn="l" pos="1879560"/>
                <a:tab algn="l" pos="2819520"/>
                <a:tab algn="l" pos="3759120"/>
                <a:tab algn="l" pos="4699080"/>
                <a:tab algn="l" pos="5638680"/>
                <a:tab algn="l" pos="6578640"/>
                <a:tab algn="l" pos="7518240"/>
                <a:tab algn="l" pos="8458200"/>
                <a:tab algn="l" pos="9398160"/>
                <a:tab algn="l" pos="10337760"/>
              </a:tabLst>
            </a:pPr>
            <a:endParaRPr b="0" lang="en-US" sz="3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592360" y="2346120"/>
            <a:ext cx="2119680" cy="3166560"/>
          </a:xfrm>
          <a:prstGeom prst="rect">
            <a:avLst/>
          </a:prstGeom>
          <a:noFill/>
          <a:ln w="0">
            <a:noFill/>
          </a:ln>
        </p:spPr>
        <p:txBody>
          <a:bodyPr lIns="93960" rIns="93960" tIns="47160" bIns="47160" anchor="t">
            <a:normAutofit/>
          </a:bodyPr>
          <a:p>
            <a:pPr indent="0">
              <a:spcBef>
                <a:spcPts val="850"/>
              </a:spcBef>
              <a:buNone/>
              <a:tabLst>
                <a:tab algn="l" pos="939960"/>
                <a:tab algn="l" pos="1879560"/>
                <a:tab algn="l" pos="2819520"/>
                <a:tab algn="l" pos="3759120"/>
                <a:tab algn="l" pos="4699080"/>
                <a:tab algn="l" pos="5638680"/>
                <a:tab algn="l" pos="6578640"/>
                <a:tab algn="l" pos="7518240"/>
                <a:tab algn="l" pos="8458200"/>
                <a:tab algn="l" pos="9398160"/>
                <a:tab algn="l" pos="10337760"/>
              </a:tabLst>
            </a:pPr>
            <a:endParaRPr b="0" lang="en-US" sz="3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818600" y="2346120"/>
            <a:ext cx="2119680" cy="3166560"/>
          </a:xfrm>
          <a:prstGeom prst="rect">
            <a:avLst/>
          </a:prstGeom>
          <a:noFill/>
          <a:ln w="0">
            <a:noFill/>
          </a:ln>
        </p:spPr>
        <p:txBody>
          <a:bodyPr lIns="93960" rIns="93960" tIns="47160" bIns="47160" anchor="t">
            <a:normAutofit/>
          </a:bodyPr>
          <a:p>
            <a:pPr indent="0">
              <a:spcBef>
                <a:spcPts val="850"/>
              </a:spcBef>
              <a:buNone/>
              <a:tabLst>
                <a:tab algn="l" pos="939960"/>
                <a:tab algn="l" pos="1879560"/>
                <a:tab algn="l" pos="2819520"/>
                <a:tab algn="l" pos="3759120"/>
                <a:tab algn="l" pos="4699080"/>
                <a:tab algn="l" pos="5638680"/>
                <a:tab algn="l" pos="6578640"/>
                <a:tab algn="l" pos="7518240"/>
                <a:tab algn="l" pos="8458200"/>
                <a:tab algn="l" pos="9398160"/>
                <a:tab algn="l" pos="10337760"/>
              </a:tabLst>
            </a:pPr>
            <a:endParaRPr b="0" lang="en-US" sz="3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66480" y="5814000"/>
            <a:ext cx="2119680" cy="3166560"/>
          </a:xfrm>
          <a:prstGeom prst="rect">
            <a:avLst/>
          </a:prstGeom>
          <a:noFill/>
          <a:ln w="0">
            <a:noFill/>
          </a:ln>
        </p:spPr>
        <p:txBody>
          <a:bodyPr lIns="93960" rIns="93960" tIns="47160" bIns="47160" anchor="t">
            <a:normAutofit/>
          </a:bodyPr>
          <a:p>
            <a:pPr indent="0">
              <a:spcBef>
                <a:spcPts val="850"/>
              </a:spcBef>
              <a:buNone/>
              <a:tabLst>
                <a:tab algn="l" pos="939960"/>
                <a:tab algn="l" pos="1879560"/>
                <a:tab algn="l" pos="2819520"/>
                <a:tab algn="l" pos="3759120"/>
                <a:tab algn="l" pos="4699080"/>
                <a:tab algn="l" pos="5638680"/>
                <a:tab algn="l" pos="6578640"/>
                <a:tab algn="l" pos="7518240"/>
                <a:tab algn="l" pos="8458200"/>
                <a:tab algn="l" pos="9398160"/>
                <a:tab algn="l" pos="10337760"/>
              </a:tabLst>
            </a:pPr>
            <a:endParaRPr b="0" lang="en-US" sz="3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592360" y="5814000"/>
            <a:ext cx="2119680" cy="3166560"/>
          </a:xfrm>
          <a:prstGeom prst="rect">
            <a:avLst/>
          </a:prstGeom>
          <a:noFill/>
          <a:ln w="0">
            <a:noFill/>
          </a:ln>
        </p:spPr>
        <p:txBody>
          <a:bodyPr lIns="93960" rIns="93960" tIns="47160" bIns="47160" anchor="t">
            <a:normAutofit/>
          </a:bodyPr>
          <a:p>
            <a:pPr indent="0">
              <a:spcBef>
                <a:spcPts val="850"/>
              </a:spcBef>
              <a:buNone/>
              <a:tabLst>
                <a:tab algn="l" pos="939960"/>
                <a:tab algn="l" pos="1879560"/>
                <a:tab algn="l" pos="2819520"/>
                <a:tab algn="l" pos="3759120"/>
                <a:tab algn="l" pos="4699080"/>
                <a:tab algn="l" pos="5638680"/>
                <a:tab algn="l" pos="6578640"/>
                <a:tab algn="l" pos="7518240"/>
                <a:tab algn="l" pos="8458200"/>
                <a:tab algn="l" pos="9398160"/>
                <a:tab algn="l" pos="10337760"/>
              </a:tabLst>
            </a:pPr>
            <a:endParaRPr b="0" lang="en-US" sz="3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818600" y="5814000"/>
            <a:ext cx="2119680" cy="3166560"/>
          </a:xfrm>
          <a:prstGeom prst="rect">
            <a:avLst/>
          </a:prstGeom>
          <a:noFill/>
          <a:ln w="0">
            <a:noFill/>
          </a:ln>
        </p:spPr>
        <p:txBody>
          <a:bodyPr lIns="93960" rIns="93960" tIns="47160" bIns="47160" anchor="t">
            <a:normAutofit/>
          </a:bodyPr>
          <a:p>
            <a:pPr indent="0">
              <a:spcBef>
                <a:spcPts val="850"/>
              </a:spcBef>
              <a:buNone/>
              <a:tabLst>
                <a:tab algn="l" pos="939960"/>
                <a:tab algn="l" pos="1879560"/>
                <a:tab algn="l" pos="2819520"/>
                <a:tab algn="l" pos="3759120"/>
                <a:tab algn="l" pos="4699080"/>
                <a:tab algn="l" pos="5638680"/>
                <a:tab algn="l" pos="6578640"/>
                <a:tab algn="l" pos="7518240"/>
                <a:tab algn="l" pos="8458200"/>
                <a:tab algn="l" pos="9398160"/>
                <a:tab algn="l" pos="10337760"/>
              </a:tabLst>
            </a:pPr>
            <a:endParaRPr b="0" lang="en-US" sz="3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54B6970-6B8E-426A-96E8-78EDC59CEC5F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66480" y="402840"/>
            <a:ext cx="6583320" cy="1676520"/>
          </a:xfrm>
          <a:prstGeom prst="rect">
            <a:avLst/>
          </a:prstGeom>
          <a:noFill/>
          <a:ln w="0">
            <a:noFill/>
          </a:ln>
        </p:spPr>
        <p:txBody>
          <a:bodyPr lIns="93960" rIns="93960" tIns="47160" bIns="47160" anchor="ctr">
            <a:noAutofit/>
          </a:bodyPr>
          <a:p>
            <a:pPr indent="0" algn="ctr">
              <a:buNone/>
              <a:tabLst>
                <a:tab algn="l" pos="0"/>
                <a:tab algn="l" pos="939960"/>
                <a:tab algn="l" pos="1879560"/>
                <a:tab algn="l" pos="2819520"/>
                <a:tab algn="l" pos="3759120"/>
                <a:tab algn="l" pos="4699080"/>
                <a:tab algn="l" pos="5638680"/>
                <a:tab algn="l" pos="6578640"/>
                <a:tab algn="l" pos="7518240"/>
                <a:tab algn="l" pos="8458200"/>
                <a:tab algn="l" pos="9398160"/>
                <a:tab algn="l" pos="10337760"/>
              </a:tabLst>
            </a:pPr>
            <a:endParaRPr b="0" lang="en-US" sz="4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66480" y="2346120"/>
            <a:ext cx="6583320" cy="66387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850"/>
              </a:spcBef>
              <a:buNone/>
              <a:tabLst>
                <a:tab algn="l" pos="0"/>
                <a:tab algn="l" pos="939960"/>
                <a:tab algn="l" pos="1879560"/>
                <a:tab algn="l" pos="2819520"/>
                <a:tab algn="l" pos="3759120"/>
                <a:tab algn="l" pos="4699080"/>
                <a:tab algn="l" pos="5638680"/>
                <a:tab algn="l" pos="6578640"/>
                <a:tab algn="l" pos="7518240"/>
                <a:tab algn="l" pos="8458200"/>
                <a:tab algn="l" pos="9398160"/>
                <a:tab algn="l" pos="10337760"/>
              </a:tabLst>
            </a:pPr>
            <a:endParaRPr b="0" lang="en-US" sz="3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A280A01-94BF-424D-A7DE-4FD563019BB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66480" y="402840"/>
            <a:ext cx="6583320" cy="1676520"/>
          </a:xfrm>
          <a:prstGeom prst="rect">
            <a:avLst/>
          </a:prstGeom>
          <a:noFill/>
          <a:ln w="0">
            <a:noFill/>
          </a:ln>
        </p:spPr>
        <p:txBody>
          <a:bodyPr lIns="93960" rIns="93960" tIns="47160" bIns="47160" anchor="ctr">
            <a:noAutofit/>
          </a:bodyPr>
          <a:p>
            <a:pPr indent="0" algn="ctr">
              <a:buNone/>
              <a:tabLst>
                <a:tab algn="l" pos="0"/>
                <a:tab algn="l" pos="939960"/>
                <a:tab algn="l" pos="1879560"/>
                <a:tab algn="l" pos="2819520"/>
                <a:tab algn="l" pos="3759120"/>
                <a:tab algn="l" pos="4699080"/>
                <a:tab algn="l" pos="5638680"/>
                <a:tab algn="l" pos="6578640"/>
                <a:tab algn="l" pos="7518240"/>
                <a:tab algn="l" pos="8458200"/>
                <a:tab algn="l" pos="9398160"/>
                <a:tab algn="l" pos="10337760"/>
              </a:tabLst>
            </a:pPr>
            <a:endParaRPr b="0" lang="en-US" sz="4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66480" y="2346120"/>
            <a:ext cx="6583320" cy="6638760"/>
          </a:xfrm>
          <a:prstGeom prst="rect">
            <a:avLst/>
          </a:prstGeom>
          <a:noFill/>
          <a:ln w="0">
            <a:noFill/>
          </a:ln>
        </p:spPr>
        <p:txBody>
          <a:bodyPr lIns="93960" rIns="93960" tIns="47160" bIns="47160" anchor="t">
            <a:normAutofit/>
          </a:bodyPr>
          <a:p>
            <a:pPr indent="0">
              <a:spcBef>
                <a:spcPts val="850"/>
              </a:spcBef>
              <a:buNone/>
              <a:tabLst>
                <a:tab algn="l" pos="939960"/>
                <a:tab algn="l" pos="1879560"/>
                <a:tab algn="l" pos="2819520"/>
                <a:tab algn="l" pos="3759120"/>
                <a:tab algn="l" pos="4699080"/>
                <a:tab algn="l" pos="5638680"/>
                <a:tab algn="l" pos="6578640"/>
                <a:tab algn="l" pos="7518240"/>
                <a:tab algn="l" pos="8458200"/>
                <a:tab algn="l" pos="9398160"/>
                <a:tab algn="l" pos="10337760"/>
              </a:tabLst>
            </a:pPr>
            <a:endParaRPr b="0" lang="en-US" sz="3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DB60A5F-B89D-41E3-9E2A-8532ACE8A04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66480" y="402840"/>
            <a:ext cx="6583320" cy="1676520"/>
          </a:xfrm>
          <a:prstGeom prst="rect">
            <a:avLst/>
          </a:prstGeom>
          <a:noFill/>
          <a:ln w="0">
            <a:noFill/>
          </a:ln>
        </p:spPr>
        <p:txBody>
          <a:bodyPr lIns="93960" rIns="93960" tIns="47160" bIns="47160" anchor="ctr">
            <a:noAutofit/>
          </a:bodyPr>
          <a:p>
            <a:pPr indent="0" algn="ctr">
              <a:buNone/>
              <a:tabLst>
                <a:tab algn="l" pos="0"/>
                <a:tab algn="l" pos="939960"/>
                <a:tab algn="l" pos="1879560"/>
                <a:tab algn="l" pos="2819520"/>
                <a:tab algn="l" pos="3759120"/>
                <a:tab algn="l" pos="4699080"/>
                <a:tab algn="l" pos="5638680"/>
                <a:tab algn="l" pos="6578640"/>
                <a:tab algn="l" pos="7518240"/>
                <a:tab algn="l" pos="8458200"/>
                <a:tab algn="l" pos="9398160"/>
                <a:tab algn="l" pos="10337760"/>
              </a:tabLst>
            </a:pPr>
            <a:endParaRPr b="0" lang="en-US" sz="4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66480" y="2346120"/>
            <a:ext cx="3212640" cy="6638760"/>
          </a:xfrm>
          <a:prstGeom prst="rect">
            <a:avLst/>
          </a:prstGeom>
          <a:noFill/>
          <a:ln w="0">
            <a:noFill/>
          </a:ln>
        </p:spPr>
        <p:txBody>
          <a:bodyPr lIns="93960" rIns="93960" tIns="47160" bIns="47160" anchor="t">
            <a:normAutofit/>
          </a:bodyPr>
          <a:p>
            <a:pPr indent="0">
              <a:spcBef>
                <a:spcPts val="850"/>
              </a:spcBef>
              <a:buNone/>
              <a:tabLst>
                <a:tab algn="l" pos="939960"/>
                <a:tab algn="l" pos="1879560"/>
                <a:tab algn="l" pos="2819520"/>
                <a:tab algn="l" pos="3759120"/>
                <a:tab algn="l" pos="4699080"/>
                <a:tab algn="l" pos="5638680"/>
                <a:tab algn="l" pos="6578640"/>
                <a:tab algn="l" pos="7518240"/>
                <a:tab algn="l" pos="8458200"/>
                <a:tab algn="l" pos="9398160"/>
                <a:tab algn="l" pos="10337760"/>
              </a:tabLst>
            </a:pPr>
            <a:endParaRPr b="0" lang="en-US" sz="3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740040" y="2346120"/>
            <a:ext cx="3212640" cy="6638760"/>
          </a:xfrm>
          <a:prstGeom prst="rect">
            <a:avLst/>
          </a:prstGeom>
          <a:noFill/>
          <a:ln w="0">
            <a:noFill/>
          </a:ln>
        </p:spPr>
        <p:txBody>
          <a:bodyPr lIns="93960" rIns="93960" tIns="47160" bIns="47160" anchor="t">
            <a:normAutofit/>
          </a:bodyPr>
          <a:p>
            <a:pPr indent="0">
              <a:spcBef>
                <a:spcPts val="850"/>
              </a:spcBef>
              <a:buNone/>
              <a:tabLst>
                <a:tab algn="l" pos="939960"/>
                <a:tab algn="l" pos="1879560"/>
                <a:tab algn="l" pos="2819520"/>
                <a:tab algn="l" pos="3759120"/>
                <a:tab algn="l" pos="4699080"/>
                <a:tab algn="l" pos="5638680"/>
                <a:tab algn="l" pos="6578640"/>
                <a:tab algn="l" pos="7518240"/>
                <a:tab algn="l" pos="8458200"/>
                <a:tab algn="l" pos="9398160"/>
                <a:tab algn="l" pos="10337760"/>
              </a:tabLst>
            </a:pPr>
            <a:endParaRPr b="0" lang="en-US" sz="3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771CF97-7E37-4385-BFE0-64BF76D7A6A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66480" y="402840"/>
            <a:ext cx="6583320" cy="1676520"/>
          </a:xfrm>
          <a:prstGeom prst="rect">
            <a:avLst/>
          </a:prstGeom>
          <a:noFill/>
          <a:ln w="0">
            <a:noFill/>
          </a:ln>
        </p:spPr>
        <p:txBody>
          <a:bodyPr lIns="93960" rIns="93960" tIns="47160" bIns="47160" anchor="ctr">
            <a:noAutofit/>
          </a:bodyPr>
          <a:p>
            <a:pPr indent="0" algn="ctr">
              <a:buNone/>
              <a:tabLst>
                <a:tab algn="l" pos="0"/>
                <a:tab algn="l" pos="939960"/>
                <a:tab algn="l" pos="1879560"/>
                <a:tab algn="l" pos="2819520"/>
                <a:tab algn="l" pos="3759120"/>
                <a:tab algn="l" pos="4699080"/>
                <a:tab algn="l" pos="5638680"/>
                <a:tab algn="l" pos="6578640"/>
                <a:tab algn="l" pos="7518240"/>
                <a:tab algn="l" pos="8458200"/>
                <a:tab algn="l" pos="9398160"/>
                <a:tab algn="l" pos="10337760"/>
              </a:tabLst>
            </a:pPr>
            <a:endParaRPr b="0" lang="en-US" sz="4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31EA6F5-6D87-4C41-9C31-55A7D00713A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66480" y="402840"/>
            <a:ext cx="6583320" cy="77727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850"/>
              </a:spcBef>
              <a:tabLst>
                <a:tab algn="l" pos="0"/>
                <a:tab algn="l" pos="939960"/>
                <a:tab algn="l" pos="1879560"/>
                <a:tab algn="l" pos="2819520"/>
                <a:tab algn="l" pos="3759120"/>
                <a:tab algn="l" pos="4699080"/>
                <a:tab algn="l" pos="5638680"/>
                <a:tab algn="l" pos="6578640"/>
                <a:tab algn="l" pos="7518240"/>
                <a:tab algn="l" pos="8458200"/>
                <a:tab algn="l" pos="9398160"/>
                <a:tab algn="l" pos="10337760"/>
              </a:tabLst>
            </a:pPr>
            <a:endParaRPr b="0" lang="en-US" sz="3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860F7CC-5D70-4C34-9139-82CCB863EA8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66480" y="402840"/>
            <a:ext cx="6583320" cy="1676520"/>
          </a:xfrm>
          <a:prstGeom prst="rect">
            <a:avLst/>
          </a:prstGeom>
          <a:noFill/>
          <a:ln w="0">
            <a:noFill/>
          </a:ln>
        </p:spPr>
        <p:txBody>
          <a:bodyPr lIns="93960" rIns="93960" tIns="47160" bIns="47160" anchor="ctr">
            <a:noAutofit/>
          </a:bodyPr>
          <a:p>
            <a:pPr indent="0" algn="ctr">
              <a:buNone/>
              <a:tabLst>
                <a:tab algn="l" pos="0"/>
                <a:tab algn="l" pos="939960"/>
                <a:tab algn="l" pos="1879560"/>
                <a:tab algn="l" pos="2819520"/>
                <a:tab algn="l" pos="3759120"/>
                <a:tab algn="l" pos="4699080"/>
                <a:tab algn="l" pos="5638680"/>
                <a:tab algn="l" pos="6578640"/>
                <a:tab algn="l" pos="7518240"/>
                <a:tab algn="l" pos="8458200"/>
                <a:tab algn="l" pos="9398160"/>
                <a:tab algn="l" pos="10337760"/>
              </a:tabLst>
            </a:pPr>
            <a:endParaRPr b="0" lang="en-US" sz="4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66480" y="2346120"/>
            <a:ext cx="3212640" cy="3166560"/>
          </a:xfrm>
          <a:prstGeom prst="rect">
            <a:avLst/>
          </a:prstGeom>
          <a:noFill/>
          <a:ln w="0">
            <a:noFill/>
          </a:ln>
        </p:spPr>
        <p:txBody>
          <a:bodyPr lIns="93960" rIns="93960" tIns="47160" bIns="47160" anchor="t">
            <a:normAutofit/>
          </a:bodyPr>
          <a:p>
            <a:pPr indent="0">
              <a:spcBef>
                <a:spcPts val="850"/>
              </a:spcBef>
              <a:buNone/>
              <a:tabLst>
                <a:tab algn="l" pos="939960"/>
                <a:tab algn="l" pos="1879560"/>
                <a:tab algn="l" pos="2819520"/>
                <a:tab algn="l" pos="3759120"/>
                <a:tab algn="l" pos="4699080"/>
                <a:tab algn="l" pos="5638680"/>
                <a:tab algn="l" pos="6578640"/>
                <a:tab algn="l" pos="7518240"/>
                <a:tab algn="l" pos="8458200"/>
                <a:tab algn="l" pos="9398160"/>
                <a:tab algn="l" pos="10337760"/>
              </a:tabLst>
            </a:pPr>
            <a:endParaRPr b="0" lang="en-US" sz="3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740040" y="2346120"/>
            <a:ext cx="3212640" cy="6638760"/>
          </a:xfrm>
          <a:prstGeom prst="rect">
            <a:avLst/>
          </a:prstGeom>
          <a:noFill/>
          <a:ln w="0">
            <a:noFill/>
          </a:ln>
        </p:spPr>
        <p:txBody>
          <a:bodyPr lIns="93960" rIns="93960" tIns="47160" bIns="47160" anchor="t">
            <a:normAutofit/>
          </a:bodyPr>
          <a:p>
            <a:pPr indent="0">
              <a:spcBef>
                <a:spcPts val="850"/>
              </a:spcBef>
              <a:buNone/>
              <a:tabLst>
                <a:tab algn="l" pos="939960"/>
                <a:tab algn="l" pos="1879560"/>
                <a:tab algn="l" pos="2819520"/>
                <a:tab algn="l" pos="3759120"/>
                <a:tab algn="l" pos="4699080"/>
                <a:tab algn="l" pos="5638680"/>
                <a:tab algn="l" pos="6578640"/>
                <a:tab algn="l" pos="7518240"/>
                <a:tab algn="l" pos="8458200"/>
                <a:tab algn="l" pos="9398160"/>
                <a:tab algn="l" pos="10337760"/>
              </a:tabLst>
            </a:pPr>
            <a:endParaRPr b="0" lang="en-US" sz="3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66480" y="5814000"/>
            <a:ext cx="3212640" cy="3166560"/>
          </a:xfrm>
          <a:prstGeom prst="rect">
            <a:avLst/>
          </a:prstGeom>
          <a:noFill/>
          <a:ln w="0">
            <a:noFill/>
          </a:ln>
        </p:spPr>
        <p:txBody>
          <a:bodyPr lIns="93960" rIns="93960" tIns="47160" bIns="47160" anchor="t">
            <a:normAutofit/>
          </a:bodyPr>
          <a:p>
            <a:pPr indent="0">
              <a:spcBef>
                <a:spcPts val="850"/>
              </a:spcBef>
              <a:buNone/>
              <a:tabLst>
                <a:tab algn="l" pos="939960"/>
                <a:tab algn="l" pos="1879560"/>
                <a:tab algn="l" pos="2819520"/>
                <a:tab algn="l" pos="3759120"/>
                <a:tab algn="l" pos="4699080"/>
                <a:tab algn="l" pos="5638680"/>
                <a:tab algn="l" pos="6578640"/>
                <a:tab algn="l" pos="7518240"/>
                <a:tab algn="l" pos="8458200"/>
                <a:tab algn="l" pos="9398160"/>
                <a:tab algn="l" pos="10337760"/>
              </a:tabLst>
            </a:pPr>
            <a:endParaRPr b="0" lang="en-US" sz="3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C864E47-A247-460B-8CE5-04790AF2902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66480" y="402840"/>
            <a:ext cx="6583320" cy="1676520"/>
          </a:xfrm>
          <a:prstGeom prst="rect">
            <a:avLst/>
          </a:prstGeom>
          <a:noFill/>
          <a:ln w="0">
            <a:noFill/>
          </a:ln>
        </p:spPr>
        <p:txBody>
          <a:bodyPr lIns="93960" rIns="93960" tIns="47160" bIns="47160" anchor="ctr">
            <a:noAutofit/>
          </a:bodyPr>
          <a:p>
            <a:pPr indent="0" algn="ctr">
              <a:buNone/>
              <a:tabLst>
                <a:tab algn="l" pos="0"/>
                <a:tab algn="l" pos="939960"/>
                <a:tab algn="l" pos="1879560"/>
                <a:tab algn="l" pos="2819520"/>
                <a:tab algn="l" pos="3759120"/>
                <a:tab algn="l" pos="4699080"/>
                <a:tab algn="l" pos="5638680"/>
                <a:tab algn="l" pos="6578640"/>
                <a:tab algn="l" pos="7518240"/>
                <a:tab algn="l" pos="8458200"/>
                <a:tab algn="l" pos="9398160"/>
                <a:tab algn="l" pos="10337760"/>
              </a:tabLst>
            </a:pPr>
            <a:endParaRPr b="0" lang="en-US" sz="4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66480" y="2346120"/>
            <a:ext cx="3212640" cy="6638760"/>
          </a:xfrm>
          <a:prstGeom prst="rect">
            <a:avLst/>
          </a:prstGeom>
          <a:noFill/>
          <a:ln w="0">
            <a:noFill/>
          </a:ln>
        </p:spPr>
        <p:txBody>
          <a:bodyPr lIns="93960" rIns="93960" tIns="47160" bIns="47160" anchor="t">
            <a:normAutofit/>
          </a:bodyPr>
          <a:p>
            <a:pPr indent="0">
              <a:spcBef>
                <a:spcPts val="850"/>
              </a:spcBef>
              <a:buNone/>
              <a:tabLst>
                <a:tab algn="l" pos="939960"/>
                <a:tab algn="l" pos="1879560"/>
                <a:tab algn="l" pos="2819520"/>
                <a:tab algn="l" pos="3759120"/>
                <a:tab algn="l" pos="4699080"/>
                <a:tab algn="l" pos="5638680"/>
                <a:tab algn="l" pos="6578640"/>
                <a:tab algn="l" pos="7518240"/>
                <a:tab algn="l" pos="8458200"/>
                <a:tab algn="l" pos="9398160"/>
                <a:tab algn="l" pos="10337760"/>
              </a:tabLst>
            </a:pPr>
            <a:endParaRPr b="0" lang="en-US" sz="3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740040" y="2346120"/>
            <a:ext cx="3212640" cy="3166560"/>
          </a:xfrm>
          <a:prstGeom prst="rect">
            <a:avLst/>
          </a:prstGeom>
          <a:noFill/>
          <a:ln w="0">
            <a:noFill/>
          </a:ln>
        </p:spPr>
        <p:txBody>
          <a:bodyPr lIns="93960" rIns="93960" tIns="47160" bIns="47160" anchor="t">
            <a:normAutofit/>
          </a:bodyPr>
          <a:p>
            <a:pPr indent="0">
              <a:spcBef>
                <a:spcPts val="850"/>
              </a:spcBef>
              <a:buNone/>
              <a:tabLst>
                <a:tab algn="l" pos="939960"/>
                <a:tab algn="l" pos="1879560"/>
                <a:tab algn="l" pos="2819520"/>
                <a:tab algn="l" pos="3759120"/>
                <a:tab algn="l" pos="4699080"/>
                <a:tab algn="l" pos="5638680"/>
                <a:tab algn="l" pos="6578640"/>
                <a:tab algn="l" pos="7518240"/>
                <a:tab algn="l" pos="8458200"/>
                <a:tab algn="l" pos="9398160"/>
                <a:tab algn="l" pos="10337760"/>
              </a:tabLst>
            </a:pPr>
            <a:endParaRPr b="0" lang="en-US" sz="3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740040" y="5814000"/>
            <a:ext cx="3212640" cy="3166560"/>
          </a:xfrm>
          <a:prstGeom prst="rect">
            <a:avLst/>
          </a:prstGeom>
          <a:noFill/>
          <a:ln w="0">
            <a:noFill/>
          </a:ln>
        </p:spPr>
        <p:txBody>
          <a:bodyPr lIns="93960" rIns="93960" tIns="47160" bIns="47160" anchor="t">
            <a:normAutofit/>
          </a:bodyPr>
          <a:p>
            <a:pPr indent="0">
              <a:spcBef>
                <a:spcPts val="850"/>
              </a:spcBef>
              <a:buNone/>
              <a:tabLst>
                <a:tab algn="l" pos="939960"/>
                <a:tab algn="l" pos="1879560"/>
                <a:tab algn="l" pos="2819520"/>
                <a:tab algn="l" pos="3759120"/>
                <a:tab algn="l" pos="4699080"/>
                <a:tab algn="l" pos="5638680"/>
                <a:tab algn="l" pos="6578640"/>
                <a:tab algn="l" pos="7518240"/>
                <a:tab algn="l" pos="8458200"/>
                <a:tab algn="l" pos="9398160"/>
                <a:tab algn="l" pos="10337760"/>
              </a:tabLst>
            </a:pPr>
            <a:endParaRPr b="0" lang="en-US" sz="3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C53C74B-0825-40B6-B528-B1C183AEF4A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66480" y="402840"/>
            <a:ext cx="6583320" cy="1676520"/>
          </a:xfrm>
          <a:prstGeom prst="rect">
            <a:avLst/>
          </a:prstGeom>
          <a:noFill/>
          <a:ln w="0">
            <a:noFill/>
          </a:ln>
        </p:spPr>
        <p:txBody>
          <a:bodyPr lIns="93960" rIns="93960" tIns="47160" bIns="47160" anchor="ctr">
            <a:noAutofit/>
          </a:bodyPr>
          <a:p>
            <a:pPr indent="0" algn="ctr">
              <a:buNone/>
              <a:tabLst>
                <a:tab algn="l" pos="0"/>
                <a:tab algn="l" pos="939960"/>
                <a:tab algn="l" pos="1879560"/>
                <a:tab algn="l" pos="2819520"/>
                <a:tab algn="l" pos="3759120"/>
                <a:tab algn="l" pos="4699080"/>
                <a:tab algn="l" pos="5638680"/>
                <a:tab algn="l" pos="6578640"/>
                <a:tab algn="l" pos="7518240"/>
                <a:tab algn="l" pos="8458200"/>
                <a:tab algn="l" pos="9398160"/>
                <a:tab algn="l" pos="10337760"/>
              </a:tabLst>
            </a:pPr>
            <a:endParaRPr b="0" lang="en-US" sz="4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66480" y="2346120"/>
            <a:ext cx="3212640" cy="3166560"/>
          </a:xfrm>
          <a:prstGeom prst="rect">
            <a:avLst/>
          </a:prstGeom>
          <a:noFill/>
          <a:ln w="0">
            <a:noFill/>
          </a:ln>
        </p:spPr>
        <p:txBody>
          <a:bodyPr lIns="93960" rIns="93960" tIns="47160" bIns="47160" anchor="t">
            <a:normAutofit/>
          </a:bodyPr>
          <a:p>
            <a:pPr indent="0">
              <a:spcBef>
                <a:spcPts val="850"/>
              </a:spcBef>
              <a:buNone/>
              <a:tabLst>
                <a:tab algn="l" pos="939960"/>
                <a:tab algn="l" pos="1879560"/>
                <a:tab algn="l" pos="2819520"/>
                <a:tab algn="l" pos="3759120"/>
                <a:tab algn="l" pos="4699080"/>
                <a:tab algn="l" pos="5638680"/>
                <a:tab algn="l" pos="6578640"/>
                <a:tab algn="l" pos="7518240"/>
                <a:tab algn="l" pos="8458200"/>
                <a:tab algn="l" pos="9398160"/>
                <a:tab algn="l" pos="10337760"/>
              </a:tabLst>
            </a:pPr>
            <a:endParaRPr b="0" lang="en-US" sz="3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740040" y="2346120"/>
            <a:ext cx="3212640" cy="3166560"/>
          </a:xfrm>
          <a:prstGeom prst="rect">
            <a:avLst/>
          </a:prstGeom>
          <a:noFill/>
          <a:ln w="0">
            <a:noFill/>
          </a:ln>
        </p:spPr>
        <p:txBody>
          <a:bodyPr lIns="93960" rIns="93960" tIns="47160" bIns="47160" anchor="t">
            <a:normAutofit/>
          </a:bodyPr>
          <a:p>
            <a:pPr indent="0">
              <a:spcBef>
                <a:spcPts val="850"/>
              </a:spcBef>
              <a:buNone/>
              <a:tabLst>
                <a:tab algn="l" pos="939960"/>
                <a:tab algn="l" pos="1879560"/>
                <a:tab algn="l" pos="2819520"/>
                <a:tab algn="l" pos="3759120"/>
                <a:tab algn="l" pos="4699080"/>
                <a:tab algn="l" pos="5638680"/>
                <a:tab algn="l" pos="6578640"/>
                <a:tab algn="l" pos="7518240"/>
                <a:tab algn="l" pos="8458200"/>
                <a:tab algn="l" pos="9398160"/>
                <a:tab algn="l" pos="10337760"/>
              </a:tabLst>
            </a:pPr>
            <a:endParaRPr b="0" lang="en-US" sz="3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66480" y="5814000"/>
            <a:ext cx="6583320" cy="3166560"/>
          </a:xfrm>
          <a:prstGeom prst="rect">
            <a:avLst/>
          </a:prstGeom>
          <a:noFill/>
          <a:ln w="0">
            <a:noFill/>
          </a:ln>
        </p:spPr>
        <p:txBody>
          <a:bodyPr lIns="93960" rIns="93960" tIns="47160" bIns="47160" anchor="t">
            <a:normAutofit/>
          </a:bodyPr>
          <a:p>
            <a:pPr indent="0">
              <a:spcBef>
                <a:spcPts val="850"/>
              </a:spcBef>
              <a:buNone/>
              <a:tabLst>
                <a:tab algn="l" pos="939960"/>
                <a:tab algn="l" pos="1879560"/>
                <a:tab algn="l" pos="2819520"/>
                <a:tab algn="l" pos="3759120"/>
                <a:tab algn="l" pos="4699080"/>
                <a:tab algn="l" pos="5638680"/>
                <a:tab algn="l" pos="6578640"/>
                <a:tab algn="l" pos="7518240"/>
                <a:tab algn="l" pos="8458200"/>
                <a:tab algn="l" pos="9398160"/>
                <a:tab algn="l" pos="10337760"/>
              </a:tabLst>
            </a:pPr>
            <a:endParaRPr b="0" lang="en-US" sz="3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A24506D-DD35-4794-9EFA-5711AEC4406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66480" y="402840"/>
            <a:ext cx="6583320" cy="1676520"/>
          </a:xfrm>
          <a:prstGeom prst="rect">
            <a:avLst/>
          </a:prstGeom>
          <a:noFill/>
          <a:ln w="0">
            <a:noFill/>
          </a:ln>
        </p:spPr>
        <p:txBody>
          <a:bodyPr lIns="93960" rIns="93960" tIns="47160" bIns="47160" anchor="ctr">
            <a:noAutofit/>
          </a:bodyPr>
          <a:p>
            <a:pPr indent="0" algn="ctr">
              <a:buNone/>
              <a:tabLst>
                <a:tab algn="l" pos="0"/>
                <a:tab algn="l" pos="939960"/>
                <a:tab algn="l" pos="1879560"/>
                <a:tab algn="l" pos="2819520"/>
                <a:tab algn="l" pos="3759120"/>
                <a:tab algn="l" pos="4699080"/>
                <a:tab algn="l" pos="5638680"/>
                <a:tab algn="l" pos="6578640"/>
                <a:tab algn="l" pos="7518240"/>
                <a:tab algn="l" pos="8458200"/>
                <a:tab algn="l" pos="9398160"/>
                <a:tab algn="l" pos="10337760"/>
              </a:tabLst>
            </a:pPr>
            <a:r>
              <a:rPr b="0" lang="en-US" sz="46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66480" y="2346120"/>
            <a:ext cx="6583320" cy="6638760"/>
          </a:xfrm>
          <a:prstGeom prst="rect">
            <a:avLst/>
          </a:prstGeom>
          <a:noFill/>
          <a:ln w="0">
            <a:noFill/>
          </a:ln>
        </p:spPr>
        <p:txBody>
          <a:bodyPr lIns="93960" rIns="93960" tIns="47160" bIns="47160" anchor="t">
            <a:normAutofit/>
          </a:bodyPr>
          <a:p>
            <a:pPr marL="353880" indent="-353880">
              <a:spcBef>
                <a:spcPts val="850"/>
              </a:spcBef>
              <a:buClr>
                <a:srgbClr val="000000"/>
              </a:buClr>
              <a:buFont typeface="Arial"/>
              <a:buChar char="•"/>
              <a:tabLst>
                <a:tab algn="l" pos="939960"/>
                <a:tab algn="l" pos="1879560"/>
                <a:tab algn="l" pos="2819520"/>
                <a:tab algn="l" pos="3759120"/>
                <a:tab algn="l" pos="4699080"/>
                <a:tab algn="l" pos="5638680"/>
                <a:tab algn="l" pos="6578640"/>
                <a:tab algn="l" pos="7518240"/>
                <a:tab algn="l" pos="8458200"/>
                <a:tab algn="l" pos="9398160"/>
                <a:tab algn="l" pos="10337760"/>
              </a:tabLst>
            </a:pPr>
            <a:r>
              <a:rPr b="0" lang="en-US" sz="34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400" spc="-1" strike="noStrike">
              <a:solidFill>
                <a:srgbClr val="000000"/>
              </a:solidFill>
              <a:latin typeface="Arial"/>
            </a:endParaRPr>
          </a:p>
          <a:p>
            <a:pPr lvl="1" marL="763560" indent="-293760">
              <a:spcBef>
                <a:spcPts val="850"/>
              </a:spcBef>
              <a:buClr>
                <a:srgbClr val="000000"/>
              </a:buClr>
              <a:buFont typeface="Arial"/>
              <a:buChar char="–"/>
              <a:tabLst>
                <a:tab algn="l" pos="939960"/>
                <a:tab algn="l" pos="1879560"/>
                <a:tab algn="l" pos="2819520"/>
                <a:tab algn="l" pos="3759120"/>
                <a:tab algn="l" pos="4699080"/>
                <a:tab algn="l" pos="5638680"/>
                <a:tab algn="l" pos="6578640"/>
                <a:tab algn="l" pos="7518240"/>
                <a:tab algn="l" pos="8458200"/>
                <a:tab algn="l" pos="9398160"/>
                <a:tab algn="l" pos="10337760"/>
              </a:tabLst>
            </a:pPr>
            <a:r>
              <a:rPr b="0" lang="en-US" sz="34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400" spc="-1" strike="noStrike">
              <a:solidFill>
                <a:srgbClr val="000000"/>
              </a:solidFill>
              <a:latin typeface="Arial"/>
            </a:endParaRPr>
          </a:p>
          <a:p>
            <a:pPr lvl="2" marL="1174680" indent="-234720">
              <a:spcBef>
                <a:spcPts val="850"/>
              </a:spcBef>
              <a:buClr>
                <a:srgbClr val="000000"/>
              </a:buClr>
              <a:buFont typeface="Arial"/>
              <a:buChar char="•"/>
              <a:tabLst>
                <a:tab algn="l" pos="939960"/>
                <a:tab algn="l" pos="1879560"/>
                <a:tab algn="l" pos="2819520"/>
                <a:tab algn="l" pos="3759120"/>
                <a:tab algn="l" pos="4699080"/>
                <a:tab algn="l" pos="5638680"/>
                <a:tab algn="l" pos="6578640"/>
                <a:tab algn="l" pos="7518240"/>
                <a:tab algn="l" pos="8458200"/>
                <a:tab algn="l" pos="9398160"/>
                <a:tab algn="l" pos="10337760"/>
              </a:tabLst>
            </a:pPr>
            <a:r>
              <a:rPr b="0" lang="en-US" sz="34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400" spc="-1" strike="noStrike">
              <a:solidFill>
                <a:srgbClr val="000000"/>
              </a:solidFill>
              <a:latin typeface="Arial"/>
            </a:endParaRPr>
          </a:p>
          <a:p>
            <a:pPr lvl="3" marL="1646280" indent="-236520">
              <a:spcBef>
                <a:spcPts val="850"/>
              </a:spcBef>
              <a:buClr>
                <a:srgbClr val="000000"/>
              </a:buClr>
              <a:buFont typeface="Arial"/>
              <a:buChar char="–"/>
              <a:tabLst>
                <a:tab algn="l" pos="939960"/>
                <a:tab algn="l" pos="1879560"/>
                <a:tab algn="l" pos="2819520"/>
                <a:tab algn="l" pos="3759120"/>
                <a:tab algn="l" pos="4699080"/>
                <a:tab algn="l" pos="5638680"/>
                <a:tab algn="l" pos="6578640"/>
                <a:tab algn="l" pos="7518240"/>
                <a:tab algn="l" pos="8458200"/>
                <a:tab algn="l" pos="9398160"/>
                <a:tab algn="l" pos="10337760"/>
              </a:tabLst>
            </a:pPr>
            <a:r>
              <a:rPr b="0" lang="en-US" sz="34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400" spc="-1" strike="noStrike">
              <a:solidFill>
                <a:srgbClr val="000000"/>
              </a:solidFill>
              <a:latin typeface="Arial"/>
            </a:endParaRPr>
          </a:p>
          <a:p>
            <a:pPr lvl="4" marL="2116080" indent="-234720">
              <a:spcBef>
                <a:spcPts val="850"/>
              </a:spcBef>
              <a:buClr>
                <a:srgbClr val="000000"/>
              </a:buClr>
              <a:buFont typeface="Arial"/>
              <a:buChar char="»"/>
              <a:tabLst>
                <a:tab algn="l" pos="939960"/>
                <a:tab algn="l" pos="1879560"/>
                <a:tab algn="l" pos="2819520"/>
                <a:tab algn="l" pos="3759120"/>
                <a:tab algn="l" pos="4699080"/>
                <a:tab algn="l" pos="5638680"/>
                <a:tab algn="l" pos="6578640"/>
                <a:tab algn="l" pos="7518240"/>
                <a:tab algn="l" pos="8458200"/>
                <a:tab algn="l" pos="9398160"/>
                <a:tab algn="l" pos="10337760"/>
              </a:tabLst>
            </a:pPr>
            <a:r>
              <a:rPr b="0" lang="en-US" sz="34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400" spc="-1" strike="noStrike">
              <a:solidFill>
                <a:srgbClr val="000000"/>
              </a:solidFill>
              <a:latin typeface="Arial"/>
            </a:endParaRPr>
          </a:p>
          <a:p>
            <a:pPr lvl="5" marL="2116080" indent="-234720">
              <a:spcBef>
                <a:spcPts val="850"/>
              </a:spcBef>
              <a:buClr>
                <a:srgbClr val="000000"/>
              </a:buClr>
              <a:buFont typeface="Arial"/>
              <a:buChar char="»"/>
              <a:tabLst>
                <a:tab algn="l" pos="939960"/>
                <a:tab algn="l" pos="1879560"/>
                <a:tab algn="l" pos="2819520"/>
                <a:tab algn="l" pos="3759120"/>
                <a:tab algn="l" pos="4699080"/>
                <a:tab algn="l" pos="5638680"/>
                <a:tab algn="l" pos="6578640"/>
                <a:tab algn="l" pos="7518240"/>
                <a:tab algn="l" pos="8458200"/>
                <a:tab algn="l" pos="9398160"/>
                <a:tab algn="l" pos="10337760"/>
              </a:tabLst>
            </a:pPr>
            <a:r>
              <a:rPr b="0" lang="en-US" sz="34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400" spc="-1" strike="noStrike">
              <a:solidFill>
                <a:srgbClr val="000000"/>
              </a:solidFill>
              <a:latin typeface="Arial"/>
            </a:endParaRPr>
          </a:p>
          <a:p>
            <a:pPr lvl="6" marL="2116080" indent="-234720">
              <a:spcBef>
                <a:spcPts val="850"/>
              </a:spcBef>
              <a:buClr>
                <a:srgbClr val="000000"/>
              </a:buClr>
              <a:buFont typeface="Arial"/>
              <a:buChar char="»"/>
              <a:tabLst>
                <a:tab algn="l" pos="939960"/>
                <a:tab algn="l" pos="1879560"/>
                <a:tab algn="l" pos="2819520"/>
                <a:tab algn="l" pos="3759120"/>
                <a:tab algn="l" pos="4699080"/>
                <a:tab algn="l" pos="5638680"/>
                <a:tab algn="l" pos="6578640"/>
                <a:tab algn="l" pos="7518240"/>
                <a:tab algn="l" pos="8458200"/>
                <a:tab algn="l" pos="9398160"/>
                <a:tab algn="l" pos="10337760"/>
              </a:tabLst>
            </a:pPr>
            <a:r>
              <a:rPr b="0" lang="en-US" sz="34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66840" y="9159840"/>
            <a:ext cx="1706400" cy="698400"/>
          </a:xfrm>
          <a:prstGeom prst="rect">
            <a:avLst/>
          </a:prstGeom>
          <a:noFill/>
          <a:ln w="0">
            <a:noFill/>
          </a:ln>
        </p:spPr>
        <p:txBody>
          <a:bodyPr lIns="93960" rIns="93960" tIns="47160" bIns="47160" anchor="t">
            <a:noAutofit/>
          </a:bodyPr>
          <a:lstStyle>
            <a:lvl1pPr indent="0">
              <a:buNone/>
              <a:tabLst>
                <a:tab algn="l" pos="0"/>
                <a:tab algn="l" pos="939960"/>
                <a:tab algn="l" pos="1879560"/>
                <a:tab algn="l" pos="2819520"/>
                <a:tab algn="l" pos="3759120"/>
                <a:tab algn="l" pos="4699080"/>
                <a:tab algn="l" pos="5638680"/>
                <a:tab algn="l" pos="6578640"/>
                <a:tab algn="l" pos="7518240"/>
                <a:tab algn="l" pos="8458200"/>
                <a:tab algn="l" pos="9398160"/>
                <a:tab algn="l" pos="1033776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39960"/>
                <a:tab algn="l" pos="1879560"/>
                <a:tab algn="l" pos="2819520"/>
                <a:tab algn="l" pos="3759120"/>
                <a:tab algn="l" pos="4699080"/>
                <a:tab algn="l" pos="5638680"/>
                <a:tab algn="l" pos="6578640"/>
                <a:tab algn="l" pos="7518240"/>
                <a:tab algn="l" pos="8458200"/>
                <a:tab algn="l" pos="9398160"/>
                <a:tab algn="l" pos="1033776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500200" y="9159840"/>
            <a:ext cx="2316240" cy="698400"/>
          </a:xfrm>
          <a:prstGeom prst="rect">
            <a:avLst/>
          </a:prstGeom>
          <a:noFill/>
          <a:ln w="0">
            <a:noFill/>
          </a:ln>
        </p:spPr>
        <p:txBody>
          <a:bodyPr lIns="93960" rIns="93960" tIns="47160" bIns="47160" anchor="t">
            <a:noAutofit/>
          </a:bodyPr>
          <a:lstStyle>
            <a:lvl1pPr indent="0" algn="ctr">
              <a:buNone/>
              <a:tabLst>
                <a:tab algn="l" pos="0"/>
                <a:tab algn="l" pos="939960"/>
                <a:tab algn="l" pos="1879560"/>
                <a:tab algn="l" pos="2819520"/>
                <a:tab algn="l" pos="3759120"/>
                <a:tab algn="l" pos="4699080"/>
                <a:tab algn="l" pos="5638680"/>
                <a:tab algn="l" pos="6578640"/>
                <a:tab algn="l" pos="7518240"/>
                <a:tab algn="l" pos="8458200"/>
                <a:tab algn="l" pos="9398160"/>
                <a:tab algn="l" pos="1033776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39960"/>
                <a:tab algn="l" pos="1879560"/>
                <a:tab algn="l" pos="2819520"/>
                <a:tab algn="l" pos="3759120"/>
                <a:tab algn="l" pos="4699080"/>
                <a:tab algn="l" pos="5638680"/>
                <a:tab algn="l" pos="6578640"/>
                <a:tab algn="l" pos="7518240"/>
                <a:tab algn="l" pos="8458200"/>
                <a:tab algn="l" pos="9398160"/>
                <a:tab algn="l" pos="1033776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5243040" y="9159840"/>
            <a:ext cx="1706760" cy="698400"/>
          </a:xfrm>
          <a:prstGeom prst="rect">
            <a:avLst/>
          </a:prstGeom>
          <a:noFill/>
          <a:ln w="0">
            <a:noFill/>
          </a:ln>
        </p:spPr>
        <p:txBody>
          <a:bodyPr lIns="93960" rIns="93960" tIns="47160" bIns="47160" anchor="t">
            <a:noAutofit/>
          </a:bodyPr>
          <a:lstStyle>
            <a:lvl1pPr indent="0" algn="r">
              <a:buNone/>
              <a:tabLst>
                <a:tab algn="l" pos="0"/>
                <a:tab algn="l" pos="939960"/>
                <a:tab algn="l" pos="1879560"/>
                <a:tab algn="l" pos="2819520"/>
                <a:tab algn="l" pos="3759120"/>
                <a:tab algn="l" pos="4699080"/>
                <a:tab algn="l" pos="5638680"/>
                <a:tab algn="l" pos="6578640"/>
                <a:tab algn="l" pos="7518240"/>
                <a:tab algn="l" pos="8458200"/>
                <a:tab algn="l" pos="9398160"/>
                <a:tab algn="l" pos="1033776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39960"/>
                <a:tab algn="l" pos="1879560"/>
                <a:tab algn="l" pos="2819520"/>
                <a:tab algn="l" pos="3759120"/>
                <a:tab algn="l" pos="4699080"/>
                <a:tab algn="l" pos="5638680"/>
                <a:tab algn="l" pos="6578640"/>
                <a:tab algn="l" pos="7518240"/>
                <a:tab algn="l" pos="8458200"/>
                <a:tab algn="l" pos="9398160"/>
                <a:tab algn="l" pos="10337760"/>
              </a:tabLst>
            </a:pPr>
            <a:fld id="{4D006E98-1A0D-4DA5-B889-4DE155471617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2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"/>
          <p:cNvGrpSpPr/>
          <p:nvPr/>
        </p:nvGrpSpPr>
        <p:grpSpPr>
          <a:xfrm>
            <a:off x="476280" y="266400"/>
            <a:ext cx="6532200" cy="9348120"/>
            <a:chOff x="476280" y="266400"/>
            <a:chExt cx="6532200" cy="9348120"/>
          </a:xfrm>
        </p:grpSpPr>
        <p:grpSp>
          <p:nvGrpSpPr>
            <p:cNvPr id="42" name=""/>
            <p:cNvGrpSpPr/>
            <p:nvPr/>
          </p:nvGrpSpPr>
          <p:grpSpPr>
            <a:xfrm>
              <a:off x="476280" y="266400"/>
              <a:ext cx="6532200" cy="8811360"/>
              <a:chOff x="476280" y="266400"/>
              <a:chExt cx="6532200" cy="8811360"/>
            </a:xfrm>
          </p:grpSpPr>
          <p:sp>
            <p:nvSpPr>
              <p:cNvPr id="43" name=""/>
              <p:cNvSpPr/>
              <p:nvPr/>
            </p:nvSpPr>
            <p:spPr>
              <a:xfrm>
                <a:off x="5699520" y="268200"/>
                <a:ext cx="1220040" cy="213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1149480"/>
                    <a:tab algn="l" pos="2298600"/>
                    <a:tab algn="l" pos="3448080"/>
                    <a:tab algn="l" pos="4597560"/>
                    <a:tab algn="l" pos="5746680"/>
                    <a:tab algn="l" pos="6896160"/>
                    <a:tab algn="l" pos="8045280"/>
                    <a:tab algn="l" pos="9194760"/>
                    <a:tab algn="l" pos="10344240"/>
                  </a:tabLst>
                </a:pPr>
                <a:r>
                  <a:rPr b="1" lang="en-US" sz="14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1" lang="en-US" sz="1400" spc="-1" strike="noStrike">
                    <a:solidFill>
                      <a:srgbClr val="000000"/>
                    </a:solidFill>
                    <a:latin typeface="Arial"/>
                  </a:rPr>
                  <a:t>BraA.GRF14.r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4" name=""/>
              <p:cNvSpPr/>
              <p:nvPr/>
            </p:nvSpPr>
            <p:spPr>
              <a:xfrm>
                <a:off x="5254560" y="407880"/>
                <a:ext cx="179640" cy="90360"/>
              </a:xfrm>
              <a:custGeom>
                <a:avLst/>
                <a:gdLst/>
                <a:ahLst/>
                <a:rect l="l" t="t" r="r" b="b"/>
                <a:pathLst>
                  <a:path w="113" h="57">
                    <a:moveTo>
                      <a:pt x="0" y="57"/>
                    </a:moveTo>
                    <a:lnTo>
                      <a:pt x="0" y="0"/>
                    </a:lnTo>
                    <a:lnTo>
                      <a:pt x="113" y="0"/>
                    </a:lnTo>
                  </a:path>
                </a:pathLst>
              </a:custGeom>
              <a:noFill/>
              <a:ln w="255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3560" bIns="43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5" name=""/>
              <p:cNvSpPr/>
              <p:nvPr/>
            </p:nvSpPr>
            <p:spPr>
              <a:xfrm>
                <a:off x="5699520" y="472680"/>
                <a:ext cx="1248840" cy="213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1149480"/>
                    <a:tab algn="l" pos="2298600"/>
                    <a:tab algn="l" pos="3448080"/>
                    <a:tab algn="l" pos="4597560"/>
                    <a:tab algn="l" pos="5746680"/>
                    <a:tab algn="l" pos="6896160"/>
                    <a:tab algn="l" pos="8045280"/>
                    <a:tab algn="l" pos="9194760"/>
                    <a:tab algn="l" pos="10344240"/>
                  </a:tabLst>
                </a:pPr>
                <a:r>
                  <a:rPr b="1" lang="en-US" sz="14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1" lang="en-US" sz="1400" spc="-1" strike="noStrike">
                    <a:solidFill>
                      <a:srgbClr val="000000"/>
                    </a:solidFill>
                    <a:latin typeface="Arial"/>
                  </a:rPr>
                  <a:t>BraA.GRF14.s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6" name=""/>
              <p:cNvSpPr/>
              <p:nvPr/>
            </p:nvSpPr>
            <p:spPr>
              <a:xfrm>
                <a:off x="5254560" y="523800"/>
                <a:ext cx="179640" cy="88560"/>
              </a:xfrm>
              <a:custGeom>
                <a:avLst/>
                <a:gdLst/>
                <a:ahLst/>
                <a:rect l="l" t="t" r="r" b="b"/>
                <a:pathLst>
                  <a:path w="113" h="56">
                    <a:moveTo>
                      <a:pt x="0" y="0"/>
                    </a:moveTo>
                    <a:lnTo>
                      <a:pt x="0" y="56"/>
                    </a:lnTo>
                    <a:lnTo>
                      <a:pt x="113" y="56"/>
                    </a:lnTo>
                  </a:path>
                </a:pathLst>
              </a:custGeom>
              <a:noFill/>
              <a:ln w="255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1760" bIns="41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7" name=""/>
              <p:cNvSpPr/>
              <p:nvPr/>
            </p:nvSpPr>
            <p:spPr>
              <a:xfrm>
                <a:off x="5164200" y="510840"/>
                <a:ext cx="90360" cy="139680"/>
              </a:xfrm>
              <a:custGeom>
                <a:avLst/>
                <a:gdLst/>
                <a:ahLst/>
                <a:rect l="l" t="t" r="r" b="b"/>
                <a:pathLst>
                  <a:path w="57" h="88">
                    <a:moveTo>
                      <a:pt x="0" y="88"/>
                    </a:moveTo>
                    <a:lnTo>
                      <a:pt x="0" y="0"/>
                    </a:lnTo>
                    <a:lnTo>
                      <a:pt x="57" y="0"/>
                    </a:lnTo>
                  </a:path>
                </a:pathLst>
              </a:custGeom>
              <a:noFill/>
              <a:ln w="255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8" name=""/>
              <p:cNvSpPr/>
              <p:nvPr/>
            </p:nvSpPr>
            <p:spPr>
              <a:xfrm>
                <a:off x="5700960" y="676080"/>
                <a:ext cx="712440" cy="213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1149480"/>
                    <a:tab algn="l" pos="2298600"/>
                    <a:tab algn="l" pos="3448080"/>
                    <a:tab algn="l" pos="4597560"/>
                    <a:tab algn="l" pos="5746680"/>
                    <a:tab algn="l" pos="6896160"/>
                    <a:tab algn="l" pos="8045280"/>
                    <a:tab algn="l" pos="9194760"/>
                    <a:tab algn="l" pos="10344240"/>
                  </a:tabLst>
                </a:pPr>
                <a:r>
                  <a:rPr b="1" lang="en-US" sz="14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1" lang="en-US" sz="1400" spc="-1" strike="noStrike">
                    <a:solidFill>
                      <a:srgbClr val="000000"/>
                    </a:solidFill>
                    <a:latin typeface="Arial"/>
                  </a:rPr>
                  <a:t>AtGRF4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9" name=""/>
              <p:cNvSpPr/>
              <p:nvPr/>
            </p:nvSpPr>
            <p:spPr>
              <a:xfrm>
                <a:off x="5164200" y="676080"/>
                <a:ext cx="270000" cy="141120"/>
              </a:xfrm>
              <a:custGeom>
                <a:avLst/>
                <a:gdLst/>
                <a:ahLst/>
                <a:rect l="l" t="t" r="r" b="b"/>
                <a:pathLst>
                  <a:path w="170" h="89">
                    <a:moveTo>
                      <a:pt x="0" y="0"/>
                    </a:moveTo>
                    <a:lnTo>
                      <a:pt x="0" y="89"/>
                    </a:lnTo>
                    <a:lnTo>
                      <a:pt x="170" y="89"/>
                    </a:lnTo>
                  </a:path>
                </a:pathLst>
              </a:custGeom>
              <a:noFill/>
              <a:ln w="255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0" name=""/>
              <p:cNvSpPr/>
              <p:nvPr/>
            </p:nvSpPr>
            <p:spPr>
              <a:xfrm>
                <a:off x="4998960" y="663480"/>
                <a:ext cx="165240" cy="166680"/>
              </a:xfrm>
              <a:custGeom>
                <a:avLst/>
                <a:gdLst/>
                <a:ahLst/>
                <a:rect l="l" t="t" r="r" b="b"/>
                <a:pathLst>
                  <a:path w="104" h="105">
                    <a:moveTo>
                      <a:pt x="0" y="105"/>
                    </a:moveTo>
                    <a:lnTo>
                      <a:pt x="0" y="0"/>
                    </a:lnTo>
                    <a:lnTo>
                      <a:pt x="104" y="0"/>
                    </a:lnTo>
                  </a:path>
                </a:pathLst>
              </a:custGeom>
              <a:noFill/>
              <a:ln w="255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1" name=""/>
              <p:cNvSpPr/>
              <p:nvPr/>
            </p:nvSpPr>
            <p:spPr>
              <a:xfrm>
                <a:off x="5700960" y="880920"/>
                <a:ext cx="712440" cy="213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1149480"/>
                    <a:tab algn="l" pos="2298600"/>
                    <a:tab algn="l" pos="3448080"/>
                    <a:tab algn="l" pos="4597560"/>
                    <a:tab algn="l" pos="5746680"/>
                    <a:tab algn="l" pos="6896160"/>
                    <a:tab algn="l" pos="8045280"/>
                    <a:tab algn="l" pos="9194760"/>
                    <a:tab algn="l" pos="10344240"/>
                  </a:tabLst>
                </a:pPr>
                <a:r>
                  <a:rPr b="1" lang="en-US" sz="14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1" lang="en-US" sz="1400" spc="-1" strike="noStrike">
                    <a:solidFill>
                      <a:srgbClr val="000000"/>
                    </a:solidFill>
                    <a:latin typeface="Arial"/>
                  </a:rPr>
                  <a:t>AtGRF1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2" name=""/>
              <p:cNvSpPr/>
              <p:nvPr/>
            </p:nvSpPr>
            <p:spPr>
              <a:xfrm>
                <a:off x="4998960" y="855360"/>
                <a:ext cx="435240" cy="166680"/>
              </a:xfrm>
              <a:custGeom>
                <a:avLst/>
                <a:gdLst/>
                <a:ahLst/>
                <a:rect l="l" t="t" r="r" b="b"/>
                <a:pathLst>
                  <a:path w="274" h="105">
                    <a:moveTo>
                      <a:pt x="0" y="0"/>
                    </a:moveTo>
                    <a:lnTo>
                      <a:pt x="0" y="105"/>
                    </a:lnTo>
                    <a:lnTo>
                      <a:pt x="274" y="105"/>
                    </a:lnTo>
                  </a:path>
                </a:pathLst>
              </a:custGeom>
              <a:noFill/>
              <a:ln w="255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3" name=""/>
              <p:cNvSpPr/>
              <p:nvPr/>
            </p:nvSpPr>
            <p:spPr>
              <a:xfrm>
                <a:off x="4832280" y="842760"/>
                <a:ext cx="166680" cy="179280"/>
              </a:xfrm>
              <a:custGeom>
                <a:avLst/>
                <a:gdLst/>
                <a:ahLst/>
                <a:rect l="l" t="t" r="r" b="b"/>
                <a:pathLst>
                  <a:path w="105" h="113">
                    <a:moveTo>
                      <a:pt x="0" y="113"/>
                    </a:moveTo>
                    <a:lnTo>
                      <a:pt x="0" y="0"/>
                    </a:lnTo>
                    <a:lnTo>
                      <a:pt x="105" y="0"/>
                    </a:lnTo>
                  </a:path>
                </a:pathLst>
              </a:custGeom>
              <a:noFill/>
              <a:ln w="255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4" name=""/>
              <p:cNvSpPr/>
              <p:nvPr/>
            </p:nvSpPr>
            <p:spPr>
              <a:xfrm>
                <a:off x="5700960" y="1085760"/>
                <a:ext cx="712440" cy="213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1149480"/>
                    <a:tab algn="l" pos="2298600"/>
                    <a:tab algn="l" pos="3448080"/>
                    <a:tab algn="l" pos="4597560"/>
                    <a:tab algn="l" pos="5746680"/>
                    <a:tab algn="l" pos="6896160"/>
                    <a:tab algn="l" pos="8045280"/>
                    <a:tab algn="l" pos="9194760"/>
                    <a:tab algn="l" pos="10344240"/>
                  </a:tabLst>
                </a:pPr>
                <a:r>
                  <a:rPr b="1" lang="en-US" sz="14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1" lang="en-US" sz="1400" spc="-1" strike="noStrike">
                    <a:solidFill>
                      <a:srgbClr val="000000"/>
                    </a:solidFill>
                    <a:latin typeface="Arial"/>
                  </a:rPr>
                  <a:t>AtGRF2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5" name=""/>
              <p:cNvSpPr/>
              <p:nvPr/>
            </p:nvSpPr>
            <p:spPr>
              <a:xfrm>
                <a:off x="4832280" y="1047600"/>
                <a:ext cx="601920" cy="179280"/>
              </a:xfrm>
              <a:custGeom>
                <a:avLst/>
                <a:gdLst/>
                <a:ahLst/>
                <a:rect l="l" t="t" r="r" b="b"/>
                <a:pathLst>
                  <a:path w="379" h="113">
                    <a:moveTo>
                      <a:pt x="0" y="0"/>
                    </a:moveTo>
                    <a:lnTo>
                      <a:pt x="0" y="113"/>
                    </a:lnTo>
                    <a:lnTo>
                      <a:pt x="379" y="113"/>
                    </a:lnTo>
                  </a:path>
                </a:pathLst>
              </a:custGeom>
              <a:noFill/>
              <a:ln w="255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6" name=""/>
              <p:cNvSpPr/>
              <p:nvPr/>
            </p:nvSpPr>
            <p:spPr>
              <a:xfrm>
                <a:off x="4754520" y="1034640"/>
                <a:ext cx="77760" cy="255600"/>
              </a:xfrm>
              <a:custGeom>
                <a:avLst/>
                <a:gdLst/>
                <a:ahLst/>
                <a:rect l="l" t="t" r="r" b="b"/>
                <a:pathLst>
                  <a:path w="49" h="161">
                    <a:moveTo>
                      <a:pt x="0" y="161"/>
                    </a:moveTo>
                    <a:lnTo>
                      <a:pt x="0" y="0"/>
                    </a:lnTo>
                    <a:lnTo>
                      <a:pt x="49" y="0"/>
                    </a:lnTo>
                  </a:path>
                </a:pathLst>
              </a:custGeom>
              <a:noFill/>
              <a:ln w="255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7" name=""/>
              <p:cNvSpPr/>
              <p:nvPr/>
            </p:nvSpPr>
            <p:spPr>
              <a:xfrm>
                <a:off x="5699520" y="1290240"/>
                <a:ext cx="1258200" cy="213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1149480"/>
                    <a:tab algn="l" pos="2298600"/>
                    <a:tab algn="l" pos="3448080"/>
                    <a:tab algn="l" pos="4597560"/>
                    <a:tab algn="l" pos="5746680"/>
                    <a:tab algn="l" pos="6896160"/>
                    <a:tab algn="l" pos="8045280"/>
                    <a:tab algn="l" pos="9194760"/>
                    <a:tab algn="l" pos="10344240"/>
                  </a:tabLst>
                </a:pPr>
                <a:r>
                  <a:rPr b="1" lang="en-US" sz="14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1" lang="en-US" sz="1400" spc="-1" strike="noStrike">
                    <a:solidFill>
                      <a:srgbClr val="000000"/>
                    </a:solidFill>
                    <a:latin typeface="Arial"/>
                  </a:rPr>
                  <a:t>BraA.GRF14.g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8" name=""/>
              <p:cNvSpPr/>
              <p:nvPr/>
            </p:nvSpPr>
            <p:spPr>
              <a:xfrm>
                <a:off x="4998960" y="1431720"/>
                <a:ext cx="435240" cy="139680"/>
              </a:xfrm>
              <a:custGeom>
                <a:avLst/>
                <a:gdLst/>
                <a:ahLst/>
                <a:rect l="l" t="t" r="r" b="b"/>
                <a:pathLst>
                  <a:path w="274" h="88">
                    <a:moveTo>
                      <a:pt x="0" y="88"/>
                    </a:moveTo>
                    <a:lnTo>
                      <a:pt x="0" y="0"/>
                    </a:lnTo>
                    <a:lnTo>
                      <a:pt x="274" y="0"/>
                    </a:lnTo>
                  </a:path>
                </a:pathLst>
              </a:custGeom>
              <a:noFill/>
              <a:ln w="255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9" name=""/>
              <p:cNvSpPr/>
              <p:nvPr/>
            </p:nvSpPr>
            <p:spPr>
              <a:xfrm>
                <a:off x="5699520" y="1495080"/>
                <a:ext cx="1258200" cy="213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1149480"/>
                    <a:tab algn="l" pos="2298600"/>
                    <a:tab algn="l" pos="3448080"/>
                    <a:tab algn="l" pos="4597560"/>
                    <a:tab algn="l" pos="5746680"/>
                    <a:tab algn="l" pos="6896160"/>
                    <a:tab algn="l" pos="8045280"/>
                    <a:tab algn="l" pos="9194760"/>
                    <a:tab algn="l" pos="10344240"/>
                  </a:tabLst>
                </a:pPr>
                <a:r>
                  <a:rPr b="1" lang="en-US" sz="14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1" lang="en-US" sz="1400" spc="-1" strike="noStrike">
                    <a:solidFill>
                      <a:srgbClr val="000000"/>
                    </a:solidFill>
                    <a:latin typeface="Arial"/>
                  </a:rPr>
                  <a:t>BraA.GRF14.h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0" name=""/>
              <p:cNvSpPr/>
              <p:nvPr/>
            </p:nvSpPr>
            <p:spPr>
              <a:xfrm>
                <a:off x="5126040" y="1636560"/>
                <a:ext cx="308160" cy="88920"/>
              </a:xfrm>
              <a:custGeom>
                <a:avLst/>
                <a:gdLst/>
                <a:ahLst/>
                <a:rect l="l" t="t" r="r" b="b"/>
                <a:pathLst>
                  <a:path w="194" h="56">
                    <a:moveTo>
                      <a:pt x="0" y="56"/>
                    </a:moveTo>
                    <a:lnTo>
                      <a:pt x="0" y="0"/>
                    </a:lnTo>
                    <a:lnTo>
                      <a:pt x="194" y="0"/>
                    </a:lnTo>
                  </a:path>
                </a:pathLst>
              </a:custGeom>
              <a:noFill/>
              <a:ln w="255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2120" bIns="421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1" name=""/>
              <p:cNvSpPr/>
              <p:nvPr/>
            </p:nvSpPr>
            <p:spPr>
              <a:xfrm>
                <a:off x="5699160" y="1699920"/>
                <a:ext cx="1200240" cy="213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1149480"/>
                    <a:tab algn="l" pos="2298600"/>
                    <a:tab algn="l" pos="3448080"/>
                    <a:tab algn="l" pos="4597560"/>
                    <a:tab algn="l" pos="5746680"/>
                    <a:tab algn="l" pos="6896160"/>
                    <a:tab algn="l" pos="8045280"/>
                    <a:tab algn="l" pos="9194760"/>
                    <a:tab algn="l" pos="10344240"/>
                  </a:tabLst>
                </a:pPr>
                <a:r>
                  <a:rPr b="1" lang="en-US" sz="14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1" lang="en-US" sz="1400" spc="-1" strike="noStrike">
                    <a:solidFill>
                      <a:srgbClr val="000000"/>
                    </a:solidFill>
                    <a:latin typeface="Arial"/>
                  </a:rPr>
                  <a:t>BraA.GRF14.i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2" name=""/>
              <p:cNvSpPr/>
              <p:nvPr/>
            </p:nvSpPr>
            <p:spPr>
              <a:xfrm>
                <a:off x="5126040" y="1750680"/>
                <a:ext cx="308160" cy="90720"/>
              </a:xfrm>
              <a:custGeom>
                <a:avLst/>
                <a:gdLst/>
                <a:ahLst/>
                <a:rect l="l" t="t" r="r" b="b"/>
                <a:pathLst>
                  <a:path w="194" h="57">
                    <a:moveTo>
                      <a:pt x="0" y="0"/>
                    </a:moveTo>
                    <a:lnTo>
                      <a:pt x="0" y="57"/>
                    </a:lnTo>
                    <a:lnTo>
                      <a:pt x="194" y="57"/>
                    </a:lnTo>
                  </a:path>
                </a:pathLst>
              </a:custGeom>
              <a:noFill/>
              <a:ln w="255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3920" bIns="43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3" name=""/>
              <p:cNvSpPr/>
              <p:nvPr/>
            </p:nvSpPr>
            <p:spPr>
              <a:xfrm>
                <a:off x="4998960" y="1598400"/>
                <a:ext cx="127080" cy="139680"/>
              </a:xfrm>
              <a:custGeom>
                <a:avLst/>
                <a:gdLst/>
                <a:ahLst/>
                <a:rect l="l" t="t" r="r" b="b"/>
                <a:pathLst>
                  <a:path w="80" h="88">
                    <a:moveTo>
                      <a:pt x="0" y="0"/>
                    </a:moveTo>
                    <a:lnTo>
                      <a:pt x="0" y="88"/>
                    </a:lnTo>
                    <a:lnTo>
                      <a:pt x="80" y="88"/>
                    </a:lnTo>
                  </a:path>
                </a:pathLst>
              </a:custGeom>
              <a:noFill/>
              <a:ln w="255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4" name=""/>
              <p:cNvSpPr/>
              <p:nvPr/>
            </p:nvSpPr>
            <p:spPr>
              <a:xfrm>
                <a:off x="4754520" y="1315800"/>
                <a:ext cx="244440" cy="268200"/>
              </a:xfrm>
              <a:custGeom>
                <a:avLst/>
                <a:gdLst/>
                <a:ahLst/>
                <a:rect l="l" t="t" r="r" b="b"/>
                <a:pathLst>
                  <a:path w="154" h="169">
                    <a:moveTo>
                      <a:pt x="0" y="0"/>
                    </a:moveTo>
                    <a:lnTo>
                      <a:pt x="0" y="169"/>
                    </a:lnTo>
                    <a:lnTo>
                      <a:pt x="154" y="169"/>
                    </a:lnTo>
                  </a:path>
                </a:pathLst>
              </a:custGeom>
              <a:noFill/>
              <a:ln w="255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5" name=""/>
              <p:cNvSpPr/>
              <p:nvPr/>
            </p:nvSpPr>
            <p:spPr>
              <a:xfrm>
                <a:off x="4049640" y="1303200"/>
                <a:ext cx="704880" cy="409320"/>
              </a:xfrm>
              <a:custGeom>
                <a:avLst/>
                <a:gdLst/>
                <a:ahLst/>
                <a:rect l="l" t="t" r="r" b="b"/>
                <a:pathLst>
                  <a:path w="444" h="258">
                    <a:moveTo>
                      <a:pt x="0" y="258"/>
                    </a:moveTo>
                    <a:lnTo>
                      <a:pt x="0" y="0"/>
                    </a:lnTo>
                    <a:lnTo>
                      <a:pt x="444" y="0"/>
                    </a:lnTo>
                  </a:path>
                </a:pathLst>
              </a:custGeom>
              <a:noFill/>
              <a:ln w="255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6" name=""/>
              <p:cNvSpPr/>
              <p:nvPr/>
            </p:nvSpPr>
            <p:spPr>
              <a:xfrm>
                <a:off x="5699160" y="1904760"/>
                <a:ext cx="1200240" cy="213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1149480"/>
                    <a:tab algn="l" pos="2298600"/>
                    <a:tab algn="l" pos="3448080"/>
                    <a:tab algn="l" pos="4597560"/>
                    <a:tab algn="l" pos="5746680"/>
                    <a:tab algn="l" pos="6896160"/>
                    <a:tab algn="l" pos="8045280"/>
                    <a:tab algn="l" pos="9194760"/>
                    <a:tab algn="l" pos="10344240"/>
                  </a:tabLst>
                </a:pPr>
                <a:r>
                  <a:rPr b="1" lang="en-US" sz="14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1" lang="en-US" sz="1400" spc="-1" strike="noStrike">
                    <a:solidFill>
                      <a:srgbClr val="000000"/>
                    </a:solidFill>
                    <a:latin typeface="Arial"/>
                  </a:rPr>
                  <a:t>BraA.GRF14.j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7" name=""/>
              <p:cNvSpPr/>
              <p:nvPr/>
            </p:nvSpPr>
            <p:spPr>
              <a:xfrm>
                <a:off x="5011920" y="2045880"/>
                <a:ext cx="422280" cy="88920"/>
              </a:xfrm>
              <a:custGeom>
                <a:avLst/>
                <a:gdLst/>
                <a:ahLst/>
                <a:rect l="l" t="t" r="r" b="b"/>
                <a:pathLst>
                  <a:path w="266" h="56">
                    <a:moveTo>
                      <a:pt x="0" y="56"/>
                    </a:moveTo>
                    <a:lnTo>
                      <a:pt x="0" y="0"/>
                    </a:lnTo>
                    <a:lnTo>
                      <a:pt x="266" y="0"/>
                    </a:lnTo>
                  </a:path>
                </a:pathLst>
              </a:custGeom>
              <a:noFill/>
              <a:ln w="255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2120" bIns="421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8" name=""/>
              <p:cNvSpPr/>
              <p:nvPr/>
            </p:nvSpPr>
            <p:spPr>
              <a:xfrm>
                <a:off x="5699520" y="2109600"/>
                <a:ext cx="1258200" cy="213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1149480"/>
                    <a:tab algn="l" pos="2298600"/>
                    <a:tab algn="l" pos="3448080"/>
                    <a:tab algn="l" pos="4597560"/>
                    <a:tab algn="l" pos="5746680"/>
                    <a:tab algn="l" pos="6896160"/>
                    <a:tab algn="l" pos="8045280"/>
                    <a:tab algn="l" pos="9194760"/>
                    <a:tab algn="l" pos="10344240"/>
                  </a:tabLst>
                </a:pPr>
                <a:r>
                  <a:rPr b="1" lang="en-US" sz="14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1" lang="en-US" sz="1400" spc="-1" strike="noStrike">
                    <a:solidFill>
                      <a:srgbClr val="000000"/>
                    </a:solidFill>
                    <a:latin typeface="Arial"/>
                  </a:rPr>
                  <a:t>BraA.GRF14.p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9" name=""/>
              <p:cNvSpPr/>
              <p:nvPr/>
            </p:nvSpPr>
            <p:spPr>
              <a:xfrm>
                <a:off x="5011920" y="2160360"/>
                <a:ext cx="422280" cy="88920"/>
              </a:xfrm>
              <a:custGeom>
                <a:avLst/>
                <a:gdLst/>
                <a:ahLst/>
                <a:rect l="l" t="t" r="r" b="b"/>
                <a:pathLst>
                  <a:path w="266" h="56">
                    <a:moveTo>
                      <a:pt x="0" y="0"/>
                    </a:moveTo>
                    <a:lnTo>
                      <a:pt x="0" y="56"/>
                    </a:lnTo>
                    <a:lnTo>
                      <a:pt x="266" y="56"/>
                    </a:lnTo>
                  </a:path>
                </a:pathLst>
              </a:custGeom>
              <a:noFill/>
              <a:ln w="255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2120" bIns="421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0" name=""/>
              <p:cNvSpPr/>
              <p:nvPr/>
            </p:nvSpPr>
            <p:spPr>
              <a:xfrm>
                <a:off x="4049640" y="1738080"/>
                <a:ext cx="962280" cy="409680"/>
              </a:xfrm>
              <a:custGeom>
                <a:avLst/>
                <a:gdLst/>
                <a:ahLst/>
                <a:rect l="l" t="t" r="r" b="b"/>
                <a:pathLst>
                  <a:path w="606" h="258">
                    <a:moveTo>
                      <a:pt x="0" y="0"/>
                    </a:moveTo>
                    <a:lnTo>
                      <a:pt x="0" y="258"/>
                    </a:lnTo>
                    <a:lnTo>
                      <a:pt x="606" y="258"/>
                    </a:lnTo>
                  </a:path>
                </a:pathLst>
              </a:custGeom>
              <a:noFill/>
              <a:ln w="255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1" name=""/>
              <p:cNvSpPr/>
              <p:nvPr/>
            </p:nvSpPr>
            <p:spPr>
              <a:xfrm>
                <a:off x="3627360" y="1725480"/>
                <a:ext cx="422280" cy="345960"/>
              </a:xfrm>
              <a:custGeom>
                <a:avLst/>
                <a:gdLst/>
                <a:ahLst/>
                <a:rect l="l" t="t" r="r" b="b"/>
                <a:pathLst>
                  <a:path w="266" h="218">
                    <a:moveTo>
                      <a:pt x="0" y="218"/>
                    </a:moveTo>
                    <a:lnTo>
                      <a:pt x="0" y="0"/>
                    </a:lnTo>
                    <a:lnTo>
                      <a:pt x="266" y="0"/>
                    </a:lnTo>
                  </a:path>
                </a:pathLst>
              </a:custGeom>
              <a:noFill/>
              <a:ln w="255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2" name=""/>
              <p:cNvSpPr/>
              <p:nvPr/>
            </p:nvSpPr>
            <p:spPr>
              <a:xfrm>
                <a:off x="5698440" y="2314440"/>
                <a:ext cx="1090440" cy="213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1149480"/>
                    <a:tab algn="l" pos="2298600"/>
                    <a:tab algn="l" pos="3448080"/>
                    <a:tab algn="l" pos="4597560"/>
                    <a:tab algn="l" pos="5746680"/>
                    <a:tab algn="l" pos="6896160"/>
                    <a:tab algn="l" pos="8045280"/>
                    <a:tab algn="l" pos="9194760"/>
                    <a:tab algn="l" pos="10344240"/>
                  </a:tabLst>
                </a:pPr>
                <a:r>
                  <a:rPr b="1" lang="en-US" sz="14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1" lang="en-US" sz="1400" spc="-1" strike="noStrike">
                    <a:solidFill>
                      <a:srgbClr val="000000"/>
                    </a:solidFill>
                    <a:latin typeface="Arial"/>
                  </a:rPr>
                  <a:t>Os08g37490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3" name=""/>
              <p:cNvSpPr/>
              <p:nvPr/>
            </p:nvSpPr>
            <p:spPr>
              <a:xfrm>
                <a:off x="3627360" y="2097000"/>
                <a:ext cx="1806840" cy="357120"/>
              </a:xfrm>
              <a:custGeom>
                <a:avLst/>
                <a:gdLst/>
                <a:ahLst/>
                <a:rect l="l" t="t" r="r" b="b"/>
                <a:pathLst>
                  <a:path w="1138" h="225">
                    <a:moveTo>
                      <a:pt x="0" y="0"/>
                    </a:moveTo>
                    <a:lnTo>
                      <a:pt x="0" y="225"/>
                    </a:lnTo>
                    <a:lnTo>
                      <a:pt x="1138" y="225"/>
                    </a:lnTo>
                  </a:path>
                </a:pathLst>
              </a:custGeom>
              <a:noFill/>
              <a:ln w="255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4" name=""/>
              <p:cNvSpPr/>
              <p:nvPr/>
            </p:nvSpPr>
            <p:spPr>
              <a:xfrm>
                <a:off x="3294000" y="2084040"/>
                <a:ext cx="333360" cy="370080"/>
              </a:xfrm>
              <a:custGeom>
                <a:avLst/>
                <a:gdLst/>
                <a:ahLst/>
                <a:rect l="l" t="t" r="r" b="b"/>
                <a:pathLst>
                  <a:path w="210" h="233">
                    <a:moveTo>
                      <a:pt x="0" y="233"/>
                    </a:moveTo>
                    <a:lnTo>
                      <a:pt x="0" y="0"/>
                    </a:lnTo>
                    <a:lnTo>
                      <a:pt x="210" y="0"/>
                    </a:lnTo>
                  </a:path>
                </a:pathLst>
              </a:custGeom>
              <a:noFill/>
              <a:ln w="255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5" name=""/>
              <p:cNvSpPr/>
              <p:nvPr/>
            </p:nvSpPr>
            <p:spPr>
              <a:xfrm>
                <a:off x="5699520" y="2519280"/>
                <a:ext cx="1258200" cy="213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1149480"/>
                    <a:tab algn="l" pos="2298600"/>
                    <a:tab algn="l" pos="3448080"/>
                    <a:tab algn="l" pos="4597560"/>
                    <a:tab algn="l" pos="5746680"/>
                    <a:tab algn="l" pos="6896160"/>
                    <a:tab algn="l" pos="8045280"/>
                    <a:tab algn="l" pos="9194760"/>
                    <a:tab algn="l" pos="10344240"/>
                  </a:tabLst>
                </a:pPr>
                <a:r>
                  <a:rPr b="1" lang="en-US" sz="14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1" lang="en-US" sz="1400" spc="-1" strike="noStrike">
                    <a:solidFill>
                      <a:srgbClr val="000000"/>
                    </a:solidFill>
                    <a:latin typeface="Arial"/>
                  </a:rPr>
                  <a:t>BraA.GRF14.n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6" name=""/>
              <p:cNvSpPr/>
              <p:nvPr/>
            </p:nvSpPr>
            <p:spPr>
              <a:xfrm>
                <a:off x="4767480" y="2658960"/>
                <a:ext cx="666720" cy="179280"/>
              </a:xfrm>
              <a:custGeom>
                <a:avLst/>
                <a:gdLst/>
                <a:ahLst/>
                <a:rect l="l" t="t" r="r" b="b"/>
                <a:pathLst>
                  <a:path w="420" h="113">
                    <a:moveTo>
                      <a:pt x="0" y="113"/>
                    </a:moveTo>
                    <a:lnTo>
                      <a:pt x="0" y="0"/>
                    </a:lnTo>
                    <a:lnTo>
                      <a:pt x="420" y="0"/>
                    </a:lnTo>
                  </a:path>
                </a:pathLst>
              </a:custGeom>
              <a:noFill/>
              <a:ln w="255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7" name=""/>
              <p:cNvSpPr/>
              <p:nvPr/>
            </p:nvSpPr>
            <p:spPr>
              <a:xfrm>
                <a:off x="5699520" y="2723760"/>
                <a:ext cx="1258200" cy="213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1149480"/>
                    <a:tab algn="l" pos="2298600"/>
                    <a:tab algn="l" pos="3448080"/>
                    <a:tab algn="l" pos="4597560"/>
                    <a:tab algn="l" pos="5746680"/>
                    <a:tab algn="l" pos="6896160"/>
                    <a:tab algn="l" pos="8045280"/>
                    <a:tab algn="l" pos="9194760"/>
                    <a:tab algn="l" pos="10344240"/>
                  </a:tabLst>
                </a:pPr>
                <a:r>
                  <a:rPr b="1" lang="en-US" sz="14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1" lang="en-US" sz="1400" spc="-1" strike="noStrike">
                    <a:solidFill>
                      <a:srgbClr val="000000"/>
                    </a:solidFill>
                    <a:latin typeface="Arial"/>
                  </a:rPr>
                  <a:t>BraA.GRF14.q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8" name=""/>
              <p:cNvSpPr/>
              <p:nvPr/>
            </p:nvSpPr>
            <p:spPr>
              <a:xfrm>
                <a:off x="4883400" y="2863440"/>
                <a:ext cx="550800" cy="179640"/>
              </a:xfrm>
              <a:custGeom>
                <a:avLst/>
                <a:gdLst/>
                <a:ahLst/>
                <a:rect l="l" t="t" r="r" b="b"/>
                <a:pathLst>
                  <a:path w="347" h="113">
                    <a:moveTo>
                      <a:pt x="0" y="113"/>
                    </a:moveTo>
                    <a:lnTo>
                      <a:pt x="0" y="0"/>
                    </a:lnTo>
                    <a:lnTo>
                      <a:pt x="347" y="0"/>
                    </a:lnTo>
                  </a:path>
                </a:pathLst>
              </a:custGeom>
              <a:noFill/>
              <a:ln w="255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9" name=""/>
              <p:cNvSpPr/>
              <p:nvPr/>
            </p:nvSpPr>
            <p:spPr>
              <a:xfrm>
                <a:off x="5700960" y="2928600"/>
                <a:ext cx="712440" cy="213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1149480"/>
                    <a:tab algn="l" pos="2298600"/>
                    <a:tab algn="l" pos="3448080"/>
                    <a:tab algn="l" pos="4597560"/>
                    <a:tab algn="l" pos="5746680"/>
                    <a:tab algn="l" pos="6896160"/>
                    <a:tab algn="l" pos="8045280"/>
                    <a:tab algn="l" pos="9194760"/>
                    <a:tab algn="l" pos="10344240"/>
                  </a:tabLst>
                </a:pPr>
                <a:r>
                  <a:rPr b="1" lang="en-US" sz="14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1" lang="en-US" sz="1400" spc="-1" strike="noStrike">
                    <a:solidFill>
                      <a:srgbClr val="000000"/>
                    </a:solidFill>
                    <a:latin typeface="Arial"/>
                  </a:rPr>
                  <a:t>AtGRF6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0" name=""/>
              <p:cNvSpPr/>
              <p:nvPr/>
            </p:nvSpPr>
            <p:spPr>
              <a:xfrm>
                <a:off x="4998960" y="3068280"/>
                <a:ext cx="435240" cy="166680"/>
              </a:xfrm>
              <a:custGeom>
                <a:avLst/>
                <a:gdLst/>
                <a:ahLst/>
                <a:rect l="l" t="t" r="r" b="b"/>
                <a:pathLst>
                  <a:path w="274" h="105">
                    <a:moveTo>
                      <a:pt x="0" y="105"/>
                    </a:moveTo>
                    <a:lnTo>
                      <a:pt x="0" y="0"/>
                    </a:lnTo>
                    <a:lnTo>
                      <a:pt x="274" y="0"/>
                    </a:lnTo>
                  </a:path>
                </a:pathLst>
              </a:custGeom>
              <a:noFill/>
              <a:ln w="255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1" name=""/>
              <p:cNvSpPr/>
              <p:nvPr/>
            </p:nvSpPr>
            <p:spPr>
              <a:xfrm>
                <a:off x="5700960" y="3133440"/>
                <a:ext cx="712440" cy="213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1149480"/>
                    <a:tab algn="l" pos="2298600"/>
                    <a:tab algn="l" pos="3448080"/>
                    <a:tab algn="l" pos="4597560"/>
                    <a:tab algn="l" pos="5746680"/>
                    <a:tab algn="l" pos="6896160"/>
                    <a:tab algn="l" pos="8045280"/>
                    <a:tab algn="l" pos="9194760"/>
                    <a:tab algn="l" pos="10344240"/>
                  </a:tabLst>
                </a:pPr>
                <a:r>
                  <a:rPr b="1" lang="en-US" sz="14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1" lang="en-US" sz="1400" spc="-1" strike="noStrike">
                    <a:solidFill>
                      <a:srgbClr val="000000"/>
                    </a:solidFill>
                    <a:latin typeface="Arial"/>
                  </a:rPr>
                  <a:t>AtGRF8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2" name=""/>
              <p:cNvSpPr/>
              <p:nvPr/>
            </p:nvSpPr>
            <p:spPr>
              <a:xfrm>
                <a:off x="5254560" y="3273120"/>
                <a:ext cx="179640" cy="141480"/>
              </a:xfrm>
              <a:custGeom>
                <a:avLst/>
                <a:gdLst/>
                <a:ahLst/>
                <a:rect l="l" t="t" r="r" b="b"/>
                <a:pathLst>
                  <a:path w="113" h="89">
                    <a:moveTo>
                      <a:pt x="0" y="89"/>
                    </a:moveTo>
                    <a:lnTo>
                      <a:pt x="0" y="0"/>
                    </a:lnTo>
                    <a:lnTo>
                      <a:pt x="113" y="0"/>
                    </a:lnTo>
                  </a:path>
                </a:pathLst>
              </a:custGeom>
              <a:noFill/>
              <a:ln w="255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3" name=""/>
              <p:cNvSpPr/>
              <p:nvPr/>
            </p:nvSpPr>
            <p:spPr>
              <a:xfrm>
                <a:off x="5699520" y="3338280"/>
                <a:ext cx="1209240" cy="213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1149480"/>
                    <a:tab algn="l" pos="2298600"/>
                    <a:tab algn="l" pos="3448080"/>
                    <a:tab algn="l" pos="4597560"/>
                    <a:tab algn="l" pos="5746680"/>
                    <a:tab algn="l" pos="6896160"/>
                    <a:tab algn="l" pos="8045280"/>
                    <a:tab algn="l" pos="9194760"/>
                    <a:tab algn="l" pos="10344240"/>
                  </a:tabLst>
                </a:pPr>
                <a:r>
                  <a:rPr b="1" lang="en-US" sz="14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1" lang="en-US" sz="1400" spc="-1" strike="noStrike">
                    <a:solidFill>
                      <a:srgbClr val="000000"/>
                    </a:solidFill>
                    <a:latin typeface="Arial"/>
                  </a:rPr>
                  <a:t>BraA.GRF14.t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4" name=""/>
              <p:cNvSpPr/>
              <p:nvPr/>
            </p:nvSpPr>
            <p:spPr>
              <a:xfrm>
                <a:off x="5370480" y="3477960"/>
                <a:ext cx="63720" cy="88920"/>
              </a:xfrm>
              <a:custGeom>
                <a:avLst/>
                <a:gdLst/>
                <a:ahLst/>
                <a:rect l="l" t="t" r="r" b="b"/>
                <a:pathLst>
                  <a:path w="40" h="56">
                    <a:moveTo>
                      <a:pt x="0" y="56"/>
                    </a:moveTo>
                    <a:lnTo>
                      <a:pt x="0" y="0"/>
                    </a:lnTo>
                    <a:lnTo>
                      <a:pt x="40" y="0"/>
                    </a:lnTo>
                  </a:path>
                </a:pathLst>
              </a:custGeom>
              <a:noFill/>
              <a:ln w="255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2120" bIns="421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5" name=""/>
              <p:cNvSpPr/>
              <p:nvPr/>
            </p:nvSpPr>
            <p:spPr>
              <a:xfrm>
                <a:off x="5699520" y="3541320"/>
                <a:ext cx="1258200" cy="213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1149480"/>
                    <a:tab algn="l" pos="2298600"/>
                    <a:tab algn="l" pos="3448080"/>
                    <a:tab algn="l" pos="4597560"/>
                    <a:tab algn="l" pos="5746680"/>
                    <a:tab algn="l" pos="6896160"/>
                    <a:tab algn="l" pos="8045280"/>
                    <a:tab algn="l" pos="9194760"/>
                    <a:tab algn="l" pos="10344240"/>
                  </a:tabLst>
                </a:pPr>
                <a:r>
                  <a:rPr b="1" lang="en-US" sz="14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1" lang="en-US" sz="1400" spc="-1" strike="noStrike">
                    <a:solidFill>
                      <a:srgbClr val="000000"/>
                    </a:solidFill>
                    <a:latin typeface="Arial"/>
                  </a:rPr>
                  <a:t>BraA.GRF14.u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6" name=""/>
              <p:cNvSpPr/>
              <p:nvPr/>
            </p:nvSpPr>
            <p:spPr>
              <a:xfrm>
                <a:off x="5370480" y="3593880"/>
                <a:ext cx="63720" cy="88920"/>
              </a:xfrm>
              <a:custGeom>
                <a:avLst/>
                <a:gdLst/>
                <a:ahLst/>
                <a:rect l="l" t="t" r="r" b="b"/>
                <a:pathLst>
                  <a:path w="40" h="56">
                    <a:moveTo>
                      <a:pt x="0" y="0"/>
                    </a:moveTo>
                    <a:lnTo>
                      <a:pt x="0" y="56"/>
                    </a:lnTo>
                    <a:lnTo>
                      <a:pt x="40" y="56"/>
                    </a:lnTo>
                  </a:path>
                </a:pathLst>
              </a:custGeom>
              <a:noFill/>
              <a:ln w="255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2120" bIns="421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7" name=""/>
              <p:cNvSpPr/>
              <p:nvPr/>
            </p:nvSpPr>
            <p:spPr>
              <a:xfrm>
                <a:off x="5254560" y="3439800"/>
                <a:ext cx="115920" cy="141480"/>
              </a:xfrm>
              <a:custGeom>
                <a:avLst/>
                <a:gdLst/>
                <a:ahLst/>
                <a:rect l="l" t="t" r="r" b="b"/>
                <a:pathLst>
                  <a:path w="73" h="89">
                    <a:moveTo>
                      <a:pt x="0" y="0"/>
                    </a:moveTo>
                    <a:lnTo>
                      <a:pt x="0" y="89"/>
                    </a:lnTo>
                    <a:lnTo>
                      <a:pt x="73" y="89"/>
                    </a:lnTo>
                  </a:path>
                </a:pathLst>
              </a:custGeom>
              <a:noFill/>
              <a:ln w="255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8" name=""/>
              <p:cNvSpPr/>
              <p:nvPr/>
            </p:nvSpPr>
            <p:spPr>
              <a:xfrm>
                <a:off x="4998960" y="3260520"/>
                <a:ext cx="255600" cy="166680"/>
              </a:xfrm>
              <a:custGeom>
                <a:avLst/>
                <a:gdLst/>
                <a:ahLst/>
                <a:rect l="l" t="t" r="r" b="b"/>
                <a:pathLst>
                  <a:path w="161" h="105">
                    <a:moveTo>
                      <a:pt x="0" y="0"/>
                    </a:moveTo>
                    <a:lnTo>
                      <a:pt x="0" y="105"/>
                    </a:lnTo>
                    <a:lnTo>
                      <a:pt x="161" y="105"/>
                    </a:lnTo>
                  </a:path>
                </a:pathLst>
              </a:custGeom>
              <a:noFill/>
              <a:ln w="255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9" name=""/>
              <p:cNvSpPr/>
              <p:nvPr/>
            </p:nvSpPr>
            <p:spPr>
              <a:xfrm>
                <a:off x="4883400" y="3068280"/>
                <a:ext cx="115560" cy="179640"/>
              </a:xfrm>
              <a:custGeom>
                <a:avLst/>
                <a:gdLst/>
                <a:ahLst/>
                <a:rect l="l" t="t" r="r" b="b"/>
                <a:pathLst>
                  <a:path w="73" h="113">
                    <a:moveTo>
                      <a:pt x="0" y="0"/>
                    </a:moveTo>
                    <a:lnTo>
                      <a:pt x="0" y="113"/>
                    </a:lnTo>
                    <a:lnTo>
                      <a:pt x="73" y="113"/>
                    </a:lnTo>
                  </a:path>
                </a:pathLst>
              </a:custGeom>
              <a:noFill/>
              <a:ln w="255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0" name=""/>
              <p:cNvSpPr/>
              <p:nvPr/>
            </p:nvSpPr>
            <p:spPr>
              <a:xfrm>
                <a:off x="4767480" y="2863440"/>
                <a:ext cx="115920" cy="192240"/>
              </a:xfrm>
              <a:custGeom>
                <a:avLst/>
                <a:gdLst/>
                <a:ahLst/>
                <a:rect l="l" t="t" r="r" b="b"/>
                <a:pathLst>
                  <a:path w="73" h="121">
                    <a:moveTo>
                      <a:pt x="0" y="0"/>
                    </a:moveTo>
                    <a:lnTo>
                      <a:pt x="0" y="121"/>
                    </a:lnTo>
                    <a:lnTo>
                      <a:pt x="73" y="121"/>
                    </a:lnTo>
                  </a:path>
                </a:pathLst>
              </a:custGeom>
              <a:noFill/>
              <a:ln w="255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1" name=""/>
              <p:cNvSpPr/>
              <p:nvPr/>
            </p:nvSpPr>
            <p:spPr>
              <a:xfrm>
                <a:off x="3294000" y="2481120"/>
                <a:ext cx="1473480" cy="369720"/>
              </a:xfrm>
              <a:custGeom>
                <a:avLst/>
                <a:gdLst/>
                <a:ahLst/>
                <a:rect l="l" t="t" r="r" b="b"/>
                <a:pathLst>
                  <a:path w="928" h="233">
                    <a:moveTo>
                      <a:pt x="0" y="0"/>
                    </a:moveTo>
                    <a:lnTo>
                      <a:pt x="0" y="233"/>
                    </a:lnTo>
                    <a:lnTo>
                      <a:pt x="928" y="233"/>
                    </a:lnTo>
                  </a:path>
                </a:pathLst>
              </a:custGeom>
              <a:noFill/>
              <a:ln w="255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2" name=""/>
              <p:cNvSpPr/>
              <p:nvPr/>
            </p:nvSpPr>
            <p:spPr>
              <a:xfrm>
                <a:off x="3192480" y="2466720"/>
                <a:ext cx="101520" cy="960480"/>
              </a:xfrm>
              <a:custGeom>
                <a:avLst/>
                <a:gdLst/>
                <a:ahLst/>
                <a:rect l="l" t="t" r="r" b="b"/>
                <a:pathLst>
                  <a:path w="64" h="605">
                    <a:moveTo>
                      <a:pt x="0" y="605"/>
                    </a:moveTo>
                    <a:lnTo>
                      <a:pt x="0" y="0"/>
                    </a:lnTo>
                    <a:lnTo>
                      <a:pt x="64" y="0"/>
                    </a:lnTo>
                  </a:path>
                </a:pathLst>
              </a:custGeom>
              <a:noFill/>
              <a:ln w="255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3" name=""/>
              <p:cNvSpPr/>
              <p:nvPr/>
            </p:nvSpPr>
            <p:spPr>
              <a:xfrm>
                <a:off x="5698440" y="3746160"/>
                <a:ext cx="1090440" cy="213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1149480"/>
                    <a:tab algn="l" pos="2298600"/>
                    <a:tab algn="l" pos="3448080"/>
                    <a:tab algn="l" pos="4597560"/>
                    <a:tab algn="l" pos="5746680"/>
                    <a:tab algn="l" pos="6896160"/>
                    <a:tab algn="l" pos="8045280"/>
                    <a:tab algn="l" pos="9194760"/>
                    <a:tab algn="l" pos="10344240"/>
                  </a:tabLst>
                </a:pPr>
                <a:r>
                  <a:rPr b="1" lang="en-US" sz="14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1" lang="en-US" sz="1400" spc="-1" strike="noStrike">
                    <a:solidFill>
                      <a:srgbClr val="000000"/>
                    </a:solidFill>
                    <a:latin typeface="Arial"/>
                  </a:rPr>
                  <a:t>Os03g50290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4" name=""/>
              <p:cNvSpPr/>
              <p:nvPr/>
            </p:nvSpPr>
            <p:spPr>
              <a:xfrm>
                <a:off x="3961080" y="3887640"/>
                <a:ext cx="1473120" cy="511200"/>
              </a:xfrm>
              <a:custGeom>
                <a:avLst/>
                <a:gdLst/>
                <a:ahLst/>
                <a:rect l="l" t="t" r="r" b="b"/>
                <a:pathLst>
                  <a:path w="928" h="322">
                    <a:moveTo>
                      <a:pt x="0" y="322"/>
                    </a:moveTo>
                    <a:lnTo>
                      <a:pt x="0" y="0"/>
                    </a:lnTo>
                    <a:lnTo>
                      <a:pt x="928" y="0"/>
                    </a:lnTo>
                  </a:path>
                </a:pathLst>
              </a:custGeom>
              <a:noFill/>
              <a:ln w="255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5" name=""/>
              <p:cNvSpPr/>
              <p:nvPr/>
            </p:nvSpPr>
            <p:spPr>
              <a:xfrm>
                <a:off x="5698440" y="3951000"/>
                <a:ext cx="1090440" cy="213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1149480"/>
                    <a:tab algn="l" pos="2298600"/>
                    <a:tab algn="l" pos="3448080"/>
                    <a:tab algn="l" pos="4597560"/>
                    <a:tab algn="l" pos="5746680"/>
                    <a:tab algn="l" pos="6896160"/>
                    <a:tab algn="l" pos="8045280"/>
                    <a:tab algn="l" pos="9194760"/>
                    <a:tab algn="l" pos="10344240"/>
                  </a:tabLst>
                </a:pPr>
                <a:r>
                  <a:rPr b="1" lang="en-US" sz="14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1" lang="en-US" sz="1400" spc="-1" strike="noStrike">
                    <a:solidFill>
                      <a:srgbClr val="000000"/>
                    </a:solidFill>
                    <a:latin typeface="Arial"/>
                  </a:rPr>
                  <a:t>Os02g36974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6" name=""/>
              <p:cNvSpPr/>
              <p:nvPr/>
            </p:nvSpPr>
            <p:spPr>
              <a:xfrm>
                <a:off x="5229360" y="4092480"/>
                <a:ext cx="204840" cy="88920"/>
              </a:xfrm>
              <a:custGeom>
                <a:avLst/>
                <a:gdLst/>
                <a:ahLst/>
                <a:rect l="l" t="t" r="r" b="b"/>
                <a:pathLst>
                  <a:path w="129" h="56">
                    <a:moveTo>
                      <a:pt x="0" y="56"/>
                    </a:moveTo>
                    <a:lnTo>
                      <a:pt x="0" y="0"/>
                    </a:lnTo>
                    <a:lnTo>
                      <a:pt x="129" y="0"/>
                    </a:lnTo>
                  </a:path>
                </a:pathLst>
              </a:custGeom>
              <a:noFill/>
              <a:ln w="255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2120" bIns="421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7" name=""/>
              <p:cNvSpPr/>
              <p:nvPr/>
            </p:nvSpPr>
            <p:spPr>
              <a:xfrm>
                <a:off x="5698440" y="4155840"/>
                <a:ext cx="1090440" cy="213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1149480"/>
                    <a:tab algn="l" pos="2298600"/>
                    <a:tab algn="l" pos="3448080"/>
                    <a:tab algn="l" pos="4597560"/>
                    <a:tab algn="l" pos="5746680"/>
                    <a:tab algn="l" pos="6896160"/>
                    <a:tab algn="l" pos="8045280"/>
                    <a:tab algn="l" pos="9194760"/>
                    <a:tab algn="l" pos="10344240"/>
                  </a:tabLst>
                </a:pPr>
                <a:r>
                  <a:rPr b="1" lang="en-US" sz="14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1" lang="en-US" sz="1400" spc="-1" strike="noStrike">
                    <a:solidFill>
                      <a:srgbClr val="000000"/>
                    </a:solidFill>
                    <a:latin typeface="Arial"/>
                  </a:rPr>
                  <a:t>Os04g38870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8" name=""/>
              <p:cNvSpPr/>
              <p:nvPr/>
            </p:nvSpPr>
            <p:spPr>
              <a:xfrm>
                <a:off x="5229360" y="4206600"/>
                <a:ext cx="204840" cy="90360"/>
              </a:xfrm>
              <a:custGeom>
                <a:avLst/>
                <a:gdLst/>
                <a:ahLst/>
                <a:rect l="l" t="t" r="r" b="b"/>
                <a:pathLst>
                  <a:path w="129" h="57">
                    <a:moveTo>
                      <a:pt x="0" y="0"/>
                    </a:moveTo>
                    <a:lnTo>
                      <a:pt x="0" y="57"/>
                    </a:lnTo>
                    <a:lnTo>
                      <a:pt x="129" y="57"/>
                    </a:lnTo>
                  </a:path>
                </a:pathLst>
              </a:custGeom>
              <a:noFill/>
              <a:ln w="255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3560" bIns="43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9" name=""/>
              <p:cNvSpPr/>
              <p:nvPr/>
            </p:nvSpPr>
            <p:spPr>
              <a:xfrm>
                <a:off x="4332240" y="4194000"/>
                <a:ext cx="897120" cy="191880"/>
              </a:xfrm>
              <a:custGeom>
                <a:avLst/>
                <a:gdLst/>
                <a:ahLst/>
                <a:rect l="l" t="t" r="r" b="b"/>
                <a:pathLst>
                  <a:path w="565" h="121">
                    <a:moveTo>
                      <a:pt x="0" y="121"/>
                    </a:moveTo>
                    <a:lnTo>
                      <a:pt x="0" y="0"/>
                    </a:lnTo>
                    <a:lnTo>
                      <a:pt x="565" y="0"/>
                    </a:lnTo>
                  </a:path>
                </a:pathLst>
              </a:custGeom>
              <a:noFill/>
              <a:ln w="255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0" name=""/>
              <p:cNvSpPr/>
              <p:nvPr/>
            </p:nvSpPr>
            <p:spPr>
              <a:xfrm>
                <a:off x="5698440" y="4360680"/>
                <a:ext cx="1090440" cy="213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1149480"/>
                    <a:tab algn="l" pos="2298600"/>
                    <a:tab algn="l" pos="3448080"/>
                    <a:tab algn="l" pos="4597560"/>
                    <a:tab algn="l" pos="5746680"/>
                    <a:tab algn="l" pos="6896160"/>
                    <a:tab algn="l" pos="8045280"/>
                    <a:tab algn="l" pos="9194760"/>
                    <a:tab algn="l" pos="10344240"/>
                  </a:tabLst>
                </a:pPr>
                <a:r>
                  <a:rPr b="1" lang="en-US" sz="14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1" lang="en-US" sz="1400" spc="-1" strike="noStrike">
                    <a:solidFill>
                      <a:srgbClr val="000000"/>
                    </a:solidFill>
                    <a:latin typeface="Arial"/>
                  </a:rPr>
                  <a:t>Os08g33370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1" name=""/>
              <p:cNvSpPr/>
              <p:nvPr/>
            </p:nvSpPr>
            <p:spPr>
              <a:xfrm>
                <a:off x="4626000" y="4501800"/>
                <a:ext cx="808200" cy="88920"/>
              </a:xfrm>
              <a:custGeom>
                <a:avLst/>
                <a:gdLst/>
                <a:ahLst/>
                <a:rect l="l" t="t" r="r" b="b"/>
                <a:pathLst>
                  <a:path w="509" h="56">
                    <a:moveTo>
                      <a:pt x="0" y="56"/>
                    </a:moveTo>
                    <a:lnTo>
                      <a:pt x="0" y="0"/>
                    </a:lnTo>
                    <a:lnTo>
                      <a:pt x="509" y="0"/>
                    </a:lnTo>
                  </a:path>
                </a:pathLst>
              </a:custGeom>
              <a:noFill/>
              <a:ln w="255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2120" bIns="421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2" name=""/>
              <p:cNvSpPr/>
              <p:nvPr/>
            </p:nvSpPr>
            <p:spPr>
              <a:xfrm>
                <a:off x="5698440" y="4565520"/>
                <a:ext cx="1090440" cy="213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1149480"/>
                    <a:tab algn="l" pos="2298600"/>
                    <a:tab algn="l" pos="3448080"/>
                    <a:tab algn="l" pos="4597560"/>
                    <a:tab algn="l" pos="5746680"/>
                    <a:tab algn="l" pos="6896160"/>
                    <a:tab algn="l" pos="8045280"/>
                    <a:tab algn="l" pos="9194760"/>
                    <a:tab algn="l" pos="10344240"/>
                  </a:tabLst>
                </a:pPr>
                <a:r>
                  <a:rPr b="1" lang="en-US" sz="14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1" lang="en-US" sz="1400" spc="-1" strike="noStrike">
                    <a:solidFill>
                      <a:srgbClr val="000000"/>
                    </a:solidFill>
                    <a:latin typeface="Arial"/>
                  </a:rPr>
                  <a:t>Os11g34450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3" name=""/>
              <p:cNvSpPr/>
              <p:nvPr/>
            </p:nvSpPr>
            <p:spPr>
              <a:xfrm>
                <a:off x="4626000" y="4616280"/>
                <a:ext cx="808200" cy="90360"/>
              </a:xfrm>
              <a:custGeom>
                <a:avLst/>
                <a:gdLst/>
                <a:ahLst/>
                <a:rect l="l" t="t" r="r" b="b"/>
                <a:pathLst>
                  <a:path w="509" h="57">
                    <a:moveTo>
                      <a:pt x="0" y="0"/>
                    </a:moveTo>
                    <a:lnTo>
                      <a:pt x="0" y="57"/>
                    </a:lnTo>
                    <a:lnTo>
                      <a:pt x="509" y="57"/>
                    </a:lnTo>
                  </a:path>
                </a:pathLst>
              </a:custGeom>
              <a:noFill/>
              <a:ln w="255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3560" bIns="43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4" name=""/>
              <p:cNvSpPr/>
              <p:nvPr/>
            </p:nvSpPr>
            <p:spPr>
              <a:xfrm>
                <a:off x="4332240" y="4411440"/>
                <a:ext cx="293760" cy="192240"/>
              </a:xfrm>
              <a:custGeom>
                <a:avLst/>
                <a:gdLst/>
                <a:ahLst/>
                <a:rect l="l" t="t" r="r" b="b"/>
                <a:pathLst>
                  <a:path w="185" h="121">
                    <a:moveTo>
                      <a:pt x="0" y="0"/>
                    </a:moveTo>
                    <a:lnTo>
                      <a:pt x="0" y="121"/>
                    </a:lnTo>
                    <a:lnTo>
                      <a:pt x="185" y="121"/>
                    </a:lnTo>
                  </a:path>
                </a:pathLst>
              </a:custGeom>
              <a:noFill/>
              <a:ln w="255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5" name=""/>
              <p:cNvSpPr/>
              <p:nvPr/>
            </p:nvSpPr>
            <p:spPr>
              <a:xfrm>
                <a:off x="4203720" y="4398840"/>
                <a:ext cx="128520" cy="525240"/>
              </a:xfrm>
              <a:custGeom>
                <a:avLst/>
                <a:gdLst/>
                <a:ahLst/>
                <a:rect l="l" t="t" r="r" b="b"/>
                <a:pathLst>
                  <a:path w="81" h="331">
                    <a:moveTo>
                      <a:pt x="0" y="331"/>
                    </a:moveTo>
                    <a:lnTo>
                      <a:pt x="0" y="0"/>
                    </a:lnTo>
                    <a:lnTo>
                      <a:pt x="81" y="0"/>
                    </a:lnTo>
                  </a:path>
                </a:pathLst>
              </a:custGeom>
              <a:noFill/>
              <a:ln w="255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6" name=""/>
              <p:cNvSpPr/>
              <p:nvPr/>
            </p:nvSpPr>
            <p:spPr>
              <a:xfrm>
                <a:off x="5699520" y="4770360"/>
                <a:ext cx="1248840" cy="213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1149480"/>
                    <a:tab algn="l" pos="2298600"/>
                    <a:tab algn="l" pos="3448080"/>
                    <a:tab algn="l" pos="4597560"/>
                    <a:tab algn="l" pos="5746680"/>
                    <a:tab algn="l" pos="6896160"/>
                    <a:tab algn="l" pos="8045280"/>
                    <a:tab algn="l" pos="9194760"/>
                    <a:tab algn="l" pos="10344240"/>
                  </a:tabLst>
                </a:pPr>
                <a:r>
                  <a:rPr b="1" lang="en-US" sz="14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1" lang="en-US" sz="1400" spc="-1" strike="noStrike">
                    <a:solidFill>
                      <a:srgbClr val="000000"/>
                    </a:solidFill>
                    <a:latin typeface="Arial"/>
                  </a:rPr>
                  <a:t>BraA.GRF14.k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7" name=""/>
              <p:cNvSpPr/>
              <p:nvPr/>
            </p:nvSpPr>
            <p:spPr>
              <a:xfrm>
                <a:off x="5139000" y="4911480"/>
                <a:ext cx="295200" cy="88920"/>
              </a:xfrm>
              <a:custGeom>
                <a:avLst/>
                <a:gdLst/>
                <a:ahLst/>
                <a:rect l="l" t="t" r="r" b="b"/>
                <a:pathLst>
                  <a:path w="186" h="56">
                    <a:moveTo>
                      <a:pt x="0" y="56"/>
                    </a:moveTo>
                    <a:lnTo>
                      <a:pt x="0" y="0"/>
                    </a:lnTo>
                    <a:lnTo>
                      <a:pt x="186" y="0"/>
                    </a:lnTo>
                  </a:path>
                </a:pathLst>
              </a:custGeom>
              <a:noFill/>
              <a:ln w="255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2120" bIns="421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8" name=""/>
              <p:cNvSpPr/>
              <p:nvPr/>
            </p:nvSpPr>
            <p:spPr>
              <a:xfrm>
                <a:off x="5699160" y="4974840"/>
                <a:ext cx="1200240" cy="213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1149480"/>
                    <a:tab algn="l" pos="2298600"/>
                    <a:tab algn="l" pos="3448080"/>
                    <a:tab algn="l" pos="4597560"/>
                    <a:tab algn="l" pos="5746680"/>
                    <a:tab algn="l" pos="6896160"/>
                    <a:tab algn="l" pos="8045280"/>
                    <a:tab algn="l" pos="9194760"/>
                    <a:tab algn="l" pos="10344240"/>
                  </a:tabLst>
                </a:pPr>
                <a:r>
                  <a:rPr b="1" lang="en-US" sz="14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1" lang="en-US" sz="1400" spc="-1" strike="noStrike">
                    <a:solidFill>
                      <a:srgbClr val="000000"/>
                    </a:solidFill>
                    <a:latin typeface="Arial"/>
                  </a:rPr>
                  <a:t>BraA.GRF14.l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9" name=""/>
              <p:cNvSpPr/>
              <p:nvPr/>
            </p:nvSpPr>
            <p:spPr>
              <a:xfrm>
                <a:off x="5139000" y="5025960"/>
                <a:ext cx="295200" cy="88560"/>
              </a:xfrm>
              <a:custGeom>
                <a:avLst/>
                <a:gdLst/>
                <a:ahLst/>
                <a:rect l="l" t="t" r="r" b="b"/>
                <a:pathLst>
                  <a:path w="186" h="56">
                    <a:moveTo>
                      <a:pt x="0" y="0"/>
                    </a:moveTo>
                    <a:lnTo>
                      <a:pt x="0" y="56"/>
                    </a:lnTo>
                    <a:lnTo>
                      <a:pt x="186" y="56"/>
                    </a:lnTo>
                  </a:path>
                </a:pathLst>
              </a:custGeom>
              <a:noFill/>
              <a:ln w="255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1760" bIns="41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0" name=""/>
              <p:cNvSpPr/>
              <p:nvPr/>
            </p:nvSpPr>
            <p:spPr>
              <a:xfrm>
                <a:off x="5100840" y="5013000"/>
                <a:ext cx="38160" cy="141480"/>
              </a:xfrm>
              <a:custGeom>
                <a:avLst/>
                <a:gdLst/>
                <a:ahLst/>
                <a:rect l="l" t="t" r="r" b="b"/>
                <a:pathLst>
                  <a:path w="24" h="89">
                    <a:moveTo>
                      <a:pt x="0" y="89"/>
                    </a:moveTo>
                    <a:lnTo>
                      <a:pt x="0" y="0"/>
                    </a:lnTo>
                    <a:lnTo>
                      <a:pt x="24" y="0"/>
                    </a:lnTo>
                  </a:path>
                </a:pathLst>
              </a:custGeom>
              <a:noFill/>
              <a:ln w="255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1" name=""/>
              <p:cNvSpPr/>
              <p:nvPr/>
            </p:nvSpPr>
            <p:spPr>
              <a:xfrm>
                <a:off x="5700960" y="5179680"/>
                <a:ext cx="712440" cy="213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1149480"/>
                    <a:tab algn="l" pos="2298600"/>
                    <a:tab algn="l" pos="3448080"/>
                    <a:tab algn="l" pos="4597560"/>
                    <a:tab algn="l" pos="5746680"/>
                    <a:tab algn="l" pos="6896160"/>
                    <a:tab algn="l" pos="8045280"/>
                    <a:tab algn="l" pos="9194760"/>
                    <a:tab algn="l" pos="10344240"/>
                  </a:tabLst>
                </a:pPr>
                <a:r>
                  <a:rPr b="1" lang="en-US" sz="14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1" lang="en-US" sz="1400" spc="-1" strike="noStrike">
                    <a:solidFill>
                      <a:srgbClr val="000000"/>
                    </a:solidFill>
                    <a:latin typeface="Arial"/>
                  </a:rPr>
                  <a:t>AtGRF3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2" name=""/>
              <p:cNvSpPr/>
              <p:nvPr/>
            </p:nvSpPr>
            <p:spPr>
              <a:xfrm>
                <a:off x="5100840" y="5179680"/>
                <a:ext cx="333360" cy="139680"/>
              </a:xfrm>
              <a:custGeom>
                <a:avLst/>
                <a:gdLst/>
                <a:ahLst/>
                <a:rect l="l" t="t" r="r" b="b"/>
                <a:pathLst>
                  <a:path w="210" h="88">
                    <a:moveTo>
                      <a:pt x="0" y="0"/>
                    </a:moveTo>
                    <a:lnTo>
                      <a:pt x="0" y="88"/>
                    </a:lnTo>
                    <a:lnTo>
                      <a:pt x="210" y="88"/>
                    </a:lnTo>
                  </a:path>
                </a:pathLst>
              </a:custGeom>
              <a:noFill/>
              <a:ln w="255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3" name=""/>
              <p:cNvSpPr/>
              <p:nvPr/>
            </p:nvSpPr>
            <p:spPr>
              <a:xfrm>
                <a:off x="4537080" y="5167080"/>
                <a:ext cx="563760" cy="293760"/>
              </a:xfrm>
              <a:custGeom>
                <a:avLst/>
                <a:gdLst/>
                <a:ahLst/>
                <a:rect l="l" t="t" r="r" b="b"/>
                <a:pathLst>
                  <a:path w="355" h="185">
                    <a:moveTo>
                      <a:pt x="0" y="185"/>
                    </a:moveTo>
                    <a:lnTo>
                      <a:pt x="0" y="0"/>
                    </a:lnTo>
                    <a:lnTo>
                      <a:pt x="355" y="0"/>
                    </a:lnTo>
                  </a:path>
                </a:pathLst>
              </a:custGeom>
              <a:noFill/>
              <a:ln w="255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4" name=""/>
              <p:cNvSpPr/>
              <p:nvPr/>
            </p:nvSpPr>
            <p:spPr>
              <a:xfrm>
                <a:off x="5699880" y="5384520"/>
                <a:ext cx="1308600" cy="213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1149480"/>
                    <a:tab algn="l" pos="2298600"/>
                    <a:tab algn="l" pos="3448080"/>
                    <a:tab algn="l" pos="4597560"/>
                    <a:tab algn="l" pos="5746680"/>
                    <a:tab algn="l" pos="6896160"/>
                    <a:tab algn="l" pos="8045280"/>
                    <a:tab algn="l" pos="9194760"/>
                    <a:tab algn="l" pos="10344240"/>
                  </a:tabLst>
                </a:pPr>
                <a:r>
                  <a:rPr b="1" lang="en-US" sz="14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1" lang="en-US" sz="1400" spc="-1" strike="noStrike">
                    <a:solidFill>
                      <a:srgbClr val="000000"/>
                    </a:solidFill>
                    <a:latin typeface="Arial"/>
                  </a:rPr>
                  <a:t>BraA.GRF14.m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5" name=""/>
              <p:cNvSpPr/>
              <p:nvPr/>
            </p:nvSpPr>
            <p:spPr>
              <a:xfrm>
                <a:off x="4819680" y="5524200"/>
                <a:ext cx="614520" cy="243000"/>
              </a:xfrm>
              <a:custGeom>
                <a:avLst/>
                <a:gdLst/>
                <a:ahLst/>
                <a:rect l="l" t="t" r="r" b="b"/>
                <a:pathLst>
                  <a:path w="387" h="153">
                    <a:moveTo>
                      <a:pt x="0" y="153"/>
                    </a:moveTo>
                    <a:lnTo>
                      <a:pt x="0" y="0"/>
                    </a:lnTo>
                    <a:lnTo>
                      <a:pt x="387" y="0"/>
                    </a:lnTo>
                  </a:path>
                </a:pathLst>
              </a:custGeom>
              <a:noFill/>
              <a:ln w="255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6" name=""/>
              <p:cNvSpPr/>
              <p:nvPr/>
            </p:nvSpPr>
            <p:spPr>
              <a:xfrm>
                <a:off x="5699520" y="5589360"/>
                <a:ext cx="1258200" cy="213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1149480"/>
                    <a:tab algn="l" pos="2298600"/>
                    <a:tab algn="l" pos="3448080"/>
                    <a:tab algn="l" pos="4597560"/>
                    <a:tab algn="l" pos="5746680"/>
                    <a:tab algn="l" pos="6896160"/>
                    <a:tab algn="l" pos="8045280"/>
                    <a:tab algn="l" pos="9194760"/>
                    <a:tab algn="l" pos="10344240"/>
                  </a:tabLst>
                </a:pPr>
                <a:r>
                  <a:rPr b="1" lang="en-US" sz="14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1" lang="en-US" sz="1400" spc="-1" strike="noStrike">
                    <a:solidFill>
                      <a:srgbClr val="000000"/>
                    </a:solidFill>
                    <a:latin typeface="Arial"/>
                  </a:rPr>
                  <a:t>BraA.GRF14.o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7" name=""/>
              <p:cNvSpPr/>
              <p:nvPr/>
            </p:nvSpPr>
            <p:spPr>
              <a:xfrm>
                <a:off x="4819680" y="5729040"/>
                <a:ext cx="614520" cy="141120"/>
              </a:xfrm>
              <a:custGeom>
                <a:avLst/>
                <a:gdLst/>
                <a:ahLst/>
                <a:rect l="l" t="t" r="r" b="b"/>
                <a:pathLst>
                  <a:path w="387" h="89">
                    <a:moveTo>
                      <a:pt x="0" y="89"/>
                    </a:moveTo>
                    <a:lnTo>
                      <a:pt x="0" y="0"/>
                    </a:lnTo>
                    <a:lnTo>
                      <a:pt x="387" y="0"/>
                    </a:lnTo>
                  </a:path>
                </a:pathLst>
              </a:custGeom>
              <a:noFill/>
              <a:ln w="255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8" name=""/>
              <p:cNvSpPr/>
              <p:nvPr/>
            </p:nvSpPr>
            <p:spPr>
              <a:xfrm>
                <a:off x="5700960" y="5794200"/>
                <a:ext cx="712440" cy="213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1149480"/>
                    <a:tab algn="l" pos="2298600"/>
                    <a:tab algn="l" pos="3448080"/>
                    <a:tab algn="l" pos="4597560"/>
                    <a:tab algn="l" pos="5746680"/>
                    <a:tab algn="l" pos="6896160"/>
                    <a:tab algn="l" pos="8045280"/>
                    <a:tab algn="l" pos="9194760"/>
                    <a:tab algn="l" pos="10344240"/>
                  </a:tabLst>
                </a:pPr>
                <a:r>
                  <a:rPr b="1" lang="en-US" sz="14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1" lang="en-US" sz="1400" spc="-1" strike="noStrike">
                    <a:solidFill>
                      <a:srgbClr val="000000"/>
                    </a:solidFill>
                    <a:latin typeface="Arial"/>
                  </a:rPr>
                  <a:t>AtGRF5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9" name=""/>
              <p:cNvSpPr/>
              <p:nvPr/>
            </p:nvSpPr>
            <p:spPr>
              <a:xfrm>
                <a:off x="5024520" y="5933880"/>
                <a:ext cx="409680" cy="90360"/>
              </a:xfrm>
              <a:custGeom>
                <a:avLst/>
                <a:gdLst/>
                <a:ahLst/>
                <a:rect l="l" t="t" r="r" b="b"/>
                <a:pathLst>
                  <a:path w="258" h="57">
                    <a:moveTo>
                      <a:pt x="0" y="57"/>
                    </a:moveTo>
                    <a:lnTo>
                      <a:pt x="0" y="0"/>
                    </a:lnTo>
                    <a:lnTo>
                      <a:pt x="258" y="0"/>
                    </a:lnTo>
                  </a:path>
                </a:pathLst>
              </a:custGeom>
              <a:noFill/>
              <a:ln w="255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3560" bIns="43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0" name=""/>
              <p:cNvSpPr/>
              <p:nvPr/>
            </p:nvSpPr>
            <p:spPr>
              <a:xfrm>
                <a:off x="5700960" y="5999040"/>
                <a:ext cx="712440" cy="213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1149480"/>
                    <a:tab algn="l" pos="2298600"/>
                    <a:tab algn="l" pos="3448080"/>
                    <a:tab algn="l" pos="4597560"/>
                    <a:tab algn="l" pos="5746680"/>
                    <a:tab algn="l" pos="6896160"/>
                    <a:tab algn="l" pos="8045280"/>
                    <a:tab algn="l" pos="9194760"/>
                    <a:tab algn="l" pos="10344240"/>
                  </a:tabLst>
                </a:pPr>
                <a:r>
                  <a:rPr b="1" lang="en-US" sz="14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1" lang="en-US" sz="1400" spc="-1" strike="noStrike">
                    <a:solidFill>
                      <a:srgbClr val="000000"/>
                    </a:solidFill>
                    <a:latin typeface="Arial"/>
                  </a:rPr>
                  <a:t>AtGRF7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1" name=""/>
              <p:cNvSpPr/>
              <p:nvPr/>
            </p:nvSpPr>
            <p:spPr>
              <a:xfrm>
                <a:off x="5024520" y="6049800"/>
                <a:ext cx="409680" cy="88920"/>
              </a:xfrm>
              <a:custGeom>
                <a:avLst/>
                <a:gdLst/>
                <a:ahLst/>
                <a:rect l="l" t="t" r="r" b="b"/>
                <a:pathLst>
                  <a:path w="258" h="56">
                    <a:moveTo>
                      <a:pt x="0" y="0"/>
                    </a:moveTo>
                    <a:lnTo>
                      <a:pt x="0" y="56"/>
                    </a:lnTo>
                    <a:lnTo>
                      <a:pt x="258" y="56"/>
                    </a:lnTo>
                  </a:path>
                </a:pathLst>
              </a:custGeom>
              <a:noFill/>
              <a:ln w="255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2120" bIns="421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2" name=""/>
              <p:cNvSpPr/>
              <p:nvPr/>
            </p:nvSpPr>
            <p:spPr>
              <a:xfrm>
                <a:off x="4819680" y="5895720"/>
                <a:ext cx="204840" cy="141480"/>
              </a:xfrm>
              <a:custGeom>
                <a:avLst/>
                <a:gdLst/>
                <a:ahLst/>
                <a:rect l="l" t="t" r="r" b="b"/>
                <a:pathLst>
                  <a:path w="129" h="89">
                    <a:moveTo>
                      <a:pt x="0" y="0"/>
                    </a:moveTo>
                    <a:lnTo>
                      <a:pt x="0" y="89"/>
                    </a:lnTo>
                    <a:lnTo>
                      <a:pt x="129" y="89"/>
                    </a:lnTo>
                  </a:path>
                </a:pathLst>
              </a:custGeom>
              <a:noFill/>
              <a:ln w="255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3" name=""/>
              <p:cNvSpPr/>
              <p:nvPr/>
            </p:nvSpPr>
            <p:spPr>
              <a:xfrm>
                <a:off x="4819680" y="5794200"/>
                <a:ext cx="1800" cy="243000"/>
              </a:xfrm>
              <a:prstGeom prst="line">
                <a:avLst/>
              </a:prstGeom>
              <a:ln w="255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4" name=""/>
              <p:cNvSpPr/>
              <p:nvPr/>
            </p:nvSpPr>
            <p:spPr>
              <a:xfrm>
                <a:off x="4537080" y="5486040"/>
                <a:ext cx="282600" cy="293760"/>
              </a:xfrm>
              <a:custGeom>
                <a:avLst/>
                <a:gdLst/>
                <a:ahLst/>
                <a:rect l="l" t="t" r="r" b="b"/>
                <a:pathLst>
                  <a:path w="178" h="185">
                    <a:moveTo>
                      <a:pt x="0" y="0"/>
                    </a:moveTo>
                    <a:lnTo>
                      <a:pt x="0" y="185"/>
                    </a:lnTo>
                    <a:lnTo>
                      <a:pt x="178" y="185"/>
                    </a:lnTo>
                  </a:path>
                </a:pathLst>
              </a:custGeom>
              <a:noFill/>
              <a:ln w="255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5" name=""/>
              <p:cNvSpPr/>
              <p:nvPr/>
            </p:nvSpPr>
            <p:spPr>
              <a:xfrm>
                <a:off x="4203720" y="4949640"/>
                <a:ext cx="333360" cy="523800"/>
              </a:xfrm>
              <a:custGeom>
                <a:avLst/>
                <a:gdLst/>
                <a:ahLst/>
                <a:rect l="l" t="t" r="r" b="b"/>
                <a:pathLst>
                  <a:path w="210" h="330">
                    <a:moveTo>
                      <a:pt x="0" y="0"/>
                    </a:moveTo>
                    <a:lnTo>
                      <a:pt x="0" y="330"/>
                    </a:lnTo>
                    <a:lnTo>
                      <a:pt x="210" y="330"/>
                    </a:lnTo>
                  </a:path>
                </a:pathLst>
              </a:custGeom>
              <a:noFill/>
              <a:ln w="255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6" name=""/>
              <p:cNvSpPr/>
              <p:nvPr/>
            </p:nvSpPr>
            <p:spPr>
              <a:xfrm>
                <a:off x="3961080" y="4424040"/>
                <a:ext cx="242640" cy="513000"/>
              </a:xfrm>
              <a:custGeom>
                <a:avLst/>
                <a:gdLst/>
                <a:ahLst/>
                <a:rect l="l" t="t" r="r" b="b"/>
                <a:pathLst>
                  <a:path w="153" h="323">
                    <a:moveTo>
                      <a:pt x="0" y="0"/>
                    </a:moveTo>
                    <a:lnTo>
                      <a:pt x="0" y="323"/>
                    </a:lnTo>
                    <a:lnTo>
                      <a:pt x="153" y="323"/>
                    </a:lnTo>
                  </a:path>
                </a:pathLst>
              </a:custGeom>
              <a:noFill/>
              <a:ln w="255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7" name=""/>
              <p:cNvSpPr/>
              <p:nvPr/>
            </p:nvSpPr>
            <p:spPr>
              <a:xfrm>
                <a:off x="3192480" y="3452400"/>
                <a:ext cx="768600" cy="959040"/>
              </a:xfrm>
              <a:custGeom>
                <a:avLst/>
                <a:gdLst/>
                <a:ahLst/>
                <a:rect l="l" t="t" r="r" b="b"/>
                <a:pathLst>
                  <a:path w="484" h="604">
                    <a:moveTo>
                      <a:pt x="0" y="0"/>
                    </a:moveTo>
                    <a:lnTo>
                      <a:pt x="0" y="604"/>
                    </a:lnTo>
                    <a:lnTo>
                      <a:pt x="484" y="604"/>
                    </a:lnTo>
                  </a:path>
                </a:pathLst>
              </a:custGeom>
              <a:noFill/>
              <a:ln w="255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8" name=""/>
              <p:cNvSpPr/>
              <p:nvPr/>
            </p:nvSpPr>
            <p:spPr>
              <a:xfrm>
                <a:off x="706680" y="3439800"/>
                <a:ext cx="2485800" cy="1714680"/>
              </a:xfrm>
              <a:custGeom>
                <a:avLst/>
                <a:gdLst/>
                <a:ahLst/>
                <a:rect l="l" t="t" r="r" b="b"/>
                <a:pathLst>
                  <a:path w="1566" h="1080">
                    <a:moveTo>
                      <a:pt x="0" y="1080"/>
                    </a:moveTo>
                    <a:lnTo>
                      <a:pt x="0" y="0"/>
                    </a:lnTo>
                    <a:lnTo>
                      <a:pt x="1566" y="0"/>
                    </a:lnTo>
                  </a:path>
                </a:pathLst>
              </a:custGeom>
              <a:noFill/>
              <a:ln w="255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9" name=""/>
              <p:cNvSpPr/>
              <p:nvPr/>
            </p:nvSpPr>
            <p:spPr>
              <a:xfrm>
                <a:off x="5698440" y="6202080"/>
                <a:ext cx="1090440" cy="213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1149480"/>
                    <a:tab algn="l" pos="2298600"/>
                    <a:tab algn="l" pos="3448080"/>
                    <a:tab algn="l" pos="4597560"/>
                    <a:tab algn="l" pos="5746680"/>
                    <a:tab algn="l" pos="6896160"/>
                    <a:tab algn="l" pos="8045280"/>
                    <a:tab algn="l" pos="9194760"/>
                    <a:tab algn="l" pos="10344240"/>
                  </a:tabLst>
                </a:pPr>
                <a:r>
                  <a:rPr b="1" lang="en-US" sz="14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1" lang="en-US" sz="1400" spc="-1" strike="noStrike">
                    <a:solidFill>
                      <a:srgbClr val="000000"/>
                    </a:solidFill>
                    <a:latin typeface="Arial"/>
                  </a:rPr>
                  <a:t>Os01g11110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0" name=""/>
              <p:cNvSpPr/>
              <p:nvPr/>
            </p:nvSpPr>
            <p:spPr>
              <a:xfrm>
                <a:off x="1487520" y="6343560"/>
                <a:ext cx="3946680" cy="549000"/>
              </a:xfrm>
              <a:custGeom>
                <a:avLst/>
                <a:gdLst/>
                <a:ahLst/>
                <a:rect l="l" t="t" r="r" b="b"/>
                <a:pathLst>
                  <a:path w="2486" h="346">
                    <a:moveTo>
                      <a:pt x="0" y="346"/>
                    </a:moveTo>
                    <a:lnTo>
                      <a:pt x="0" y="0"/>
                    </a:lnTo>
                    <a:lnTo>
                      <a:pt x="2486" y="0"/>
                    </a:lnTo>
                  </a:path>
                </a:pathLst>
              </a:custGeom>
              <a:noFill/>
              <a:ln w="255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1" name=""/>
              <p:cNvSpPr/>
              <p:nvPr/>
            </p:nvSpPr>
            <p:spPr>
              <a:xfrm>
                <a:off x="5699520" y="6406920"/>
                <a:ext cx="1248840" cy="213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1149480"/>
                    <a:tab algn="l" pos="2298600"/>
                    <a:tab algn="l" pos="3448080"/>
                    <a:tab algn="l" pos="4597560"/>
                    <a:tab algn="l" pos="5746680"/>
                    <a:tab algn="l" pos="6896160"/>
                    <a:tab algn="l" pos="8045280"/>
                    <a:tab algn="l" pos="9194760"/>
                    <a:tab algn="l" pos="10344240"/>
                  </a:tabLst>
                </a:pPr>
                <a:r>
                  <a:rPr b="1" lang="en-US" sz="14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1" lang="en-US" sz="1400" spc="-1" strike="noStrike">
                    <a:solidFill>
                      <a:srgbClr val="000000"/>
                    </a:solidFill>
                    <a:latin typeface="Arial"/>
                  </a:rPr>
                  <a:t>BraA.GRF14.c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2" name=""/>
              <p:cNvSpPr/>
              <p:nvPr/>
            </p:nvSpPr>
            <p:spPr>
              <a:xfrm>
                <a:off x="5357880" y="6548040"/>
                <a:ext cx="76320" cy="88920"/>
              </a:xfrm>
              <a:custGeom>
                <a:avLst/>
                <a:gdLst/>
                <a:ahLst/>
                <a:rect l="l" t="t" r="r" b="b"/>
                <a:pathLst>
                  <a:path w="48" h="56">
                    <a:moveTo>
                      <a:pt x="0" y="56"/>
                    </a:moveTo>
                    <a:lnTo>
                      <a:pt x="0" y="0"/>
                    </a:lnTo>
                    <a:lnTo>
                      <a:pt x="48" y="0"/>
                    </a:lnTo>
                  </a:path>
                </a:pathLst>
              </a:custGeom>
              <a:noFill/>
              <a:ln w="255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2120" bIns="421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3" name=""/>
              <p:cNvSpPr/>
              <p:nvPr/>
            </p:nvSpPr>
            <p:spPr>
              <a:xfrm>
                <a:off x="5699520" y="6611760"/>
                <a:ext cx="1258200" cy="213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1149480"/>
                    <a:tab algn="l" pos="2298600"/>
                    <a:tab algn="l" pos="3448080"/>
                    <a:tab algn="l" pos="4597560"/>
                    <a:tab algn="l" pos="5746680"/>
                    <a:tab algn="l" pos="6896160"/>
                    <a:tab algn="l" pos="8045280"/>
                    <a:tab algn="l" pos="9194760"/>
                    <a:tab algn="l" pos="10344240"/>
                  </a:tabLst>
                </a:pPr>
                <a:r>
                  <a:rPr b="1" lang="en-US" sz="14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1" lang="en-US" sz="1400" spc="-1" strike="noStrike">
                    <a:solidFill>
                      <a:srgbClr val="000000"/>
                    </a:solidFill>
                    <a:latin typeface="Arial"/>
                  </a:rPr>
                  <a:t>BraA.GRF14.d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4" name=""/>
              <p:cNvSpPr/>
              <p:nvPr/>
            </p:nvSpPr>
            <p:spPr>
              <a:xfrm>
                <a:off x="5357880" y="6662520"/>
                <a:ext cx="76320" cy="90360"/>
              </a:xfrm>
              <a:custGeom>
                <a:avLst/>
                <a:gdLst/>
                <a:ahLst/>
                <a:rect l="l" t="t" r="r" b="b"/>
                <a:pathLst>
                  <a:path w="48" h="57">
                    <a:moveTo>
                      <a:pt x="0" y="0"/>
                    </a:moveTo>
                    <a:lnTo>
                      <a:pt x="0" y="57"/>
                    </a:lnTo>
                    <a:lnTo>
                      <a:pt x="48" y="57"/>
                    </a:lnTo>
                  </a:path>
                </a:pathLst>
              </a:custGeom>
              <a:noFill/>
              <a:ln w="255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3560" bIns="43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5" name=""/>
              <p:cNvSpPr/>
              <p:nvPr/>
            </p:nvSpPr>
            <p:spPr>
              <a:xfrm>
                <a:off x="5280120" y="6649920"/>
                <a:ext cx="77760" cy="141120"/>
              </a:xfrm>
              <a:custGeom>
                <a:avLst/>
                <a:gdLst/>
                <a:ahLst/>
                <a:rect l="l" t="t" r="r" b="b"/>
                <a:pathLst>
                  <a:path w="49" h="89">
                    <a:moveTo>
                      <a:pt x="0" y="89"/>
                    </a:moveTo>
                    <a:lnTo>
                      <a:pt x="0" y="0"/>
                    </a:lnTo>
                    <a:lnTo>
                      <a:pt x="49" y="0"/>
                    </a:lnTo>
                  </a:path>
                </a:pathLst>
              </a:custGeom>
              <a:noFill/>
              <a:ln w="255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6" name=""/>
              <p:cNvSpPr/>
              <p:nvPr/>
            </p:nvSpPr>
            <p:spPr>
              <a:xfrm>
                <a:off x="5699520" y="6816600"/>
                <a:ext cx="1258200" cy="213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1149480"/>
                    <a:tab algn="l" pos="2298600"/>
                    <a:tab algn="l" pos="3448080"/>
                    <a:tab algn="l" pos="4597560"/>
                    <a:tab algn="l" pos="5746680"/>
                    <a:tab algn="l" pos="6896160"/>
                    <a:tab algn="l" pos="8045280"/>
                    <a:tab algn="l" pos="9194760"/>
                    <a:tab algn="l" pos="10344240"/>
                  </a:tabLst>
                </a:pPr>
                <a:r>
                  <a:rPr b="1" lang="en-US" sz="14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1" lang="en-US" sz="1400" spc="-1" strike="noStrike">
                    <a:solidFill>
                      <a:srgbClr val="000000"/>
                    </a:solidFill>
                    <a:latin typeface="Arial"/>
                  </a:rPr>
                  <a:t>BraA.GRF14.b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7" name=""/>
              <p:cNvSpPr/>
              <p:nvPr/>
            </p:nvSpPr>
            <p:spPr>
              <a:xfrm>
                <a:off x="5280120" y="6816600"/>
                <a:ext cx="154080" cy="141120"/>
              </a:xfrm>
              <a:custGeom>
                <a:avLst/>
                <a:gdLst/>
                <a:ahLst/>
                <a:rect l="l" t="t" r="r" b="b"/>
                <a:pathLst>
                  <a:path w="97" h="89">
                    <a:moveTo>
                      <a:pt x="0" y="0"/>
                    </a:moveTo>
                    <a:lnTo>
                      <a:pt x="0" y="89"/>
                    </a:lnTo>
                    <a:lnTo>
                      <a:pt x="97" y="89"/>
                    </a:lnTo>
                  </a:path>
                </a:pathLst>
              </a:custGeom>
              <a:noFill/>
              <a:ln w="255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8" name=""/>
              <p:cNvSpPr/>
              <p:nvPr/>
            </p:nvSpPr>
            <p:spPr>
              <a:xfrm>
                <a:off x="5191200" y="6803640"/>
                <a:ext cx="88920" cy="166680"/>
              </a:xfrm>
              <a:custGeom>
                <a:avLst/>
                <a:gdLst/>
                <a:ahLst/>
                <a:rect l="l" t="t" r="r" b="b"/>
                <a:pathLst>
                  <a:path w="56" h="105">
                    <a:moveTo>
                      <a:pt x="0" y="105"/>
                    </a:moveTo>
                    <a:lnTo>
                      <a:pt x="0" y="0"/>
                    </a:lnTo>
                    <a:lnTo>
                      <a:pt x="56" y="0"/>
                    </a:lnTo>
                  </a:path>
                </a:pathLst>
              </a:custGeom>
              <a:noFill/>
              <a:ln w="255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9" name=""/>
              <p:cNvSpPr/>
              <p:nvPr/>
            </p:nvSpPr>
            <p:spPr>
              <a:xfrm>
                <a:off x="5700960" y="7021440"/>
                <a:ext cx="811440" cy="213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1149480"/>
                    <a:tab algn="l" pos="2298600"/>
                    <a:tab algn="l" pos="3448080"/>
                    <a:tab algn="l" pos="4597560"/>
                    <a:tab algn="l" pos="5746680"/>
                    <a:tab algn="l" pos="6896160"/>
                    <a:tab algn="l" pos="8045280"/>
                    <a:tab algn="l" pos="9194760"/>
                    <a:tab algn="l" pos="10344240"/>
                  </a:tabLst>
                </a:pPr>
                <a:r>
                  <a:rPr b="1" lang="en-US" sz="14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1" lang="en-US" sz="1400" spc="-1" strike="noStrike">
                    <a:solidFill>
                      <a:srgbClr val="000000"/>
                    </a:solidFill>
                    <a:latin typeface="Arial"/>
                  </a:rPr>
                  <a:t>AtGRF12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0" name=""/>
              <p:cNvSpPr/>
              <p:nvPr/>
            </p:nvSpPr>
            <p:spPr>
              <a:xfrm>
                <a:off x="5191200" y="6995880"/>
                <a:ext cx="243000" cy="166680"/>
              </a:xfrm>
              <a:custGeom>
                <a:avLst/>
                <a:gdLst/>
                <a:ahLst/>
                <a:rect l="l" t="t" r="r" b="b"/>
                <a:pathLst>
                  <a:path w="153" h="105">
                    <a:moveTo>
                      <a:pt x="0" y="0"/>
                    </a:moveTo>
                    <a:lnTo>
                      <a:pt x="0" y="105"/>
                    </a:lnTo>
                    <a:lnTo>
                      <a:pt x="153" y="105"/>
                    </a:lnTo>
                  </a:path>
                </a:pathLst>
              </a:custGeom>
              <a:noFill/>
              <a:ln w="255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1" name=""/>
              <p:cNvSpPr/>
              <p:nvPr/>
            </p:nvSpPr>
            <p:spPr>
              <a:xfrm>
                <a:off x="2217960" y="6983280"/>
                <a:ext cx="2973240" cy="473040"/>
              </a:xfrm>
              <a:custGeom>
                <a:avLst/>
                <a:gdLst/>
                <a:ahLst/>
                <a:rect l="l" t="t" r="r" b="b"/>
                <a:pathLst>
                  <a:path w="1873" h="298">
                    <a:moveTo>
                      <a:pt x="0" y="298"/>
                    </a:moveTo>
                    <a:lnTo>
                      <a:pt x="0" y="0"/>
                    </a:lnTo>
                    <a:lnTo>
                      <a:pt x="1873" y="0"/>
                    </a:lnTo>
                  </a:path>
                </a:pathLst>
              </a:custGeom>
              <a:noFill/>
              <a:ln w="255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2" name=""/>
              <p:cNvSpPr/>
              <p:nvPr/>
            </p:nvSpPr>
            <p:spPr>
              <a:xfrm>
                <a:off x="5700960" y="7225920"/>
                <a:ext cx="811440" cy="213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1149480"/>
                    <a:tab algn="l" pos="2298600"/>
                    <a:tab algn="l" pos="3448080"/>
                    <a:tab algn="l" pos="4597560"/>
                    <a:tab algn="l" pos="5746680"/>
                    <a:tab algn="l" pos="6896160"/>
                    <a:tab algn="l" pos="8045280"/>
                    <a:tab algn="l" pos="9194760"/>
                    <a:tab algn="l" pos="10344240"/>
                  </a:tabLst>
                </a:pPr>
                <a:r>
                  <a:rPr b="1" lang="en-US" sz="14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1" lang="en-US" sz="1400" spc="-1" strike="noStrike">
                    <a:solidFill>
                      <a:srgbClr val="000000"/>
                    </a:solidFill>
                    <a:latin typeface="Arial"/>
                  </a:rPr>
                  <a:t>AtGRF11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3" name=""/>
              <p:cNvSpPr/>
              <p:nvPr/>
            </p:nvSpPr>
            <p:spPr>
              <a:xfrm>
                <a:off x="2217960" y="7367400"/>
                <a:ext cx="3216240" cy="280800"/>
              </a:xfrm>
              <a:custGeom>
                <a:avLst/>
                <a:gdLst/>
                <a:ahLst/>
                <a:rect l="l" t="t" r="r" b="b"/>
                <a:pathLst>
                  <a:path w="2026" h="177">
                    <a:moveTo>
                      <a:pt x="0" y="177"/>
                    </a:moveTo>
                    <a:lnTo>
                      <a:pt x="0" y="0"/>
                    </a:lnTo>
                    <a:lnTo>
                      <a:pt x="2026" y="0"/>
                    </a:lnTo>
                  </a:path>
                </a:pathLst>
              </a:custGeom>
              <a:noFill/>
              <a:ln w="255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4" name=""/>
              <p:cNvSpPr/>
              <p:nvPr/>
            </p:nvSpPr>
            <p:spPr>
              <a:xfrm>
                <a:off x="5700960" y="7430760"/>
                <a:ext cx="712440" cy="213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1149480"/>
                    <a:tab algn="l" pos="2298600"/>
                    <a:tab algn="l" pos="3448080"/>
                    <a:tab algn="l" pos="4597560"/>
                    <a:tab algn="l" pos="5746680"/>
                    <a:tab algn="l" pos="6896160"/>
                    <a:tab algn="l" pos="8045280"/>
                    <a:tab algn="l" pos="9194760"/>
                    <a:tab algn="l" pos="10344240"/>
                  </a:tabLst>
                </a:pPr>
                <a:r>
                  <a:rPr b="1" lang="en-US" sz="14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1" lang="en-US" sz="1400" spc="-1" strike="noStrike">
                    <a:solidFill>
                      <a:srgbClr val="000000"/>
                    </a:solidFill>
                    <a:latin typeface="Arial"/>
                  </a:rPr>
                  <a:t>AtGRF9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5" name=""/>
              <p:cNvSpPr/>
              <p:nvPr/>
            </p:nvSpPr>
            <p:spPr>
              <a:xfrm>
                <a:off x="4883400" y="7572240"/>
                <a:ext cx="550800" cy="88920"/>
              </a:xfrm>
              <a:custGeom>
                <a:avLst/>
                <a:gdLst/>
                <a:ahLst/>
                <a:rect l="l" t="t" r="r" b="b"/>
                <a:pathLst>
                  <a:path w="347" h="56">
                    <a:moveTo>
                      <a:pt x="0" y="56"/>
                    </a:moveTo>
                    <a:lnTo>
                      <a:pt x="0" y="0"/>
                    </a:lnTo>
                    <a:lnTo>
                      <a:pt x="347" y="0"/>
                    </a:lnTo>
                  </a:path>
                </a:pathLst>
              </a:custGeom>
              <a:noFill/>
              <a:ln w="255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2120" bIns="421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6" name=""/>
              <p:cNvSpPr/>
              <p:nvPr/>
            </p:nvSpPr>
            <p:spPr>
              <a:xfrm>
                <a:off x="5699520" y="7635600"/>
                <a:ext cx="1209240" cy="213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1149480"/>
                    <a:tab algn="l" pos="2298600"/>
                    <a:tab algn="l" pos="3448080"/>
                    <a:tab algn="l" pos="4597560"/>
                    <a:tab algn="l" pos="5746680"/>
                    <a:tab algn="l" pos="6896160"/>
                    <a:tab algn="l" pos="8045280"/>
                    <a:tab algn="l" pos="9194760"/>
                    <a:tab algn="l" pos="10344240"/>
                  </a:tabLst>
                </a:pPr>
                <a:r>
                  <a:rPr b="1" lang="en-US" sz="14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1" lang="en-US" sz="1400" spc="-1" strike="noStrike">
                    <a:solidFill>
                      <a:srgbClr val="000000"/>
                    </a:solidFill>
                    <a:latin typeface="Arial"/>
                  </a:rPr>
                  <a:t>BraA.GRF14.f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7" name=""/>
              <p:cNvSpPr/>
              <p:nvPr/>
            </p:nvSpPr>
            <p:spPr>
              <a:xfrm>
                <a:off x="4883400" y="7686360"/>
                <a:ext cx="550800" cy="88920"/>
              </a:xfrm>
              <a:custGeom>
                <a:avLst/>
                <a:gdLst/>
                <a:ahLst/>
                <a:rect l="l" t="t" r="r" b="b"/>
                <a:pathLst>
                  <a:path w="347" h="56">
                    <a:moveTo>
                      <a:pt x="0" y="0"/>
                    </a:moveTo>
                    <a:lnTo>
                      <a:pt x="0" y="56"/>
                    </a:lnTo>
                    <a:lnTo>
                      <a:pt x="347" y="56"/>
                    </a:lnTo>
                  </a:path>
                </a:pathLst>
              </a:custGeom>
              <a:noFill/>
              <a:ln w="255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2120" bIns="421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8" name=""/>
              <p:cNvSpPr/>
              <p:nvPr/>
            </p:nvSpPr>
            <p:spPr>
              <a:xfrm>
                <a:off x="2243160" y="7673760"/>
                <a:ext cx="2640240" cy="268200"/>
              </a:xfrm>
              <a:custGeom>
                <a:avLst/>
                <a:gdLst/>
                <a:ahLst/>
                <a:rect l="l" t="t" r="r" b="b"/>
                <a:pathLst>
                  <a:path w="1663" h="169">
                    <a:moveTo>
                      <a:pt x="0" y="169"/>
                    </a:moveTo>
                    <a:lnTo>
                      <a:pt x="0" y="0"/>
                    </a:lnTo>
                    <a:lnTo>
                      <a:pt x="1663" y="0"/>
                    </a:lnTo>
                  </a:path>
                </a:pathLst>
              </a:custGeom>
              <a:noFill/>
              <a:ln w="255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9" name=""/>
              <p:cNvSpPr/>
              <p:nvPr/>
            </p:nvSpPr>
            <p:spPr>
              <a:xfrm>
                <a:off x="5698440" y="7840440"/>
                <a:ext cx="1090440" cy="213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1149480"/>
                    <a:tab algn="l" pos="2298600"/>
                    <a:tab algn="l" pos="3448080"/>
                    <a:tab algn="l" pos="4597560"/>
                    <a:tab algn="l" pos="5746680"/>
                    <a:tab algn="l" pos="6896160"/>
                    <a:tab algn="l" pos="8045280"/>
                    <a:tab algn="l" pos="9194760"/>
                    <a:tab algn="l" pos="10344240"/>
                  </a:tabLst>
                </a:pPr>
                <a:r>
                  <a:rPr b="1" lang="en-US" sz="14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1" lang="en-US" sz="1400" spc="-1" strike="noStrike">
                    <a:solidFill>
                      <a:srgbClr val="000000"/>
                    </a:solidFill>
                    <a:latin typeface="Arial"/>
                  </a:rPr>
                  <a:t>Os11g39540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0" name=""/>
              <p:cNvSpPr/>
              <p:nvPr/>
            </p:nvSpPr>
            <p:spPr>
              <a:xfrm>
                <a:off x="2320920" y="7980120"/>
                <a:ext cx="3113280" cy="244440"/>
              </a:xfrm>
              <a:custGeom>
                <a:avLst/>
                <a:gdLst/>
                <a:ahLst/>
                <a:rect l="l" t="t" r="r" b="b"/>
                <a:pathLst>
                  <a:path w="1961" h="154">
                    <a:moveTo>
                      <a:pt x="0" y="154"/>
                    </a:moveTo>
                    <a:lnTo>
                      <a:pt x="0" y="0"/>
                    </a:lnTo>
                    <a:lnTo>
                      <a:pt x="1961" y="0"/>
                    </a:lnTo>
                  </a:path>
                </a:pathLst>
              </a:custGeom>
              <a:noFill/>
              <a:ln w="255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1" name=""/>
              <p:cNvSpPr/>
              <p:nvPr/>
            </p:nvSpPr>
            <p:spPr>
              <a:xfrm>
                <a:off x="5700960" y="8045280"/>
                <a:ext cx="811440" cy="213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1149480"/>
                    <a:tab algn="l" pos="2298600"/>
                    <a:tab algn="l" pos="3448080"/>
                    <a:tab algn="l" pos="4597560"/>
                    <a:tab algn="l" pos="5746680"/>
                    <a:tab algn="l" pos="6896160"/>
                    <a:tab algn="l" pos="8045280"/>
                    <a:tab algn="l" pos="9194760"/>
                    <a:tab algn="l" pos="10344240"/>
                  </a:tabLst>
                </a:pPr>
                <a:r>
                  <a:rPr b="1" lang="en-US" sz="14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1" lang="en-US" sz="1400" spc="-1" strike="noStrike">
                    <a:solidFill>
                      <a:srgbClr val="000000"/>
                    </a:solidFill>
                    <a:latin typeface="Arial"/>
                  </a:rPr>
                  <a:t>AtGRF10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2" name=""/>
              <p:cNvSpPr/>
              <p:nvPr/>
            </p:nvSpPr>
            <p:spPr>
              <a:xfrm>
                <a:off x="5087880" y="8184960"/>
                <a:ext cx="346320" cy="90360"/>
              </a:xfrm>
              <a:custGeom>
                <a:avLst/>
                <a:gdLst/>
                <a:ahLst/>
                <a:rect l="l" t="t" r="r" b="b"/>
                <a:pathLst>
                  <a:path w="218" h="57">
                    <a:moveTo>
                      <a:pt x="0" y="57"/>
                    </a:moveTo>
                    <a:lnTo>
                      <a:pt x="0" y="0"/>
                    </a:lnTo>
                    <a:lnTo>
                      <a:pt x="218" y="0"/>
                    </a:lnTo>
                  </a:path>
                </a:pathLst>
              </a:custGeom>
              <a:noFill/>
              <a:ln w="255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3560" bIns="43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3" name=""/>
              <p:cNvSpPr/>
              <p:nvPr/>
            </p:nvSpPr>
            <p:spPr>
              <a:xfrm>
                <a:off x="5699520" y="8250120"/>
                <a:ext cx="1248840" cy="213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1149480"/>
                    <a:tab algn="l" pos="2298600"/>
                    <a:tab algn="l" pos="3448080"/>
                    <a:tab algn="l" pos="4597560"/>
                    <a:tab algn="l" pos="5746680"/>
                    <a:tab algn="l" pos="6896160"/>
                    <a:tab algn="l" pos="8045280"/>
                    <a:tab algn="l" pos="9194760"/>
                    <a:tab algn="l" pos="10344240"/>
                  </a:tabLst>
                </a:pPr>
                <a:r>
                  <a:rPr b="1" lang="en-US" sz="14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1" lang="en-US" sz="1400" spc="-1" strike="noStrike">
                    <a:solidFill>
                      <a:srgbClr val="000000"/>
                    </a:solidFill>
                    <a:latin typeface="Arial"/>
                  </a:rPr>
                  <a:t>BraA.GRF14.a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4" name=""/>
              <p:cNvSpPr/>
              <p:nvPr/>
            </p:nvSpPr>
            <p:spPr>
              <a:xfrm>
                <a:off x="5087880" y="8300880"/>
                <a:ext cx="346320" cy="88920"/>
              </a:xfrm>
              <a:custGeom>
                <a:avLst/>
                <a:gdLst/>
                <a:ahLst/>
                <a:rect l="l" t="t" r="r" b="b"/>
                <a:pathLst>
                  <a:path w="218" h="56">
                    <a:moveTo>
                      <a:pt x="0" y="0"/>
                    </a:moveTo>
                    <a:lnTo>
                      <a:pt x="0" y="56"/>
                    </a:lnTo>
                    <a:lnTo>
                      <a:pt x="218" y="56"/>
                    </a:lnTo>
                  </a:path>
                </a:pathLst>
              </a:custGeom>
              <a:noFill/>
              <a:ln w="255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2120" bIns="421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5" name=""/>
              <p:cNvSpPr/>
              <p:nvPr/>
            </p:nvSpPr>
            <p:spPr>
              <a:xfrm>
                <a:off x="2538360" y="8287920"/>
                <a:ext cx="2549520" cy="192240"/>
              </a:xfrm>
              <a:custGeom>
                <a:avLst/>
                <a:gdLst/>
                <a:ahLst/>
                <a:rect l="l" t="t" r="r" b="b"/>
                <a:pathLst>
                  <a:path w="1606" h="121">
                    <a:moveTo>
                      <a:pt x="0" y="121"/>
                    </a:moveTo>
                    <a:lnTo>
                      <a:pt x="0" y="0"/>
                    </a:lnTo>
                    <a:lnTo>
                      <a:pt x="1606" y="0"/>
                    </a:lnTo>
                  </a:path>
                </a:pathLst>
              </a:custGeom>
              <a:noFill/>
              <a:ln w="255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6" name=""/>
              <p:cNvSpPr/>
              <p:nvPr/>
            </p:nvSpPr>
            <p:spPr>
              <a:xfrm>
                <a:off x="5700960" y="8454960"/>
                <a:ext cx="811440" cy="213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1149480"/>
                    <a:tab algn="l" pos="2298600"/>
                    <a:tab algn="l" pos="3448080"/>
                    <a:tab algn="l" pos="4597560"/>
                    <a:tab algn="l" pos="5746680"/>
                    <a:tab algn="l" pos="6896160"/>
                    <a:tab algn="l" pos="8045280"/>
                    <a:tab algn="l" pos="9194760"/>
                    <a:tab algn="l" pos="10344240"/>
                  </a:tabLst>
                </a:pPr>
                <a:r>
                  <a:rPr b="1" lang="en-US" sz="14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1" lang="en-US" sz="1400" spc="-1" strike="noStrike">
                    <a:solidFill>
                      <a:srgbClr val="000000"/>
                    </a:solidFill>
                    <a:latin typeface="Arial"/>
                  </a:rPr>
                  <a:t>AtGRF13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7" name=""/>
              <p:cNvSpPr/>
              <p:nvPr/>
            </p:nvSpPr>
            <p:spPr>
              <a:xfrm>
                <a:off x="4024440" y="8594640"/>
                <a:ext cx="1409760" cy="90360"/>
              </a:xfrm>
              <a:custGeom>
                <a:avLst/>
                <a:gdLst/>
                <a:ahLst/>
                <a:rect l="l" t="t" r="r" b="b"/>
                <a:pathLst>
                  <a:path w="888" h="57">
                    <a:moveTo>
                      <a:pt x="0" y="57"/>
                    </a:moveTo>
                    <a:lnTo>
                      <a:pt x="0" y="0"/>
                    </a:lnTo>
                    <a:lnTo>
                      <a:pt x="888" y="0"/>
                    </a:lnTo>
                  </a:path>
                </a:pathLst>
              </a:custGeom>
              <a:noFill/>
              <a:ln w="255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3560" bIns="43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8" name=""/>
              <p:cNvSpPr/>
              <p:nvPr/>
            </p:nvSpPr>
            <p:spPr>
              <a:xfrm>
                <a:off x="5699520" y="8659440"/>
                <a:ext cx="1248840" cy="213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1149480"/>
                    <a:tab algn="l" pos="2298600"/>
                    <a:tab algn="l" pos="3448080"/>
                    <a:tab algn="l" pos="4597560"/>
                    <a:tab algn="l" pos="5746680"/>
                    <a:tab algn="l" pos="6896160"/>
                    <a:tab algn="l" pos="8045280"/>
                    <a:tab algn="l" pos="9194760"/>
                    <a:tab algn="l" pos="10344240"/>
                  </a:tabLst>
                </a:pPr>
                <a:r>
                  <a:rPr b="1" lang="en-US" sz="14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1" lang="en-US" sz="1400" spc="-1" strike="noStrike">
                    <a:solidFill>
                      <a:srgbClr val="000000"/>
                    </a:solidFill>
                    <a:latin typeface="Arial"/>
                  </a:rPr>
                  <a:t>BraA.GRF14.e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9" name=""/>
              <p:cNvSpPr/>
              <p:nvPr/>
            </p:nvSpPr>
            <p:spPr>
              <a:xfrm>
                <a:off x="4024440" y="8710200"/>
                <a:ext cx="1409760" cy="88920"/>
              </a:xfrm>
              <a:custGeom>
                <a:avLst/>
                <a:gdLst/>
                <a:ahLst/>
                <a:rect l="l" t="t" r="r" b="b"/>
                <a:pathLst>
                  <a:path w="888" h="56">
                    <a:moveTo>
                      <a:pt x="0" y="0"/>
                    </a:moveTo>
                    <a:lnTo>
                      <a:pt x="0" y="56"/>
                    </a:lnTo>
                    <a:lnTo>
                      <a:pt x="888" y="56"/>
                    </a:lnTo>
                  </a:path>
                </a:pathLst>
              </a:custGeom>
              <a:noFill/>
              <a:ln w="255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2120" bIns="421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0" name=""/>
              <p:cNvSpPr/>
              <p:nvPr/>
            </p:nvSpPr>
            <p:spPr>
              <a:xfrm>
                <a:off x="2538360" y="8505720"/>
                <a:ext cx="1486080" cy="191880"/>
              </a:xfrm>
              <a:custGeom>
                <a:avLst/>
                <a:gdLst/>
                <a:ahLst/>
                <a:rect l="l" t="t" r="r" b="b"/>
                <a:pathLst>
                  <a:path w="936" h="121">
                    <a:moveTo>
                      <a:pt x="0" y="0"/>
                    </a:moveTo>
                    <a:lnTo>
                      <a:pt x="0" y="121"/>
                    </a:lnTo>
                    <a:lnTo>
                      <a:pt x="936" y="121"/>
                    </a:lnTo>
                  </a:path>
                </a:pathLst>
              </a:custGeom>
              <a:noFill/>
              <a:ln w="255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1" name=""/>
              <p:cNvSpPr/>
              <p:nvPr/>
            </p:nvSpPr>
            <p:spPr>
              <a:xfrm>
                <a:off x="2320920" y="8250120"/>
                <a:ext cx="217440" cy="242640"/>
              </a:xfrm>
              <a:custGeom>
                <a:avLst/>
                <a:gdLst/>
                <a:ahLst/>
                <a:rect l="l" t="t" r="r" b="b"/>
                <a:pathLst>
                  <a:path w="137" h="153">
                    <a:moveTo>
                      <a:pt x="0" y="0"/>
                    </a:moveTo>
                    <a:lnTo>
                      <a:pt x="0" y="153"/>
                    </a:lnTo>
                    <a:lnTo>
                      <a:pt x="137" y="153"/>
                    </a:lnTo>
                  </a:path>
                </a:pathLst>
              </a:custGeom>
              <a:noFill/>
              <a:ln w="255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2" name=""/>
              <p:cNvSpPr/>
              <p:nvPr/>
            </p:nvSpPr>
            <p:spPr>
              <a:xfrm>
                <a:off x="2243160" y="7967520"/>
                <a:ext cx="77760" cy="269640"/>
              </a:xfrm>
              <a:custGeom>
                <a:avLst/>
                <a:gdLst/>
                <a:ahLst/>
                <a:rect l="l" t="t" r="r" b="b"/>
                <a:pathLst>
                  <a:path w="49" h="170">
                    <a:moveTo>
                      <a:pt x="0" y="0"/>
                    </a:moveTo>
                    <a:lnTo>
                      <a:pt x="0" y="170"/>
                    </a:lnTo>
                    <a:lnTo>
                      <a:pt x="49" y="170"/>
                    </a:lnTo>
                  </a:path>
                </a:pathLst>
              </a:custGeom>
              <a:noFill/>
              <a:ln w="255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3" name=""/>
              <p:cNvSpPr/>
              <p:nvPr/>
            </p:nvSpPr>
            <p:spPr>
              <a:xfrm>
                <a:off x="2217960" y="7673760"/>
                <a:ext cx="25200" cy="280800"/>
              </a:xfrm>
              <a:custGeom>
                <a:avLst/>
                <a:gdLst/>
                <a:ahLst/>
                <a:rect l="l" t="t" r="r" b="b"/>
                <a:pathLst>
                  <a:path w="16" h="177">
                    <a:moveTo>
                      <a:pt x="0" y="0"/>
                    </a:moveTo>
                    <a:lnTo>
                      <a:pt x="0" y="177"/>
                    </a:lnTo>
                    <a:lnTo>
                      <a:pt x="16" y="177"/>
                    </a:lnTo>
                  </a:path>
                </a:pathLst>
              </a:custGeom>
              <a:noFill/>
              <a:ln w="255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4" name=""/>
              <p:cNvSpPr/>
              <p:nvPr/>
            </p:nvSpPr>
            <p:spPr>
              <a:xfrm>
                <a:off x="2217960" y="7481520"/>
                <a:ext cx="1440" cy="473040"/>
              </a:xfrm>
              <a:prstGeom prst="line">
                <a:avLst/>
              </a:prstGeom>
              <a:ln w="255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5" name=""/>
              <p:cNvSpPr/>
              <p:nvPr/>
            </p:nvSpPr>
            <p:spPr>
              <a:xfrm>
                <a:off x="1487520" y="6919560"/>
                <a:ext cx="730440" cy="549360"/>
              </a:xfrm>
              <a:custGeom>
                <a:avLst/>
                <a:gdLst/>
                <a:ahLst/>
                <a:rect l="l" t="t" r="r" b="b"/>
                <a:pathLst>
                  <a:path w="460" h="346">
                    <a:moveTo>
                      <a:pt x="0" y="0"/>
                    </a:moveTo>
                    <a:lnTo>
                      <a:pt x="0" y="346"/>
                    </a:lnTo>
                    <a:lnTo>
                      <a:pt x="460" y="346"/>
                    </a:lnTo>
                  </a:path>
                </a:pathLst>
              </a:custGeom>
              <a:noFill/>
              <a:ln w="255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6" name=""/>
              <p:cNvSpPr/>
              <p:nvPr/>
            </p:nvSpPr>
            <p:spPr>
              <a:xfrm>
                <a:off x="706680" y="5179680"/>
                <a:ext cx="780840" cy="1727280"/>
              </a:xfrm>
              <a:custGeom>
                <a:avLst/>
                <a:gdLst/>
                <a:ahLst/>
                <a:rect l="l" t="t" r="r" b="b"/>
                <a:pathLst>
                  <a:path w="492" h="1088">
                    <a:moveTo>
                      <a:pt x="0" y="0"/>
                    </a:moveTo>
                    <a:lnTo>
                      <a:pt x="0" y="1088"/>
                    </a:lnTo>
                    <a:lnTo>
                      <a:pt x="492" y="1088"/>
                    </a:lnTo>
                  </a:path>
                </a:pathLst>
              </a:custGeom>
              <a:noFill/>
              <a:ln w="255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7" name=""/>
              <p:cNvSpPr/>
              <p:nvPr/>
            </p:nvSpPr>
            <p:spPr>
              <a:xfrm>
                <a:off x="476280" y="5167080"/>
                <a:ext cx="230400" cy="1905120"/>
              </a:xfrm>
              <a:custGeom>
                <a:avLst/>
                <a:gdLst/>
                <a:ahLst/>
                <a:rect l="l" t="t" r="r" b="b"/>
                <a:pathLst>
                  <a:path w="145" h="1200">
                    <a:moveTo>
                      <a:pt x="0" y="1200"/>
                    </a:moveTo>
                    <a:lnTo>
                      <a:pt x="0" y="0"/>
                    </a:lnTo>
                    <a:lnTo>
                      <a:pt x="145" y="0"/>
                    </a:lnTo>
                  </a:path>
                </a:pathLst>
              </a:custGeom>
              <a:noFill/>
              <a:ln w="255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8" name=""/>
              <p:cNvSpPr/>
              <p:nvPr/>
            </p:nvSpPr>
            <p:spPr>
              <a:xfrm>
                <a:off x="5444280" y="8864280"/>
                <a:ext cx="802440" cy="213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1149480"/>
                    <a:tab algn="l" pos="2298600"/>
                    <a:tab algn="l" pos="3448080"/>
                    <a:tab algn="l" pos="4597560"/>
                    <a:tab algn="l" pos="5746680"/>
                    <a:tab algn="l" pos="6896160"/>
                    <a:tab algn="l" pos="8045280"/>
                    <a:tab algn="l" pos="9194760"/>
                    <a:tab algn="l" pos="10344240"/>
                  </a:tabLst>
                </a:pPr>
                <a:r>
                  <a:rPr b="1" lang="en-US" sz="14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1" lang="en-US" sz="1400" spc="-1" strike="noStrike">
                    <a:solidFill>
                      <a:srgbClr val="000000"/>
                    </a:solidFill>
                    <a:latin typeface="Arial"/>
                  </a:rPr>
                  <a:t>Hs_theta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9" name=""/>
              <p:cNvSpPr/>
              <p:nvPr/>
            </p:nvSpPr>
            <p:spPr>
              <a:xfrm>
                <a:off x="476280" y="7097400"/>
                <a:ext cx="4957920" cy="1906560"/>
              </a:xfrm>
              <a:custGeom>
                <a:avLst/>
                <a:gdLst/>
                <a:ahLst/>
                <a:rect l="l" t="t" r="r" b="b"/>
                <a:pathLst>
                  <a:path w="3123" h="1201">
                    <a:moveTo>
                      <a:pt x="0" y="0"/>
                    </a:moveTo>
                    <a:lnTo>
                      <a:pt x="0" y="1201"/>
                    </a:lnTo>
                    <a:lnTo>
                      <a:pt x="3123" y="1201"/>
                    </a:lnTo>
                  </a:path>
                </a:pathLst>
              </a:custGeom>
              <a:noFill/>
              <a:ln w="255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0" name=""/>
              <p:cNvSpPr/>
              <p:nvPr/>
            </p:nvSpPr>
            <p:spPr>
              <a:xfrm>
                <a:off x="5510160" y="293400"/>
                <a:ext cx="179640" cy="177840"/>
              </a:xfrm>
              <a:prstGeom prst="ellipse">
                <a:avLst/>
              </a:prstGeom>
              <a:solidFill>
                <a:srgbClr val="000000"/>
              </a:solidFill>
              <a:ln w="381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1" name=""/>
              <p:cNvSpPr/>
              <p:nvPr/>
            </p:nvSpPr>
            <p:spPr>
              <a:xfrm>
                <a:off x="5510160" y="498240"/>
                <a:ext cx="179640" cy="177840"/>
              </a:xfrm>
              <a:prstGeom prst="ellipse">
                <a:avLst/>
              </a:prstGeom>
              <a:solidFill>
                <a:srgbClr val="000000"/>
              </a:solidFill>
              <a:ln w="381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2" name=""/>
              <p:cNvSpPr/>
              <p:nvPr/>
            </p:nvSpPr>
            <p:spPr>
              <a:xfrm>
                <a:off x="5510160" y="701280"/>
                <a:ext cx="179640" cy="179640"/>
              </a:xfrm>
              <a:prstGeom prst="ellipse">
                <a:avLst/>
              </a:prstGeom>
              <a:solidFill>
                <a:srgbClr val="ffffff"/>
              </a:solidFill>
              <a:ln w="381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3" name=""/>
              <p:cNvSpPr/>
              <p:nvPr/>
            </p:nvSpPr>
            <p:spPr>
              <a:xfrm>
                <a:off x="5510160" y="906120"/>
                <a:ext cx="179640" cy="179640"/>
              </a:xfrm>
              <a:prstGeom prst="ellipse">
                <a:avLst/>
              </a:prstGeom>
              <a:solidFill>
                <a:srgbClr val="ffffff"/>
              </a:solidFill>
              <a:ln w="381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4" name=""/>
              <p:cNvSpPr/>
              <p:nvPr/>
            </p:nvSpPr>
            <p:spPr>
              <a:xfrm>
                <a:off x="5510160" y="1110960"/>
                <a:ext cx="179640" cy="179280"/>
              </a:xfrm>
              <a:prstGeom prst="ellipse">
                <a:avLst/>
              </a:prstGeom>
              <a:solidFill>
                <a:srgbClr val="ffffff"/>
              </a:solidFill>
              <a:ln w="381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5" name=""/>
              <p:cNvSpPr/>
              <p:nvPr/>
            </p:nvSpPr>
            <p:spPr>
              <a:xfrm>
                <a:off x="5510160" y="1315800"/>
                <a:ext cx="179640" cy="179280"/>
              </a:xfrm>
              <a:prstGeom prst="ellipse">
                <a:avLst/>
              </a:prstGeom>
              <a:solidFill>
                <a:srgbClr val="000000"/>
              </a:solidFill>
              <a:ln w="381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6" name=""/>
              <p:cNvSpPr/>
              <p:nvPr/>
            </p:nvSpPr>
            <p:spPr>
              <a:xfrm>
                <a:off x="5510160" y="1520640"/>
                <a:ext cx="179640" cy="179280"/>
              </a:xfrm>
              <a:prstGeom prst="ellipse">
                <a:avLst/>
              </a:prstGeom>
              <a:solidFill>
                <a:srgbClr val="000000"/>
              </a:solidFill>
              <a:ln w="381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7" name=""/>
              <p:cNvSpPr/>
              <p:nvPr/>
            </p:nvSpPr>
            <p:spPr>
              <a:xfrm>
                <a:off x="5510160" y="1725480"/>
                <a:ext cx="179640" cy="179280"/>
              </a:xfrm>
              <a:prstGeom prst="ellipse">
                <a:avLst/>
              </a:prstGeom>
              <a:solidFill>
                <a:srgbClr val="000000"/>
              </a:solidFill>
              <a:ln w="381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8" name=""/>
              <p:cNvSpPr/>
              <p:nvPr/>
            </p:nvSpPr>
            <p:spPr>
              <a:xfrm>
                <a:off x="5510160" y="1930320"/>
                <a:ext cx="179640" cy="179280"/>
              </a:xfrm>
              <a:prstGeom prst="ellipse">
                <a:avLst/>
              </a:prstGeom>
              <a:solidFill>
                <a:srgbClr val="000000"/>
              </a:solidFill>
              <a:ln w="381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9" name=""/>
              <p:cNvSpPr/>
              <p:nvPr/>
            </p:nvSpPr>
            <p:spPr>
              <a:xfrm>
                <a:off x="5510160" y="2134800"/>
                <a:ext cx="179640" cy="179640"/>
              </a:xfrm>
              <a:prstGeom prst="ellipse">
                <a:avLst/>
              </a:prstGeom>
              <a:solidFill>
                <a:srgbClr val="000000"/>
              </a:solidFill>
              <a:ln w="381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0" name=""/>
              <p:cNvSpPr/>
              <p:nvPr/>
            </p:nvSpPr>
            <p:spPr>
              <a:xfrm>
                <a:off x="5510160" y="2339640"/>
                <a:ext cx="179640" cy="179640"/>
              </a:xfrm>
              <a:custGeom>
                <a:avLst/>
                <a:gdLst/>
                <a:ahLst/>
                <a:rect l="l" t="t" r="r" b="b"/>
                <a:pathLst>
                  <a:path w="113" h="113">
                    <a:moveTo>
                      <a:pt x="57" y="0"/>
                    </a:moveTo>
                    <a:lnTo>
                      <a:pt x="0" y="56"/>
                    </a:lnTo>
                    <a:lnTo>
                      <a:pt x="57" y="113"/>
                    </a:lnTo>
                    <a:lnTo>
                      <a:pt x="113" y="56"/>
                    </a:lnTo>
                    <a:lnTo>
                      <a:pt x="57" y="0"/>
                    </a:lnTo>
                    <a:close/>
                  </a:path>
                </a:pathLst>
              </a:custGeom>
              <a:solidFill>
                <a:srgbClr val="ffffff"/>
              </a:solidFill>
              <a:ln w="381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1" name=""/>
              <p:cNvSpPr/>
              <p:nvPr/>
            </p:nvSpPr>
            <p:spPr>
              <a:xfrm>
                <a:off x="5510160" y="2544480"/>
                <a:ext cx="179640" cy="179280"/>
              </a:xfrm>
              <a:prstGeom prst="ellipse">
                <a:avLst/>
              </a:prstGeom>
              <a:solidFill>
                <a:srgbClr val="000000"/>
              </a:solidFill>
              <a:ln w="381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2" name=""/>
              <p:cNvSpPr/>
              <p:nvPr/>
            </p:nvSpPr>
            <p:spPr>
              <a:xfrm>
                <a:off x="5510160" y="2749320"/>
                <a:ext cx="179640" cy="179280"/>
              </a:xfrm>
              <a:prstGeom prst="ellipse">
                <a:avLst/>
              </a:prstGeom>
              <a:solidFill>
                <a:srgbClr val="000000"/>
              </a:solidFill>
              <a:ln w="381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3" name=""/>
              <p:cNvSpPr/>
              <p:nvPr/>
            </p:nvSpPr>
            <p:spPr>
              <a:xfrm>
                <a:off x="5510160" y="2954160"/>
                <a:ext cx="179640" cy="177840"/>
              </a:xfrm>
              <a:prstGeom prst="ellipse">
                <a:avLst/>
              </a:prstGeom>
              <a:solidFill>
                <a:srgbClr val="ffffff"/>
              </a:solidFill>
              <a:ln w="381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4" name=""/>
              <p:cNvSpPr/>
              <p:nvPr/>
            </p:nvSpPr>
            <p:spPr>
              <a:xfrm>
                <a:off x="5510160" y="3159000"/>
                <a:ext cx="179640" cy="177840"/>
              </a:xfrm>
              <a:prstGeom prst="ellipse">
                <a:avLst/>
              </a:prstGeom>
              <a:solidFill>
                <a:srgbClr val="ffffff"/>
              </a:solidFill>
              <a:ln w="381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5" name=""/>
              <p:cNvSpPr/>
              <p:nvPr/>
            </p:nvSpPr>
            <p:spPr>
              <a:xfrm>
                <a:off x="5510160" y="3363840"/>
                <a:ext cx="179640" cy="177480"/>
              </a:xfrm>
              <a:prstGeom prst="ellipse">
                <a:avLst/>
              </a:prstGeom>
              <a:solidFill>
                <a:srgbClr val="000000"/>
              </a:solidFill>
              <a:ln w="381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6" name=""/>
              <p:cNvSpPr/>
              <p:nvPr/>
            </p:nvSpPr>
            <p:spPr>
              <a:xfrm>
                <a:off x="5510160" y="3566880"/>
                <a:ext cx="179640" cy="179280"/>
              </a:xfrm>
              <a:prstGeom prst="ellipse">
                <a:avLst/>
              </a:prstGeom>
              <a:solidFill>
                <a:srgbClr val="000000"/>
              </a:solidFill>
              <a:ln w="381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7" name=""/>
              <p:cNvSpPr/>
              <p:nvPr/>
            </p:nvSpPr>
            <p:spPr>
              <a:xfrm>
                <a:off x="5510160" y="3771720"/>
                <a:ext cx="179640" cy="179280"/>
              </a:xfrm>
              <a:custGeom>
                <a:avLst/>
                <a:gdLst/>
                <a:ahLst/>
                <a:rect l="l" t="t" r="r" b="b"/>
                <a:pathLst>
                  <a:path w="113" h="113">
                    <a:moveTo>
                      <a:pt x="57" y="0"/>
                    </a:moveTo>
                    <a:lnTo>
                      <a:pt x="0" y="57"/>
                    </a:lnTo>
                    <a:lnTo>
                      <a:pt x="57" y="113"/>
                    </a:lnTo>
                    <a:lnTo>
                      <a:pt x="113" y="57"/>
                    </a:lnTo>
                    <a:lnTo>
                      <a:pt x="57" y="0"/>
                    </a:lnTo>
                    <a:close/>
                  </a:path>
                </a:pathLst>
              </a:custGeom>
              <a:solidFill>
                <a:srgbClr val="ffffff"/>
              </a:solidFill>
              <a:ln w="381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8" name=""/>
              <p:cNvSpPr/>
              <p:nvPr/>
            </p:nvSpPr>
            <p:spPr>
              <a:xfrm>
                <a:off x="5510160" y="3976560"/>
                <a:ext cx="179640" cy="179280"/>
              </a:xfrm>
              <a:custGeom>
                <a:avLst/>
                <a:gdLst/>
                <a:ahLst/>
                <a:rect l="l" t="t" r="r" b="b"/>
                <a:pathLst>
                  <a:path w="113" h="113">
                    <a:moveTo>
                      <a:pt x="57" y="0"/>
                    </a:moveTo>
                    <a:lnTo>
                      <a:pt x="0" y="57"/>
                    </a:lnTo>
                    <a:lnTo>
                      <a:pt x="57" y="113"/>
                    </a:lnTo>
                    <a:lnTo>
                      <a:pt x="113" y="57"/>
                    </a:lnTo>
                    <a:lnTo>
                      <a:pt x="57" y="0"/>
                    </a:lnTo>
                    <a:close/>
                  </a:path>
                </a:pathLst>
              </a:custGeom>
              <a:solidFill>
                <a:srgbClr val="ffffff"/>
              </a:solidFill>
              <a:ln w="381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9" name=""/>
              <p:cNvSpPr/>
              <p:nvPr/>
            </p:nvSpPr>
            <p:spPr>
              <a:xfrm>
                <a:off x="5510160" y="4181400"/>
                <a:ext cx="179640" cy="179280"/>
              </a:xfrm>
              <a:custGeom>
                <a:avLst/>
                <a:gdLst/>
                <a:ahLst/>
                <a:rect l="l" t="t" r="r" b="b"/>
                <a:pathLst>
                  <a:path w="113" h="113">
                    <a:moveTo>
                      <a:pt x="57" y="0"/>
                    </a:moveTo>
                    <a:lnTo>
                      <a:pt x="0" y="57"/>
                    </a:lnTo>
                    <a:lnTo>
                      <a:pt x="57" y="113"/>
                    </a:lnTo>
                    <a:lnTo>
                      <a:pt x="113" y="57"/>
                    </a:lnTo>
                    <a:lnTo>
                      <a:pt x="57" y="0"/>
                    </a:lnTo>
                    <a:close/>
                  </a:path>
                </a:pathLst>
              </a:custGeom>
              <a:solidFill>
                <a:srgbClr val="ffffff"/>
              </a:solidFill>
              <a:ln w="381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0" name=""/>
              <p:cNvSpPr/>
              <p:nvPr/>
            </p:nvSpPr>
            <p:spPr>
              <a:xfrm>
                <a:off x="5510160" y="4385880"/>
                <a:ext cx="179640" cy="179640"/>
              </a:xfrm>
              <a:custGeom>
                <a:avLst/>
                <a:gdLst/>
                <a:ahLst/>
                <a:rect l="l" t="t" r="r" b="b"/>
                <a:pathLst>
                  <a:path w="113" h="113">
                    <a:moveTo>
                      <a:pt x="57" y="0"/>
                    </a:moveTo>
                    <a:lnTo>
                      <a:pt x="0" y="57"/>
                    </a:lnTo>
                    <a:lnTo>
                      <a:pt x="57" y="113"/>
                    </a:lnTo>
                    <a:lnTo>
                      <a:pt x="113" y="57"/>
                    </a:lnTo>
                    <a:lnTo>
                      <a:pt x="57" y="0"/>
                    </a:lnTo>
                    <a:close/>
                  </a:path>
                </a:pathLst>
              </a:custGeom>
              <a:solidFill>
                <a:srgbClr val="ffffff"/>
              </a:solidFill>
              <a:ln w="381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1" name=""/>
              <p:cNvSpPr/>
              <p:nvPr/>
            </p:nvSpPr>
            <p:spPr>
              <a:xfrm>
                <a:off x="5510160" y="4590720"/>
                <a:ext cx="179640" cy="179640"/>
              </a:xfrm>
              <a:custGeom>
                <a:avLst/>
                <a:gdLst/>
                <a:ahLst/>
                <a:rect l="l" t="t" r="r" b="b"/>
                <a:pathLst>
                  <a:path w="113" h="113">
                    <a:moveTo>
                      <a:pt x="57" y="0"/>
                    </a:moveTo>
                    <a:lnTo>
                      <a:pt x="0" y="56"/>
                    </a:lnTo>
                    <a:lnTo>
                      <a:pt x="57" y="113"/>
                    </a:lnTo>
                    <a:lnTo>
                      <a:pt x="113" y="56"/>
                    </a:lnTo>
                    <a:lnTo>
                      <a:pt x="57" y="0"/>
                    </a:lnTo>
                    <a:close/>
                  </a:path>
                </a:pathLst>
              </a:custGeom>
              <a:solidFill>
                <a:srgbClr val="ffffff"/>
              </a:solidFill>
              <a:ln w="381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2" name=""/>
              <p:cNvSpPr/>
              <p:nvPr/>
            </p:nvSpPr>
            <p:spPr>
              <a:xfrm>
                <a:off x="5510160" y="4795560"/>
                <a:ext cx="179640" cy="179280"/>
              </a:xfrm>
              <a:prstGeom prst="ellipse">
                <a:avLst/>
              </a:prstGeom>
              <a:solidFill>
                <a:srgbClr val="000000"/>
              </a:solidFill>
              <a:ln w="381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3" name=""/>
              <p:cNvSpPr/>
              <p:nvPr/>
            </p:nvSpPr>
            <p:spPr>
              <a:xfrm>
                <a:off x="5510160" y="5000400"/>
                <a:ext cx="179640" cy="179280"/>
              </a:xfrm>
              <a:prstGeom prst="ellipse">
                <a:avLst/>
              </a:prstGeom>
              <a:solidFill>
                <a:srgbClr val="000000"/>
              </a:solidFill>
              <a:ln w="381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4" name=""/>
              <p:cNvSpPr/>
              <p:nvPr/>
            </p:nvSpPr>
            <p:spPr>
              <a:xfrm>
                <a:off x="5510160" y="5205240"/>
                <a:ext cx="179640" cy="179280"/>
              </a:xfrm>
              <a:prstGeom prst="ellipse">
                <a:avLst/>
              </a:prstGeom>
              <a:solidFill>
                <a:srgbClr val="ffffff"/>
              </a:solidFill>
              <a:ln w="381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5" name=""/>
              <p:cNvSpPr/>
              <p:nvPr/>
            </p:nvSpPr>
            <p:spPr>
              <a:xfrm>
                <a:off x="5510160" y="5410080"/>
                <a:ext cx="179640" cy="179280"/>
              </a:xfrm>
              <a:prstGeom prst="ellipse">
                <a:avLst/>
              </a:prstGeom>
              <a:solidFill>
                <a:srgbClr val="000000"/>
              </a:solidFill>
              <a:ln w="381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6" name=""/>
              <p:cNvSpPr/>
              <p:nvPr/>
            </p:nvSpPr>
            <p:spPr>
              <a:xfrm>
                <a:off x="5510160" y="5614920"/>
                <a:ext cx="179640" cy="179280"/>
              </a:xfrm>
              <a:prstGeom prst="ellipse">
                <a:avLst/>
              </a:prstGeom>
              <a:solidFill>
                <a:srgbClr val="000000"/>
              </a:solidFill>
              <a:ln w="381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7" name=""/>
              <p:cNvSpPr/>
              <p:nvPr/>
            </p:nvSpPr>
            <p:spPr>
              <a:xfrm>
                <a:off x="5510160" y="5819400"/>
                <a:ext cx="179640" cy="177840"/>
              </a:xfrm>
              <a:prstGeom prst="ellipse">
                <a:avLst/>
              </a:prstGeom>
              <a:solidFill>
                <a:srgbClr val="ffffff"/>
              </a:solidFill>
              <a:ln w="381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8" name=""/>
              <p:cNvSpPr/>
              <p:nvPr/>
            </p:nvSpPr>
            <p:spPr>
              <a:xfrm>
                <a:off x="5510160" y="6024240"/>
                <a:ext cx="179640" cy="177840"/>
              </a:xfrm>
              <a:prstGeom prst="ellipse">
                <a:avLst/>
              </a:prstGeom>
              <a:solidFill>
                <a:srgbClr val="ffffff"/>
              </a:solidFill>
              <a:ln w="381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9" name=""/>
              <p:cNvSpPr/>
              <p:nvPr/>
            </p:nvSpPr>
            <p:spPr>
              <a:xfrm>
                <a:off x="5510160" y="6227640"/>
                <a:ext cx="179640" cy="179280"/>
              </a:xfrm>
              <a:custGeom>
                <a:avLst/>
                <a:gdLst/>
                <a:ahLst/>
                <a:rect l="l" t="t" r="r" b="b"/>
                <a:pathLst>
                  <a:path w="113" h="113">
                    <a:moveTo>
                      <a:pt x="57" y="0"/>
                    </a:moveTo>
                    <a:lnTo>
                      <a:pt x="0" y="57"/>
                    </a:lnTo>
                    <a:lnTo>
                      <a:pt x="57" y="113"/>
                    </a:lnTo>
                    <a:lnTo>
                      <a:pt x="113" y="57"/>
                    </a:lnTo>
                    <a:lnTo>
                      <a:pt x="57" y="0"/>
                    </a:lnTo>
                    <a:close/>
                  </a:path>
                </a:pathLst>
              </a:custGeom>
              <a:solidFill>
                <a:srgbClr val="ffffff"/>
              </a:solidFill>
              <a:ln w="381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0" name=""/>
              <p:cNvSpPr/>
              <p:nvPr/>
            </p:nvSpPr>
            <p:spPr>
              <a:xfrm>
                <a:off x="5510160" y="6432480"/>
                <a:ext cx="179640" cy="179280"/>
              </a:xfrm>
              <a:prstGeom prst="ellipse">
                <a:avLst/>
              </a:prstGeom>
              <a:solidFill>
                <a:srgbClr val="000000"/>
              </a:solidFill>
              <a:ln w="381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1" name=""/>
              <p:cNvSpPr/>
              <p:nvPr/>
            </p:nvSpPr>
            <p:spPr>
              <a:xfrm>
                <a:off x="5510160" y="6636960"/>
                <a:ext cx="179640" cy="179640"/>
              </a:xfrm>
              <a:prstGeom prst="ellipse">
                <a:avLst/>
              </a:prstGeom>
              <a:solidFill>
                <a:srgbClr val="000000"/>
              </a:solidFill>
              <a:ln w="381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2" name=""/>
              <p:cNvSpPr/>
              <p:nvPr/>
            </p:nvSpPr>
            <p:spPr>
              <a:xfrm>
                <a:off x="5510160" y="6841800"/>
                <a:ext cx="179640" cy="179640"/>
              </a:xfrm>
              <a:prstGeom prst="ellipse">
                <a:avLst/>
              </a:prstGeom>
              <a:solidFill>
                <a:srgbClr val="000000"/>
              </a:solidFill>
              <a:ln w="381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3" name=""/>
              <p:cNvSpPr/>
              <p:nvPr/>
            </p:nvSpPr>
            <p:spPr>
              <a:xfrm>
                <a:off x="5510160" y="7046640"/>
                <a:ext cx="179640" cy="179280"/>
              </a:xfrm>
              <a:prstGeom prst="ellipse">
                <a:avLst/>
              </a:prstGeom>
              <a:solidFill>
                <a:srgbClr val="ffffff"/>
              </a:solidFill>
              <a:ln w="381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4" name=""/>
              <p:cNvSpPr/>
              <p:nvPr/>
            </p:nvSpPr>
            <p:spPr>
              <a:xfrm>
                <a:off x="5510160" y="7251480"/>
                <a:ext cx="179640" cy="179280"/>
              </a:xfrm>
              <a:prstGeom prst="ellipse">
                <a:avLst/>
              </a:prstGeom>
              <a:solidFill>
                <a:srgbClr val="ffffff"/>
              </a:solidFill>
              <a:ln w="381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5" name=""/>
              <p:cNvSpPr/>
              <p:nvPr/>
            </p:nvSpPr>
            <p:spPr>
              <a:xfrm>
                <a:off x="5510160" y="7456320"/>
                <a:ext cx="179640" cy="179280"/>
              </a:xfrm>
              <a:prstGeom prst="ellipse">
                <a:avLst/>
              </a:prstGeom>
              <a:solidFill>
                <a:srgbClr val="ffffff"/>
              </a:solidFill>
              <a:ln w="381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6" name=""/>
              <p:cNvSpPr/>
              <p:nvPr/>
            </p:nvSpPr>
            <p:spPr>
              <a:xfrm>
                <a:off x="5510160" y="7661160"/>
                <a:ext cx="179640" cy="179280"/>
              </a:xfrm>
              <a:prstGeom prst="ellipse">
                <a:avLst/>
              </a:prstGeom>
              <a:solidFill>
                <a:srgbClr val="000000"/>
              </a:solidFill>
              <a:ln w="381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7" name=""/>
              <p:cNvSpPr/>
              <p:nvPr/>
            </p:nvSpPr>
            <p:spPr>
              <a:xfrm>
                <a:off x="5510160" y="7866000"/>
                <a:ext cx="179640" cy="179280"/>
              </a:xfrm>
              <a:custGeom>
                <a:avLst/>
                <a:gdLst/>
                <a:ahLst/>
                <a:rect l="l" t="t" r="r" b="b"/>
                <a:pathLst>
                  <a:path w="113" h="113">
                    <a:moveTo>
                      <a:pt x="57" y="0"/>
                    </a:moveTo>
                    <a:lnTo>
                      <a:pt x="0" y="56"/>
                    </a:lnTo>
                    <a:lnTo>
                      <a:pt x="57" y="113"/>
                    </a:lnTo>
                    <a:lnTo>
                      <a:pt x="113" y="56"/>
                    </a:lnTo>
                    <a:lnTo>
                      <a:pt x="57" y="0"/>
                    </a:lnTo>
                    <a:close/>
                  </a:path>
                </a:pathLst>
              </a:custGeom>
              <a:solidFill>
                <a:srgbClr val="ffffff"/>
              </a:solidFill>
              <a:ln w="381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8" name=""/>
              <p:cNvSpPr/>
              <p:nvPr/>
            </p:nvSpPr>
            <p:spPr>
              <a:xfrm>
                <a:off x="5510160" y="8070480"/>
                <a:ext cx="179640" cy="179640"/>
              </a:xfrm>
              <a:prstGeom prst="ellipse">
                <a:avLst/>
              </a:prstGeom>
              <a:solidFill>
                <a:srgbClr val="ffffff"/>
              </a:solidFill>
              <a:ln w="381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9" name=""/>
              <p:cNvSpPr/>
              <p:nvPr/>
            </p:nvSpPr>
            <p:spPr>
              <a:xfrm>
                <a:off x="5510160" y="8275320"/>
                <a:ext cx="179640" cy="179640"/>
              </a:xfrm>
              <a:prstGeom prst="ellipse">
                <a:avLst/>
              </a:prstGeom>
              <a:solidFill>
                <a:srgbClr val="000000"/>
              </a:solidFill>
              <a:ln w="381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0" name=""/>
              <p:cNvSpPr/>
              <p:nvPr/>
            </p:nvSpPr>
            <p:spPr>
              <a:xfrm>
                <a:off x="5510160" y="8480160"/>
                <a:ext cx="179640" cy="177840"/>
              </a:xfrm>
              <a:prstGeom prst="ellipse">
                <a:avLst/>
              </a:prstGeom>
              <a:solidFill>
                <a:srgbClr val="ffffff"/>
              </a:solidFill>
              <a:ln w="381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1" name=""/>
              <p:cNvSpPr/>
              <p:nvPr/>
            </p:nvSpPr>
            <p:spPr>
              <a:xfrm>
                <a:off x="5510160" y="8685000"/>
                <a:ext cx="179640" cy="177840"/>
              </a:xfrm>
              <a:prstGeom prst="ellipse">
                <a:avLst/>
              </a:prstGeom>
              <a:solidFill>
                <a:srgbClr val="000000"/>
              </a:solidFill>
              <a:ln w="381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2" name=""/>
              <p:cNvSpPr/>
              <p:nvPr/>
            </p:nvSpPr>
            <p:spPr>
              <a:xfrm>
                <a:off x="4506120" y="7430760"/>
                <a:ext cx="307080" cy="213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1149480"/>
                    <a:tab algn="l" pos="2298600"/>
                    <a:tab algn="l" pos="3448080"/>
                    <a:tab algn="l" pos="4597560"/>
                    <a:tab algn="l" pos="5746680"/>
                    <a:tab algn="l" pos="6896160"/>
                    <a:tab algn="l" pos="8045280"/>
                    <a:tab algn="l" pos="9194760"/>
                    <a:tab algn="l" pos="10344240"/>
                  </a:tabLst>
                </a:pPr>
                <a:r>
                  <a:rPr b="1" lang="en-US" sz="1400" spc="-1" strike="noStrike">
                    <a:solidFill>
                      <a:srgbClr val="000000"/>
                    </a:solidFill>
                    <a:latin typeface="MS Sans Serif"/>
                    <a:ea typeface="MS Sans Serif"/>
                  </a:rPr>
                  <a:t>100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3" name=""/>
              <p:cNvSpPr/>
              <p:nvPr/>
            </p:nvSpPr>
            <p:spPr>
              <a:xfrm>
                <a:off x="3647160" y="8735760"/>
                <a:ext cx="307080" cy="213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1149480"/>
                    <a:tab algn="l" pos="2298600"/>
                    <a:tab algn="l" pos="3448080"/>
                    <a:tab algn="l" pos="4597560"/>
                    <a:tab algn="l" pos="5746680"/>
                    <a:tab algn="l" pos="6896160"/>
                    <a:tab algn="l" pos="8045280"/>
                    <a:tab algn="l" pos="9194760"/>
                    <a:tab algn="l" pos="10344240"/>
                  </a:tabLst>
                </a:pPr>
                <a:r>
                  <a:rPr b="1" lang="en-US" sz="1400" spc="-1" strike="noStrike">
                    <a:solidFill>
                      <a:srgbClr val="000000"/>
                    </a:solidFill>
                    <a:latin typeface="MS Sans Serif"/>
                    <a:ea typeface="MS Sans Serif"/>
                  </a:rPr>
                  <a:t>100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4" name=""/>
              <p:cNvSpPr/>
              <p:nvPr/>
            </p:nvSpPr>
            <p:spPr>
              <a:xfrm>
                <a:off x="5096880" y="3619440"/>
                <a:ext cx="204840" cy="213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1149480"/>
                    <a:tab algn="l" pos="2298600"/>
                    <a:tab algn="l" pos="3448080"/>
                    <a:tab algn="l" pos="4597560"/>
                    <a:tab algn="l" pos="5746680"/>
                    <a:tab algn="l" pos="6896160"/>
                    <a:tab algn="l" pos="8045280"/>
                    <a:tab algn="l" pos="9194760"/>
                    <a:tab algn="l" pos="10344240"/>
                  </a:tabLst>
                </a:pPr>
                <a:r>
                  <a:rPr b="1" lang="en-US" sz="1400" spc="-1" strike="noStrike">
                    <a:solidFill>
                      <a:srgbClr val="000000"/>
                    </a:solidFill>
                    <a:latin typeface="MS Sans Serif"/>
                    <a:ea typeface="MS Sans Serif"/>
                  </a:rPr>
                  <a:t>84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5" name=""/>
              <p:cNvSpPr/>
              <p:nvPr/>
            </p:nvSpPr>
            <p:spPr>
              <a:xfrm>
                <a:off x="4980960" y="3465360"/>
                <a:ext cx="204840" cy="213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1149480"/>
                    <a:tab algn="l" pos="2298600"/>
                    <a:tab algn="l" pos="3448080"/>
                    <a:tab algn="l" pos="4597560"/>
                    <a:tab algn="l" pos="5746680"/>
                    <a:tab algn="l" pos="6896160"/>
                    <a:tab algn="l" pos="8045280"/>
                    <a:tab algn="l" pos="9194760"/>
                    <a:tab algn="l" pos="10344240"/>
                  </a:tabLst>
                </a:pPr>
                <a:r>
                  <a:rPr b="1" lang="en-US" sz="1400" spc="-1" strike="noStrike">
                    <a:solidFill>
                      <a:srgbClr val="000000"/>
                    </a:solidFill>
                    <a:latin typeface="MS Sans Serif"/>
                    <a:ea typeface="MS Sans Serif"/>
                  </a:rPr>
                  <a:t>87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6" name=""/>
              <p:cNvSpPr/>
              <p:nvPr/>
            </p:nvSpPr>
            <p:spPr>
              <a:xfrm>
                <a:off x="4725360" y="3285720"/>
                <a:ext cx="204840" cy="213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1149480"/>
                    <a:tab algn="l" pos="2298600"/>
                    <a:tab algn="l" pos="3448080"/>
                    <a:tab algn="l" pos="4597560"/>
                    <a:tab algn="l" pos="5746680"/>
                    <a:tab algn="l" pos="6896160"/>
                    <a:tab algn="l" pos="8045280"/>
                    <a:tab algn="l" pos="9194760"/>
                    <a:tab algn="l" pos="10344240"/>
                  </a:tabLst>
                </a:pPr>
                <a:r>
                  <a:rPr b="1" lang="en-US" sz="1400" spc="-1" strike="noStrike">
                    <a:solidFill>
                      <a:srgbClr val="000000"/>
                    </a:solidFill>
                    <a:latin typeface="MS Sans Serif"/>
                    <a:ea typeface="MS Sans Serif"/>
                  </a:rPr>
                  <a:t>61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7" name=""/>
              <p:cNvSpPr/>
              <p:nvPr/>
            </p:nvSpPr>
            <p:spPr>
              <a:xfrm>
                <a:off x="4609440" y="3093840"/>
                <a:ext cx="204840" cy="213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1149480"/>
                    <a:tab algn="l" pos="2298600"/>
                    <a:tab algn="l" pos="3448080"/>
                    <a:tab algn="l" pos="4597560"/>
                    <a:tab algn="l" pos="5746680"/>
                    <a:tab algn="l" pos="6896160"/>
                    <a:tab algn="l" pos="8045280"/>
                    <a:tab algn="l" pos="9194760"/>
                    <a:tab algn="l" pos="10344240"/>
                  </a:tabLst>
                </a:pPr>
                <a:r>
                  <a:rPr b="1" lang="en-US" sz="1400" spc="-1" strike="noStrike">
                    <a:solidFill>
                      <a:srgbClr val="000000"/>
                    </a:solidFill>
                    <a:latin typeface="MS Sans Serif"/>
                    <a:ea typeface="MS Sans Serif"/>
                  </a:rPr>
                  <a:t>56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8" name=""/>
              <p:cNvSpPr/>
              <p:nvPr/>
            </p:nvSpPr>
            <p:spPr>
              <a:xfrm>
                <a:off x="4494960" y="2901600"/>
                <a:ext cx="204840" cy="213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1149480"/>
                    <a:tab algn="l" pos="2298600"/>
                    <a:tab algn="l" pos="3448080"/>
                    <a:tab algn="l" pos="4597560"/>
                    <a:tab algn="l" pos="5746680"/>
                    <a:tab algn="l" pos="6896160"/>
                    <a:tab algn="l" pos="8045280"/>
                    <a:tab algn="l" pos="9194760"/>
                    <a:tab algn="l" pos="10344240"/>
                  </a:tabLst>
                </a:pPr>
                <a:r>
                  <a:rPr b="1" lang="en-US" sz="1400" spc="-1" strike="noStrike">
                    <a:solidFill>
                      <a:srgbClr val="000000"/>
                    </a:solidFill>
                    <a:latin typeface="MS Sans Serif"/>
                    <a:ea typeface="MS Sans Serif"/>
                  </a:rPr>
                  <a:t>99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9" name=""/>
              <p:cNvSpPr/>
              <p:nvPr/>
            </p:nvSpPr>
            <p:spPr>
              <a:xfrm>
                <a:off x="4737960" y="2185920"/>
                <a:ext cx="204840" cy="213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1149480"/>
                    <a:tab algn="l" pos="2298600"/>
                    <a:tab algn="l" pos="3448080"/>
                    <a:tab algn="l" pos="4597560"/>
                    <a:tab algn="l" pos="5746680"/>
                    <a:tab algn="l" pos="6896160"/>
                    <a:tab algn="l" pos="8045280"/>
                    <a:tab algn="l" pos="9194760"/>
                    <a:tab algn="l" pos="10344240"/>
                  </a:tabLst>
                </a:pPr>
                <a:r>
                  <a:rPr b="1" lang="en-US" sz="1400" spc="-1" strike="noStrike">
                    <a:solidFill>
                      <a:srgbClr val="000000"/>
                    </a:solidFill>
                    <a:latin typeface="MS Sans Serif"/>
                    <a:ea typeface="MS Sans Serif"/>
                  </a:rPr>
                  <a:t>99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0" name=""/>
              <p:cNvSpPr/>
              <p:nvPr/>
            </p:nvSpPr>
            <p:spPr>
              <a:xfrm>
                <a:off x="5083920" y="6406920"/>
                <a:ext cx="204840" cy="213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1149480"/>
                    <a:tab algn="l" pos="2298600"/>
                    <a:tab algn="l" pos="3448080"/>
                    <a:tab algn="l" pos="4597560"/>
                    <a:tab algn="l" pos="5746680"/>
                    <a:tab algn="l" pos="6896160"/>
                    <a:tab algn="l" pos="8045280"/>
                    <a:tab algn="l" pos="9194760"/>
                    <a:tab algn="l" pos="10344240"/>
                  </a:tabLst>
                </a:pPr>
                <a:r>
                  <a:rPr b="1" lang="en-US" sz="1400" spc="-1" strike="noStrike">
                    <a:solidFill>
                      <a:srgbClr val="000000"/>
                    </a:solidFill>
                    <a:latin typeface="MS Sans Serif"/>
                    <a:ea typeface="MS Sans Serif"/>
                  </a:rPr>
                  <a:t>63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1" name=""/>
              <p:cNvSpPr/>
              <p:nvPr/>
            </p:nvSpPr>
            <p:spPr>
              <a:xfrm>
                <a:off x="5007960" y="6561000"/>
                <a:ext cx="204840" cy="213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1149480"/>
                    <a:tab algn="l" pos="2298600"/>
                    <a:tab algn="l" pos="3448080"/>
                    <a:tab algn="l" pos="4597560"/>
                    <a:tab algn="l" pos="5746680"/>
                    <a:tab algn="l" pos="6896160"/>
                    <a:tab algn="l" pos="8045280"/>
                    <a:tab algn="l" pos="9194760"/>
                    <a:tab algn="l" pos="10344240"/>
                  </a:tabLst>
                </a:pPr>
                <a:r>
                  <a:rPr b="1" lang="en-US" sz="1400" spc="-1" strike="noStrike">
                    <a:solidFill>
                      <a:srgbClr val="000000"/>
                    </a:solidFill>
                    <a:latin typeface="MS Sans Serif"/>
                    <a:ea typeface="MS Sans Serif"/>
                  </a:rPr>
                  <a:t>44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2" name=""/>
              <p:cNvSpPr/>
              <p:nvPr/>
            </p:nvSpPr>
            <p:spPr>
              <a:xfrm>
                <a:off x="4917240" y="6740280"/>
                <a:ext cx="204840" cy="213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1149480"/>
                    <a:tab algn="l" pos="2298600"/>
                    <a:tab algn="l" pos="3448080"/>
                    <a:tab algn="l" pos="4597560"/>
                    <a:tab algn="l" pos="5746680"/>
                    <a:tab algn="l" pos="6896160"/>
                    <a:tab algn="l" pos="8045280"/>
                    <a:tab algn="l" pos="9194760"/>
                    <a:tab algn="l" pos="10344240"/>
                  </a:tabLst>
                </a:pPr>
                <a:r>
                  <a:rPr b="1" lang="en-US" sz="1400" spc="-1" strike="noStrike">
                    <a:solidFill>
                      <a:srgbClr val="000000"/>
                    </a:solidFill>
                    <a:latin typeface="MS Sans Serif"/>
                    <a:ea typeface="MS Sans Serif"/>
                  </a:rPr>
                  <a:t>97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3" name=""/>
              <p:cNvSpPr/>
              <p:nvPr/>
            </p:nvSpPr>
            <p:spPr>
              <a:xfrm>
                <a:off x="4955400" y="3951000"/>
                <a:ext cx="204840" cy="213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1149480"/>
                    <a:tab algn="l" pos="2298600"/>
                    <a:tab algn="l" pos="3448080"/>
                    <a:tab algn="l" pos="4597560"/>
                    <a:tab algn="l" pos="5746680"/>
                    <a:tab algn="l" pos="6896160"/>
                    <a:tab algn="l" pos="8045280"/>
                    <a:tab algn="l" pos="9194760"/>
                    <a:tab algn="l" pos="10344240"/>
                  </a:tabLst>
                </a:pPr>
                <a:r>
                  <a:rPr b="1" lang="en-US" sz="1400" spc="-1" strike="noStrike">
                    <a:solidFill>
                      <a:srgbClr val="000000"/>
                    </a:solidFill>
                    <a:latin typeface="MS Sans Serif"/>
                    <a:ea typeface="MS Sans Serif"/>
                  </a:rPr>
                  <a:t>96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4" name=""/>
              <p:cNvSpPr/>
              <p:nvPr/>
            </p:nvSpPr>
            <p:spPr>
              <a:xfrm>
                <a:off x="4866480" y="4770360"/>
                <a:ext cx="204840" cy="213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1149480"/>
                    <a:tab algn="l" pos="2298600"/>
                    <a:tab algn="l" pos="3448080"/>
                    <a:tab algn="l" pos="4597560"/>
                    <a:tab algn="l" pos="5746680"/>
                    <a:tab algn="l" pos="6896160"/>
                    <a:tab algn="l" pos="8045280"/>
                    <a:tab algn="l" pos="9194760"/>
                    <a:tab algn="l" pos="10344240"/>
                  </a:tabLst>
                </a:pPr>
                <a:r>
                  <a:rPr b="1" lang="en-US" sz="1400" spc="-1" strike="noStrike">
                    <a:solidFill>
                      <a:srgbClr val="000000"/>
                    </a:solidFill>
                    <a:latin typeface="MS Sans Serif"/>
                    <a:ea typeface="MS Sans Serif"/>
                  </a:rPr>
                  <a:t>39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5" name=""/>
              <p:cNvSpPr/>
              <p:nvPr/>
            </p:nvSpPr>
            <p:spPr>
              <a:xfrm>
                <a:off x="4828320" y="4924080"/>
                <a:ext cx="204840" cy="213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1149480"/>
                    <a:tab algn="l" pos="2298600"/>
                    <a:tab algn="l" pos="3448080"/>
                    <a:tab algn="l" pos="4597560"/>
                    <a:tab algn="l" pos="5746680"/>
                    <a:tab algn="l" pos="6896160"/>
                    <a:tab algn="l" pos="8045280"/>
                    <a:tab algn="l" pos="9194760"/>
                    <a:tab algn="l" pos="10344240"/>
                  </a:tabLst>
                </a:pPr>
                <a:r>
                  <a:rPr b="1" lang="en-US" sz="1400" spc="-1" strike="noStrike">
                    <a:solidFill>
                      <a:srgbClr val="000000"/>
                    </a:solidFill>
                    <a:latin typeface="MS Sans Serif"/>
                    <a:ea typeface="MS Sans Serif"/>
                  </a:rPr>
                  <a:t>92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6" name=""/>
              <p:cNvSpPr/>
              <p:nvPr/>
            </p:nvSpPr>
            <p:spPr>
              <a:xfrm>
                <a:off x="4980960" y="266400"/>
                <a:ext cx="204840" cy="213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1149480"/>
                    <a:tab algn="l" pos="2298600"/>
                    <a:tab algn="l" pos="3448080"/>
                    <a:tab algn="l" pos="4597560"/>
                    <a:tab algn="l" pos="5746680"/>
                    <a:tab algn="l" pos="6896160"/>
                    <a:tab algn="l" pos="8045280"/>
                    <a:tab algn="l" pos="9194760"/>
                    <a:tab algn="l" pos="10344240"/>
                  </a:tabLst>
                </a:pPr>
                <a:r>
                  <a:rPr b="1" lang="en-US" sz="1400" spc="-1" strike="noStrike">
                    <a:solidFill>
                      <a:srgbClr val="000000"/>
                    </a:solidFill>
                    <a:latin typeface="MS Sans Serif"/>
                    <a:ea typeface="MS Sans Serif"/>
                  </a:rPr>
                  <a:t>80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7" name=""/>
              <p:cNvSpPr/>
              <p:nvPr/>
            </p:nvSpPr>
            <p:spPr>
              <a:xfrm>
                <a:off x="4892040" y="420480"/>
                <a:ext cx="204840" cy="213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1149480"/>
                    <a:tab algn="l" pos="2298600"/>
                    <a:tab algn="l" pos="3448080"/>
                    <a:tab algn="l" pos="4597560"/>
                    <a:tab algn="l" pos="5746680"/>
                    <a:tab algn="l" pos="6896160"/>
                    <a:tab algn="l" pos="8045280"/>
                    <a:tab algn="l" pos="9194760"/>
                    <a:tab algn="l" pos="10344240"/>
                  </a:tabLst>
                </a:pPr>
                <a:r>
                  <a:rPr b="1" lang="en-US" sz="1400" spc="-1" strike="noStrike">
                    <a:solidFill>
                      <a:srgbClr val="000000"/>
                    </a:solidFill>
                    <a:latin typeface="MS Sans Serif"/>
                    <a:ea typeface="MS Sans Serif"/>
                  </a:rPr>
                  <a:t>76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8" name=""/>
              <p:cNvSpPr/>
              <p:nvPr/>
            </p:nvSpPr>
            <p:spPr>
              <a:xfrm>
                <a:off x="4725360" y="599760"/>
                <a:ext cx="204840" cy="213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1149480"/>
                    <a:tab algn="l" pos="2298600"/>
                    <a:tab algn="l" pos="3448080"/>
                    <a:tab algn="l" pos="4597560"/>
                    <a:tab algn="l" pos="5746680"/>
                    <a:tab algn="l" pos="6896160"/>
                    <a:tab algn="l" pos="8045280"/>
                    <a:tab algn="l" pos="9194760"/>
                    <a:tab algn="l" pos="10344240"/>
                  </a:tabLst>
                </a:pPr>
                <a:r>
                  <a:rPr b="1" lang="en-US" sz="1400" spc="-1" strike="noStrike">
                    <a:solidFill>
                      <a:srgbClr val="000000"/>
                    </a:solidFill>
                    <a:latin typeface="MS Sans Serif"/>
                    <a:ea typeface="MS Sans Serif"/>
                  </a:rPr>
                  <a:t>79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9" name=""/>
              <p:cNvSpPr/>
              <p:nvPr/>
            </p:nvSpPr>
            <p:spPr>
              <a:xfrm>
                <a:off x="4750560" y="6075000"/>
                <a:ext cx="204840" cy="213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1149480"/>
                    <a:tab algn="l" pos="2298600"/>
                    <a:tab algn="l" pos="3448080"/>
                    <a:tab algn="l" pos="4597560"/>
                    <a:tab algn="l" pos="5746680"/>
                    <a:tab algn="l" pos="6896160"/>
                    <a:tab algn="l" pos="8045280"/>
                    <a:tab algn="l" pos="9194760"/>
                    <a:tab algn="l" pos="10344240"/>
                  </a:tabLst>
                </a:pPr>
                <a:r>
                  <a:rPr b="1" lang="en-US" sz="1400" spc="-1" strike="noStrike">
                    <a:solidFill>
                      <a:srgbClr val="000000"/>
                    </a:solidFill>
                    <a:latin typeface="MS Sans Serif"/>
                    <a:ea typeface="MS Sans Serif"/>
                  </a:rPr>
                  <a:t>59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0" name=""/>
              <p:cNvSpPr/>
              <p:nvPr/>
            </p:nvSpPr>
            <p:spPr>
              <a:xfrm>
                <a:off x="4546080" y="5819400"/>
                <a:ext cx="204840" cy="213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1149480"/>
                    <a:tab algn="l" pos="2298600"/>
                    <a:tab algn="l" pos="3448080"/>
                    <a:tab algn="l" pos="4597560"/>
                    <a:tab algn="l" pos="5746680"/>
                    <a:tab algn="l" pos="6896160"/>
                    <a:tab algn="l" pos="8045280"/>
                    <a:tab algn="l" pos="9194760"/>
                    <a:tab algn="l" pos="10344240"/>
                  </a:tabLst>
                </a:pPr>
                <a:r>
                  <a:rPr b="1" lang="en-US" sz="1400" spc="-1" strike="noStrike">
                    <a:solidFill>
                      <a:srgbClr val="000000"/>
                    </a:solidFill>
                    <a:latin typeface="MS Sans Serif"/>
                    <a:ea typeface="MS Sans Serif"/>
                  </a:rPr>
                  <a:t>69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1" name=""/>
              <p:cNvSpPr/>
              <p:nvPr/>
            </p:nvSpPr>
            <p:spPr>
              <a:xfrm>
                <a:off x="4853880" y="1776240"/>
                <a:ext cx="204840" cy="213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1149480"/>
                    <a:tab algn="l" pos="2298600"/>
                    <a:tab algn="l" pos="3448080"/>
                    <a:tab algn="l" pos="4597560"/>
                    <a:tab algn="l" pos="5746680"/>
                    <a:tab algn="l" pos="6896160"/>
                    <a:tab algn="l" pos="8045280"/>
                    <a:tab algn="l" pos="9194760"/>
                    <a:tab algn="l" pos="10344240"/>
                  </a:tabLst>
                </a:pPr>
                <a:r>
                  <a:rPr b="1" lang="en-US" sz="1400" spc="-1" strike="noStrike">
                    <a:solidFill>
                      <a:srgbClr val="000000"/>
                    </a:solidFill>
                    <a:latin typeface="MS Sans Serif"/>
                    <a:ea typeface="MS Sans Serif"/>
                  </a:rPr>
                  <a:t>56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2" name=""/>
              <p:cNvSpPr/>
              <p:nvPr/>
            </p:nvSpPr>
            <p:spPr>
              <a:xfrm>
                <a:off x="4725360" y="1623600"/>
                <a:ext cx="204840" cy="213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1149480"/>
                    <a:tab algn="l" pos="2298600"/>
                    <a:tab algn="l" pos="3448080"/>
                    <a:tab algn="l" pos="4597560"/>
                    <a:tab algn="l" pos="5746680"/>
                    <a:tab algn="l" pos="6896160"/>
                    <a:tab algn="l" pos="8045280"/>
                    <a:tab algn="l" pos="9194760"/>
                    <a:tab algn="l" pos="10344240"/>
                  </a:tabLst>
                </a:pPr>
                <a:r>
                  <a:rPr b="1" lang="en-US" sz="1400" spc="-1" strike="noStrike">
                    <a:solidFill>
                      <a:srgbClr val="000000"/>
                    </a:solidFill>
                    <a:latin typeface="MS Sans Serif"/>
                    <a:ea typeface="MS Sans Serif"/>
                  </a:rPr>
                  <a:t>51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3" name=""/>
              <p:cNvSpPr/>
              <p:nvPr/>
            </p:nvSpPr>
            <p:spPr>
              <a:xfrm>
                <a:off x="4558680" y="792000"/>
                <a:ext cx="204840" cy="213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1149480"/>
                    <a:tab algn="l" pos="2298600"/>
                    <a:tab algn="l" pos="3448080"/>
                    <a:tab algn="l" pos="4597560"/>
                    <a:tab algn="l" pos="5746680"/>
                    <a:tab algn="l" pos="6896160"/>
                    <a:tab algn="l" pos="8045280"/>
                    <a:tab algn="l" pos="9194760"/>
                    <a:tab algn="l" pos="10344240"/>
                  </a:tabLst>
                </a:pPr>
                <a:r>
                  <a:rPr b="1" lang="en-US" sz="1400" spc="-1" strike="noStrike">
                    <a:solidFill>
                      <a:srgbClr val="000000"/>
                    </a:solidFill>
                    <a:latin typeface="MS Sans Serif"/>
                    <a:ea typeface="MS Sans Serif"/>
                  </a:rPr>
                  <a:t>36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4" name=""/>
              <p:cNvSpPr/>
              <p:nvPr/>
            </p:nvSpPr>
            <p:spPr>
              <a:xfrm>
                <a:off x="4482360" y="1060200"/>
                <a:ext cx="204840" cy="213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1149480"/>
                    <a:tab algn="l" pos="2298600"/>
                    <a:tab algn="l" pos="3448080"/>
                    <a:tab algn="l" pos="4597560"/>
                    <a:tab algn="l" pos="5746680"/>
                    <a:tab algn="l" pos="6896160"/>
                    <a:tab algn="l" pos="8045280"/>
                    <a:tab algn="l" pos="9194760"/>
                    <a:tab algn="l" pos="10344240"/>
                  </a:tabLst>
                </a:pPr>
                <a:r>
                  <a:rPr b="1" lang="en-US" sz="1400" spc="-1" strike="noStrike">
                    <a:solidFill>
                      <a:srgbClr val="000000"/>
                    </a:solidFill>
                    <a:latin typeface="MS Sans Serif"/>
                    <a:ea typeface="MS Sans Serif"/>
                  </a:rPr>
                  <a:t>35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5" name=""/>
              <p:cNvSpPr/>
              <p:nvPr/>
            </p:nvSpPr>
            <p:spPr>
              <a:xfrm>
                <a:off x="3777480" y="1482480"/>
                <a:ext cx="204840" cy="213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1149480"/>
                    <a:tab algn="l" pos="2298600"/>
                    <a:tab algn="l" pos="3448080"/>
                    <a:tab algn="l" pos="4597560"/>
                    <a:tab algn="l" pos="5746680"/>
                    <a:tab algn="l" pos="6896160"/>
                    <a:tab algn="l" pos="8045280"/>
                    <a:tab algn="l" pos="9194760"/>
                    <a:tab algn="l" pos="10344240"/>
                  </a:tabLst>
                </a:pPr>
                <a:r>
                  <a:rPr b="1" lang="en-US" sz="1400" spc="-1" strike="noStrike">
                    <a:solidFill>
                      <a:srgbClr val="000000"/>
                    </a:solidFill>
                    <a:latin typeface="MS Sans Serif"/>
                    <a:ea typeface="MS Sans Serif"/>
                  </a:rPr>
                  <a:t>60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6" name=""/>
              <p:cNvSpPr/>
              <p:nvPr/>
            </p:nvSpPr>
            <p:spPr>
              <a:xfrm>
                <a:off x="4264920" y="5511600"/>
                <a:ext cx="204840" cy="213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1149480"/>
                    <a:tab algn="l" pos="2298600"/>
                    <a:tab algn="l" pos="3448080"/>
                    <a:tab algn="l" pos="4597560"/>
                    <a:tab algn="l" pos="5746680"/>
                    <a:tab algn="l" pos="6896160"/>
                    <a:tab algn="l" pos="8045280"/>
                    <a:tab algn="l" pos="9194760"/>
                    <a:tab algn="l" pos="10344240"/>
                  </a:tabLst>
                </a:pPr>
                <a:r>
                  <a:rPr b="1" lang="en-US" sz="1400" spc="-1" strike="noStrike">
                    <a:solidFill>
                      <a:srgbClr val="000000"/>
                    </a:solidFill>
                    <a:latin typeface="MS Sans Serif"/>
                    <a:ea typeface="MS Sans Serif"/>
                  </a:rPr>
                  <a:t>59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7" name=""/>
              <p:cNvSpPr/>
              <p:nvPr/>
            </p:nvSpPr>
            <p:spPr>
              <a:xfrm>
                <a:off x="4353840" y="4641480"/>
                <a:ext cx="204840" cy="213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1149480"/>
                    <a:tab algn="l" pos="2298600"/>
                    <a:tab algn="l" pos="3448080"/>
                    <a:tab algn="l" pos="4597560"/>
                    <a:tab algn="l" pos="5746680"/>
                    <a:tab algn="l" pos="6896160"/>
                    <a:tab algn="l" pos="8045280"/>
                    <a:tab algn="l" pos="9194760"/>
                    <a:tab algn="l" pos="10344240"/>
                  </a:tabLst>
                </a:pPr>
                <a:r>
                  <a:rPr b="1" lang="en-US" sz="1400" spc="-1" strike="noStrike">
                    <a:solidFill>
                      <a:srgbClr val="000000"/>
                    </a:solidFill>
                    <a:latin typeface="MS Sans Serif"/>
                    <a:ea typeface="MS Sans Serif"/>
                  </a:rPr>
                  <a:t>51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8" name=""/>
              <p:cNvSpPr/>
              <p:nvPr/>
            </p:nvSpPr>
            <p:spPr>
              <a:xfrm>
                <a:off x="3355200" y="1841400"/>
                <a:ext cx="204840" cy="213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1149480"/>
                    <a:tab algn="l" pos="2298600"/>
                    <a:tab algn="l" pos="3448080"/>
                    <a:tab algn="l" pos="4597560"/>
                    <a:tab algn="l" pos="5746680"/>
                    <a:tab algn="l" pos="6896160"/>
                    <a:tab algn="l" pos="8045280"/>
                    <a:tab algn="l" pos="9194760"/>
                    <a:tab algn="l" pos="10344240"/>
                  </a:tabLst>
                </a:pPr>
                <a:r>
                  <a:rPr b="1" lang="en-US" sz="1400" spc="-1" strike="noStrike">
                    <a:solidFill>
                      <a:srgbClr val="000000"/>
                    </a:solidFill>
                    <a:latin typeface="MS Sans Serif"/>
                    <a:ea typeface="MS Sans Serif"/>
                  </a:rPr>
                  <a:t>48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9" name=""/>
              <p:cNvSpPr/>
              <p:nvPr/>
            </p:nvSpPr>
            <p:spPr>
              <a:xfrm>
                <a:off x="3021840" y="2223720"/>
                <a:ext cx="204840" cy="213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1149480"/>
                    <a:tab algn="l" pos="2298600"/>
                    <a:tab algn="l" pos="3448080"/>
                    <a:tab algn="l" pos="4597560"/>
                    <a:tab algn="l" pos="5746680"/>
                    <a:tab algn="l" pos="6896160"/>
                    <a:tab algn="l" pos="8045280"/>
                    <a:tab algn="l" pos="9194760"/>
                    <a:tab algn="l" pos="10344240"/>
                  </a:tabLst>
                </a:pPr>
                <a:r>
                  <a:rPr b="1" lang="en-US" sz="1400" spc="-1" strike="noStrike">
                    <a:solidFill>
                      <a:srgbClr val="000000"/>
                    </a:solidFill>
                    <a:latin typeface="MS Sans Serif"/>
                    <a:ea typeface="MS Sans Serif"/>
                  </a:rPr>
                  <a:t>30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0" name=""/>
              <p:cNvSpPr/>
              <p:nvPr/>
            </p:nvSpPr>
            <p:spPr>
              <a:xfrm>
                <a:off x="4058640" y="4155840"/>
                <a:ext cx="204840" cy="213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1149480"/>
                    <a:tab algn="l" pos="2298600"/>
                    <a:tab algn="l" pos="3448080"/>
                    <a:tab algn="l" pos="4597560"/>
                    <a:tab algn="l" pos="5746680"/>
                    <a:tab algn="l" pos="6896160"/>
                    <a:tab algn="l" pos="8045280"/>
                    <a:tab algn="l" pos="9194760"/>
                    <a:tab algn="l" pos="10344240"/>
                  </a:tabLst>
                </a:pPr>
                <a:r>
                  <a:rPr b="1" lang="en-US" sz="1400" spc="-1" strike="noStrike">
                    <a:solidFill>
                      <a:srgbClr val="000000"/>
                    </a:solidFill>
                    <a:latin typeface="MS Sans Serif"/>
                    <a:ea typeface="MS Sans Serif"/>
                  </a:rPr>
                  <a:t>25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1" name=""/>
              <p:cNvSpPr/>
              <p:nvPr/>
            </p:nvSpPr>
            <p:spPr>
              <a:xfrm>
                <a:off x="3931560" y="4974840"/>
                <a:ext cx="204840" cy="213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1149480"/>
                    <a:tab algn="l" pos="2298600"/>
                    <a:tab algn="l" pos="3448080"/>
                    <a:tab algn="l" pos="4597560"/>
                    <a:tab algn="l" pos="5746680"/>
                    <a:tab algn="l" pos="6896160"/>
                    <a:tab algn="l" pos="8045280"/>
                    <a:tab algn="l" pos="9194760"/>
                    <a:tab algn="l" pos="10344240"/>
                  </a:tabLst>
                </a:pPr>
                <a:r>
                  <a:rPr b="1" lang="en-US" sz="1400" spc="-1" strike="noStrike">
                    <a:solidFill>
                      <a:srgbClr val="000000"/>
                    </a:solidFill>
                    <a:latin typeface="MS Sans Serif"/>
                    <a:ea typeface="MS Sans Serif"/>
                  </a:rPr>
                  <a:t>15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2" name=""/>
              <p:cNvSpPr/>
              <p:nvPr/>
            </p:nvSpPr>
            <p:spPr>
              <a:xfrm>
                <a:off x="3687120" y="4449600"/>
                <a:ext cx="204840" cy="213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1149480"/>
                    <a:tab algn="l" pos="2298600"/>
                    <a:tab algn="l" pos="3448080"/>
                    <a:tab algn="l" pos="4597560"/>
                    <a:tab algn="l" pos="5746680"/>
                    <a:tab algn="l" pos="6896160"/>
                    <a:tab algn="l" pos="8045280"/>
                    <a:tab algn="l" pos="9194760"/>
                    <a:tab algn="l" pos="10344240"/>
                  </a:tabLst>
                </a:pPr>
                <a:r>
                  <a:rPr b="1" lang="en-US" sz="1400" spc="-1" strike="noStrike">
                    <a:solidFill>
                      <a:srgbClr val="000000"/>
                    </a:solidFill>
                    <a:latin typeface="MS Sans Serif"/>
                    <a:ea typeface="MS Sans Serif"/>
                  </a:rPr>
                  <a:t>24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243" name=""/>
            <p:cNvSpPr/>
            <p:nvPr/>
          </p:nvSpPr>
          <p:spPr>
            <a:xfrm>
              <a:off x="2918880" y="3197160"/>
              <a:ext cx="204840" cy="213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149480"/>
                  <a:tab algn="l" pos="2298600"/>
                  <a:tab algn="l" pos="3448080"/>
                  <a:tab algn="l" pos="4597560"/>
                  <a:tab algn="l" pos="5746680"/>
                  <a:tab algn="l" pos="6896160"/>
                  <a:tab algn="l" pos="8045280"/>
                  <a:tab algn="l" pos="9194760"/>
                  <a:tab algn="l" pos="1034424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MS Sans Serif"/>
                  <a:ea typeface="MS Sans Serif"/>
                </a:rPr>
                <a:t>91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4" name=""/>
            <p:cNvSpPr/>
            <p:nvPr/>
          </p:nvSpPr>
          <p:spPr>
            <a:xfrm>
              <a:off x="4815720" y="8045280"/>
              <a:ext cx="204840" cy="213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149480"/>
                  <a:tab algn="l" pos="2298600"/>
                  <a:tab algn="l" pos="3448080"/>
                  <a:tab algn="l" pos="4597560"/>
                  <a:tab algn="l" pos="5746680"/>
                  <a:tab algn="l" pos="6896160"/>
                  <a:tab algn="l" pos="8045280"/>
                  <a:tab algn="l" pos="9194760"/>
                  <a:tab algn="l" pos="1034424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MS Sans Serif"/>
                  <a:ea typeface="MS Sans Serif"/>
                </a:rPr>
                <a:t>81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5" name=""/>
            <p:cNvSpPr/>
            <p:nvPr/>
          </p:nvSpPr>
          <p:spPr>
            <a:xfrm>
              <a:off x="2266200" y="8530920"/>
              <a:ext cx="204840" cy="213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149480"/>
                  <a:tab algn="l" pos="2298600"/>
                  <a:tab algn="l" pos="3448080"/>
                  <a:tab algn="l" pos="4597560"/>
                  <a:tab algn="l" pos="5746680"/>
                  <a:tab algn="l" pos="6896160"/>
                  <a:tab algn="l" pos="8045280"/>
                  <a:tab algn="l" pos="9194760"/>
                  <a:tab algn="l" pos="1034424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MS Sans Serif"/>
                  <a:ea typeface="MS Sans Serif"/>
                </a:rPr>
                <a:t>67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6" name=""/>
            <p:cNvSpPr/>
            <p:nvPr/>
          </p:nvSpPr>
          <p:spPr>
            <a:xfrm>
              <a:off x="2047320" y="8275320"/>
              <a:ext cx="204840" cy="213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149480"/>
                  <a:tab algn="l" pos="2298600"/>
                  <a:tab algn="l" pos="3448080"/>
                  <a:tab algn="l" pos="4597560"/>
                  <a:tab algn="l" pos="5746680"/>
                  <a:tab algn="l" pos="6896160"/>
                  <a:tab algn="l" pos="8045280"/>
                  <a:tab algn="l" pos="9194760"/>
                  <a:tab algn="l" pos="1034424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MS Sans Serif"/>
                  <a:ea typeface="MS Sans Serif"/>
                </a:rPr>
                <a:t>25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7" name=""/>
            <p:cNvSpPr/>
            <p:nvPr/>
          </p:nvSpPr>
          <p:spPr>
            <a:xfrm>
              <a:off x="1996560" y="7992720"/>
              <a:ext cx="204840" cy="213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149480"/>
                  <a:tab algn="l" pos="2298600"/>
                  <a:tab algn="l" pos="3448080"/>
                  <a:tab algn="l" pos="4597560"/>
                  <a:tab algn="l" pos="5746680"/>
                  <a:tab algn="l" pos="6896160"/>
                  <a:tab algn="l" pos="8045280"/>
                  <a:tab algn="l" pos="9194760"/>
                  <a:tab algn="l" pos="1034424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MS Sans Serif"/>
                  <a:ea typeface="MS Sans Serif"/>
                </a:rPr>
                <a:t>16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8" name=""/>
            <p:cNvSpPr/>
            <p:nvPr/>
          </p:nvSpPr>
          <p:spPr>
            <a:xfrm>
              <a:off x="1945440" y="7507080"/>
              <a:ext cx="204840" cy="213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149480"/>
                  <a:tab algn="l" pos="2298600"/>
                  <a:tab algn="l" pos="3448080"/>
                  <a:tab algn="l" pos="4597560"/>
                  <a:tab algn="l" pos="5746680"/>
                  <a:tab algn="l" pos="6896160"/>
                  <a:tab algn="l" pos="8045280"/>
                  <a:tab algn="l" pos="9194760"/>
                  <a:tab algn="l" pos="1034424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MS Sans Serif"/>
                  <a:ea typeface="MS Sans Serif"/>
                </a:rPr>
                <a:t>40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9" name=""/>
            <p:cNvSpPr/>
            <p:nvPr/>
          </p:nvSpPr>
          <p:spPr>
            <a:xfrm>
              <a:off x="1215360" y="6945120"/>
              <a:ext cx="204840" cy="213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149480"/>
                  <a:tab algn="l" pos="2298600"/>
                  <a:tab algn="l" pos="3448080"/>
                  <a:tab algn="l" pos="4597560"/>
                  <a:tab algn="l" pos="5746680"/>
                  <a:tab algn="l" pos="6896160"/>
                  <a:tab algn="l" pos="8045280"/>
                  <a:tab algn="l" pos="9194760"/>
                  <a:tab algn="l" pos="1034424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MS Sans Serif"/>
                  <a:ea typeface="MS Sans Serif"/>
                </a:rPr>
                <a:t>85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0" name=""/>
            <p:cNvSpPr/>
            <p:nvPr/>
          </p:nvSpPr>
          <p:spPr>
            <a:xfrm>
              <a:off x="476280" y="9362880"/>
              <a:ext cx="4957920" cy="1440"/>
            </a:xfrm>
            <a:prstGeom prst="line">
              <a:avLst/>
            </a:prstGeom>
            <a:ln w="38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1" name=""/>
            <p:cNvSpPr/>
            <p:nvPr/>
          </p:nvSpPr>
          <p:spPr>
            <a:xfrm>
              <a:off x="5434200" y="9310320"/>
              <a:ext cx="1440" cy="103320"/>
            </a:xfrm>
            <a:prstGeom prst="line">
              <a:avLst/>
            </a:prstGeom>
            <a:ln w="38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2" name=""/>
            <p:cNvSpPr/>
            <p:nvPr/>
          </p:nvSpPr>
          <p:spPr>
            <a:xfrm>
              <a:off x="5316840" y="9401040"/>
              <a:ext cx="249120" cy="213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1149480"/>
                  <a:tab algn="l" pos="2298600"/>
                  <a:tab algn="l" pos="3448080"/>
                  <a:tab algn="l" pos="4597560"/>
                  <a:tab algn="l" pos="5746680"/>
                  <a:tab algn="l" pos="6896160"/>
                  <a:tab algn="l" pos="8045280"/>
                  <a:tab algn="l" pos="9194760"/>
                  <a:tab algn="l" pos="1034424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</a:rPr>
                <a:t>0.0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3" name=""/>
            <p:cNvSpPr/>
            <p:nvPr/>
          </p:nvSpPr>
          <p:spPr>
            <a:xfrm>
              <a:off x="4165560" y="9310320"/>
              <a:ext cx="1800" cy="103320"/>
            </a:xfrm>
            <a:prstGeom prst="line">
              <a:avLst/>
            </a:prstGeom>
            <a:ln w="38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4" name=""/>
            <p:cNvSpPr/>
            <p:nvPr/>
          </p:nvSpPr>
          <p:spPr>
            <a:xfrm>
              <a:off x="4048200" y="9401040"/>
              <a:ext cx="249120" cy="213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1149480"/>
                  <a:tab algn="l" pos="2298600"/>
                  <a:tab algn="l" pos="3448080"/>
                  <a:tab algn="l" pos="4597560"/>
                  <a:tab algn="l" pos="5746680"/>
                  <a:tab algn="l" pos="6896160"/>
                  <a:tab algn="l" pos="8045280"/>
                  <a:tab algn="l" pos="9194760"/>
                  <a:tab algn="l" pos="1034424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</a:rPr>
                <a:t>0.1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5" name=""/>
            <p:cNvSpPr/>
            <p:nvPr/>
          </p:nvSpPr>
          <p:spPr>
            <a:xfrm>
              <a:off x="2884680" y="9310320"/>
              <a:ext cx="1440" cy="103320"/>
            </a:xfrm>
            <a:prstGeom prst="line">
              <a:avLst/>
            </a:prstGeom>
            <a:ln w="38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6" name=""/>
            <p:cNvSpPr/>
            <p:nvPr/>
          </p:nvSpPr>
          <p:spPr>
            <a:xfrm>
              <a:off x="2767320" y="9401040"/>
              <a:ext cx="249120" cy="213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1149480"/>
                  <a:tab algn="l" pos="2298600"/>
                  <a:tab algn="l" pos="3448080"/>
                  <a:tab algn="l" pos="4597560"/>
                  <a:tab algn="l" pos="5746680"/>
                  <a:tab algn="l" pos="6896160"/>
                  <a:tab algn="l" pos="8045280"/>
                  <a:tab algn="l" pos="9194760"/>
                  <a:tab algn="l" pos="1034424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</a:rPr>
                <a:t>0.2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7" name=""/>
            <p:cNvSpPr/>
            <p:nvPr/>
          </p:nvSpPr>
          <p:spPr>
            <a:xfrm>
              <a:off x="1616040" y="9310320"/>
              <a:ext cx="1800" cy="103320"/>
            </a:xfrm>
            <a:prstGeom prst="line">
              <a:avLst/>
            </a:prstGeom>
            <a:ln w="38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8" name=""/>
            <p:cNvSpPr/>
            <p:nvPr/>
          </p:nvSpPr>
          <p:spPr>
            <a:xfrm>
              <a:off x="1486080" y="9401040"/>
              <a:ext cx="249120" cy="213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1149480"/>
                  <a:tab algn="l" pos="2298600"/>
                  <a:tab algn="l" pos="3448080"/>
                  <a:tab algn="l" pos="4597560"/>
                  <a:tab algn="l" pos="5746680"/>
                  <a:tab algn="l" pos="6896160"/>
                  <a:tab algn="l" pos="8045280"/>
                  <a:tab algn="l" pos="9194760"/>
                  <a:tab algn="l" pos="1034424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</a:rPr>
                <a:t>0.3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19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4-05-13T09:40:57Z</dcterms:created>
  <dc:creator>NIPGR</dc:creator>
  <dc:description/>
  <dc:language>en-US</dc:language>
  <cp:lastModifiedBy>NIPGR</cp:lastModifiedBy>
  <dcterms:modified xsi:type="dcterms:W3CDTF">2015-07-13T10:11:18Z</dcterms:modified>
  <cp:revision>10</cp:revision>
  <dc:subject/>
  <dc:title>Slide 1</dc:title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DocumentId">
    <vt:lpwstr>Presentation 2.PPT</vt:lpwstr>
  </property>
  <property fmtid="{D5CDD505-2E9C-101B-9397-08002B2CF9AE}" pid="3" name="DocumentType">
    <vt:lpwstr>Presentation</vt:lpwstr>
  </property>
  <property fmtid="{D5CDD505-2E9C-101B-9397-08002B2CF9AE}" pid="4" name="FileFormat">
    <vt:lpwstr>PPT</vt:lpwstr>
  </property>
  <property fmtid="{D5CDD505-2E9C-101B-9397-08002B2CF9AE}" pid="5" name="TitleName">
    <vt:lpwstr>Presentation 2.PPT</vt:lpwstr>
  </property>
</Properties>
</file>